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handoutMasterIdLst>
    <p:handoutMasterId r:id="rId6"/>
  </p:handoutMasterIdLst>
  <p:sldIdLst>
    <p:sldId id="298" r:id="rId2"/>
    <p:sldId id="299" r:id="rId3"/>
    <p:sldId id="300" r:id="rId4"/>
  </p:sldIdLst>
  <p:sldSz cx="6858000" cy="9906000" type="A4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154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99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45" autoAdjust="0"/>
    <p:restoredTop sz="94755" autoAdjust="0"/>
  </p:normalViewPr>
  <p:slideViewPr>
    <p:cSldViewPr showGuides="1">
      <p:cViewPr varScale="1">
        <p:scale>
          <a:sx n="60" d="100"/>
          <a:sy n="60" d="100"/>
        </p:scale>
        <p:origin x="2746" y="38"/>
      </p:cViewPr>
      <p:guideLst>
        <p:guide orient="horz" pos="3097"/>
        <p:guide pos="154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howGuides="1">
      <p:cViewPr varScale="1">
        <p:scale>
          <a:sx n="63" d="100"/>
          <a:sy n="63" d="100"/>
        </p:scale>
        <p:origin x="3235" y="4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19413" cy="495140"/>
          </a:xfrm>
          <a:prstGeom prst="rect">
            <a:avLst/>
          </a:prstGeom>
        </p:spPr>
        <p:txBody>
          <a:bodyPr vert="horz" lIns="91415" tIns="45708" rIns="91415" bIns="457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1"/>
            <a:ext cx="2919412" cy="495140"/>
          </a:xfrm>
          <a:prstGeom prst="rect">
            <a:avLst/>
          </a:prstGeom>
        </p:spPr>
        <p:txBody>
          <a:bodyPr vert="horz" lIns="91415" tIns="45708" rIns="91415" bIns="45708" rtlCol="0"/>
          <a:lstStyle>
            <a:lvl1pPr algn="r">
              <a:defRPr sz="1200"/>
            </a:lvl1pPr>
          </a:lstStyle>
          <a:p>
            <a:fld id="{C6F84FD3-30B9-4EF0-868D-C5DD9DA05CBB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1" y="9371173"/>
            <a:ext cx="2919413" cy="495140"/>
          </a:xfrm>
          <a:prstGeom prst="rect">
            <a:avLst/>
          </a:prstGeom>
        </p:spPr>
        <p:txBody>
          <a:bodyPr vert="horz" lIns="91415" tIns="45708" rIns="91415" bIns="457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1173"/>
            <a:ext cx="2919412" cy="495140"/>
          </a:xfrm>
          <a:prstGeom prst="rect">
            <a:avLst/>
          </a:prstGeom>
        </p:spPr>
        <p:txBody>
          <a:bodyPr vert="horz" lIns="91415" tIns="45708" rIns="91415" bIns="45708" rtlCol="0" anchor="b"/>
          <a:lstStyle>
            <a:lvl1pPr algn="r">
              <a:defRPr sz="1200"/>
            </a:lvl1pPr>
          </a:lstStyle>
          <a:p>
            <a:fld id="{E7828E72-A80E-4AA9-B6C5-906D65D24B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2080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302" cy="494813"/>
          </a:xfrm>
          <a:prstGeom prst="rect">
            <a:avLst/>
          </a:prstGeom>
        </p:spPr>
        <p:txBody>
          <a:bodyPr vert="horz" lIns="90648" tIns="45324" rIns="90648" bIns="45324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891" y="0"/>
            <a:ext cx="2919302" cy="494813"/>
          </a:xfrm>
          <a:prstGeom prst="rect">
            <a:avLst/>
          </a:prstGeom>
        </p:spPr>
        <p:txBody>
          <a:bodyPr vert="horz" lIns="90648" tIns="45324" rIns="90648" bIns="45324" rtlCol="0"/>
          <a:lstStyle>
            <a:lvl1pPr algn="r">
              <a:defRPr sz="1200"/>
            </a:lvl1pPr>
          </a:lstStyle>
          <a:p>
            <a:fld id="{03906147-076E-4C58-8B9A-C6282D36CE95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1231900"/>
            <a:ext cx="2306637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648" tIns="45324" rIns="90648" bIns="453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049" y="4747997"/>
            <a:ext cx="5387667" cy="3884437"/>
          </a:xfrm>
          <a:prstGeom prst="rect">
            <a:avLst/>
          </a:prstGeom>
        </p:spPr>
        <p:txBody>
          <a:bodyPr vert="horz" lIns="90648" tIns="45324" rIns="90648" bIns="45324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502"/>
            <a:ext cx="2919302" cy="494813"/>
          </a:xfrm>
          <a:prstGeom prst="rect">
            <a:avLst/>
          </a:prstGeom>
        </p:spPr>
        <p:txBody>
          <a:bodyPr vert="horz" lIns="90648" tIns="45324" rIns="90648" bIns="45324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891" y="9371502"/>
            <a:ext cx="2919302" cy="494813"/>
          </a:xfrm>
          <a:prstGeom prst="rect">
            <a:avLst/>
          </a:prstGeom>
        </p:spPr>
        <p:txBody>
          <a:bodyPr vert="horz" lIns="90648" tIns="45324" rIns="90648" bIns="45324" rtlCol="0" anchor="b"/>
          <a:lstStyle>
            <a:lvl1pPr algn="r">
              <a:defRPr sz="1200"/>
            </a:lvl1pPr>
          </a:lstStyle>
          <a:p>
            <a:fld id="{743191B1-E068-471F-99D1-FF1562FC4E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7939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3191B1-E068-471F-99D1-FF1562FC4E2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6537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3191B1-E068-471F-99D1-FF1562FC4E2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78607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0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739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564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708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666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068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352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9925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436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165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8717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20515-97ED-437D-8846-D8280691D360}" type="datetimeFigureOut">
              <a:rPr kumimoji="1" lang="ja-JP" altLang="en-US" smtClean="0"/>
              <a:t>2024/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98544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/>
                </a:solidFill>
              </a:defRPr>
            </a:lvl1pPr>
          </a:lstStyle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4669F-A830-4F28-B536-B8AC8C16A1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5754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>
            <a:extLst>
              <a:ext uri="{FF2B5EF4-FFF2-40B4-BE49-F238E27FC236}">
                <a16:creationId xmlns:a16="http://schemas.microsoft.com/office/drawing/2014/main" id="{F7F9B5D5-BF72-1BC2-31BF-C6260BFB5B0D}"/>
              </a:ext>
            </a:extLst>
          </p:cNvPr>
          <p:cNvSpPr txBox="1"/>
          <p:nvPr/>
        </p:nvSpPr>
        <p:spPr>
          <a:xfrm>
            <a:off x="62196" y="-24126"/>
            <a:ext cx="3168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+mj-lt"/>
              </a:rPr>
              <a:t>Supplementary Figure S1</a:t>
            </a:r>
          </a:p>
        </p:txBody>
      </p:sp>
      <p:grpSp>
        <p:nvGrpSpPr>
          <p:cNvPr id="99" name="Group 98">
            <a:extLst>
              <a:ext uri="{FF2B5EF4-FFF2-40B4-BE49-F238E27FC236}">
                <a16:creationId xmlns:a16="http://schemas.microsoft.com/office/drawing/2014/main" id="{974967DD-C9E1-C903-A6D0-413D79B6AB4B}"/>
              </a:ext>
            </a:extLst>
          </p:cNvPr>
          <p:cNvGrpSpPr/>
          <p:nvPr/>
        </p:nvGrpSpPr>
        <p:grpSpPr>
          <a:xfrm>
            <a:off x="707174" y="570369"/>
            <a:ext cx="3993462" cy="3531537"/>
            <a:chOff x="514445" y="605957"/>
            <a:chExt cx="3993462" cy="3531537"/>
          </a:xfrm>
        </p:grpSpPr>
        <p:pic>
          <p:nvPicPr>
            <p:cNvPr id="63" name="Picture 62" descr="A close-up of a dna strand&#10;&#10;Description automatically generated">
              <a:extLst>
                <a:ext uri="{FF2B5EF4-FFF2-40B4-BE49-F238E27FC236}">
                  <a16:creationId xmlns:a16="http://schemas.microsoft.com/office/drawing/2014/main" id="{B8DAA247-2958-EE6B-FAC2-EA61D03CACF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4445" y="1705666"/>
              <a:ext cx="3230156" cy="2431828"/>
            </a:xfrm>
            <a:prstGeom prst="rect">
              <a:avLst/>
            </a:prstGeom>
          </p:spPr>
        </p:pic>
        <p:sp>
          <p:nvSpPr>
            <p:cNvPr id="130" name="テキスト ボックス 14">
              <a:extLst>
                <a:ext uri="{FF2B5EF4-FFF2-40B4-BE49-F238E27FC236}">
                  <a16:creationId xmlns:a16="http://schemas.microsoft.com/office/drawing/2014/main" id="{0750AA78-1D25-488E-2748-228043BC337D}"/>
                </a:ext>
              </a:extLst>
            </p:cNvPr>
            <p:cNvSpPr txBox="1"/>
            <p:nvPr/>
          </p:nvSpPr>
          <p:spPr>
            <a:xfrm rot="16200000">
              <a:off x="302227" y="1110636"/>
              <a:ext cx="1101558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Soluble</a:t>
              </a:r>
              <a:r>
                <a:rPr lang="ja-JP" altLang="en-US" sz="900" dirty="0">
                  <a:latin typeface="+mj-lt"/>
                  <a:cs typeface="Arial" panose="020B0604020202020204" pitchFamily="34" charset="0"/>
                </a:rPr>
                <a:t> </a:t>
              </a:r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fraction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31" name="テキスト ボックス 16">
              <a:extLst>
                <a:ext uri="{FF2B5EF4-FFF2-40B4-BE49-F238E27FC236}">
                  <a16:creationId xmlns:a16="http://schemas.microsoft.com/office/drawing/2014/main" id="{EE619034-FB4B-497A-67F4-8E2CAC58FD12}"/>
                </a:ext>
              </a:extLst>
            </p:cNvPr>
            <p:cNvSpPr txBox="1"/>
            <p:nvPr/>
          </p:nvSpPr>
          <p:spPr>
            <a:xfrm rot="16200000">
              <a:off x="580320" y="1169555"/>
              <a:ext cx="983722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Inclusion body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8">
              <a:extLst>
                <a:ext uri="{FF2B5EF4-FFF2-40B4-BE49-F238E27FC236}">
                  <a16:creationId xmlns:a16="http://schemas.microsoft.com/office/drawing/2014/main" id="{840C07C4-8BD4-2D93-C014-AC3AA32F8A27}"/>
                </a:ext>
              </a:extLst>
            </p:cNvPr>
            <p:cNvSpPr txBox="1"/>
            <p:nvPr/>
          </p:nvSpPr>
          <p:spPr>
            <a:xfrm rot="16200000">
              <a:off x="809655" y="1196013"/>
              <a:ext cx="930803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Purified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33" name="テキスト ボックス 20">
              <a:extLst>
                <a:ext uri="{FF2B5EF4-FFF2-40B4-BE49-F238E27FC236}">
                  <a16:creationId xmlns:a16="http://schemas.microsoft.com/office/drawing/2014/main" id="{29304709-C2FC-2214-AF4B-2513D094D01A}"/>
                </a:ext>
              </a:extLst>
            </p:cNvPr>
            <p:cNvSpPr txBox="1"/>
            <p:nvPr/>
          </p:nvSpPr>
          <p:spPr>
            <a:xfrm rot="16200000">
              <a:off x="987282" y="1196015"/>
              <a:ext cx="930801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Concentrated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cxnSp>
          <p:nvCxnSpPr>
            <p:cNvPr id="134" name="Straight Connector 17">
              <a:extLst>
                <a:ext uri="{FF2B5EF4-FFF2-40B4-BE49-F238E27FC236}">
                  <a16:creationId xmlns:a16="http://schemas.microsoft.com/office/drawing/2014/main" id="{4194339C-B75E-9FAE-7C2E-2E6788165722}"/>
                </a:ext>
              </a:extLst>
            </p:cNvPr>
            <p:cNvCxnSpPr>
              <a:cxnSpLocks/>
            </p:cNvCxnSpPr>
            <p:nvPr/>
          </p:nvCxnSpPr>
          <p:spPr>
            <a:xfrm>
              <a:off x="798756" y="806718"/>
              <a:ext cx="71213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5" name="TextBox 21">
              <a:extLst>
                <a:ext uri="{FF2B5EF4-FFF2-40B4-BE49-F238E27FC236}">
                  <a16:creationId xmlns:a16="http://schemas.microsoft.com/office/drawing/2014/main" id="{D6AB4DBB-683F-FB32-7337-EB310D9BECE8}"/>
                </a:ext>
              </a:extLst>
            </p:cNvPr>
            <p:cNvSpPr txBox="1"/>
            <p:nvPr/>
          </p:nvSpPr>
          <p:spPr>
            <a:xfrm>
              <a:off x="997917" y="605957"/>
              <a:ext cx="313808" cy="2076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+mj-lt"/>
                  <a:cs typeface="Arial" panose="020B0604020202020204" pitchFamily="34" charset="0"/>
                </a:rPr>
                <a:t>PRM</a:t>
              </a:r>
              <a:endParaRPr 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36" name="テキスト ボックス 29">
              <a:extLst>
                <a:ext uri="{FF2B5EF4-FFF2-40B4-BE49-F238E27FC236}">
                  <a16:creationId xmlns:a16="http://schemas.microsoft.com/office/drawing/2014/main" id="{8262AF3B-4500-1EE2-97E8-BC5FECE946FF}"/>
                </a:ext>
              </a:extLst>
            </p:cNvPr>
            <p:cNvSpPr txBox="1"/>
            <p:nvPr/>
          </p:nvSpPr>
          <p:spPr>
            <a:xfrm>
              <a:off x="3852883" y="3447206"/>
              <a:ext cx="65502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 err="1">
                  <a:latin typeface="+mj-lt"/>
                  <a:cs typeface="Arial" panose="020B0604020202020204" pitchFamily="34" charset="0"/>
                </a:rPr>
                <a:t>rGST</a:t>
              </a:r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 (27kDa)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37" name="三角形 30">
              <a:extLst>
                <a:ext uri="{FF2B5EF4-FFF2-40B4-BE49-F238E27FC236}">
                  <a16:creationId xmlns:a16="http://schemas.microsoft.com/office/drawing/2014/main" id="{00C126AB-3E44-9FDE-8256-97711EF8D345}"/>
                </a:ext>
              </a:extLst>
            </p:cNvPr>
            <p:cNvSpPr/>
            <p:nvPr/>
          </p:nvSpPr>
          <p:spPr>
            <a:xfrm rot="16200000">
              <a:off x="3773004" y="3520981"/>
              <a:ext cx="67232" cy="127379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38" name="テキスト ボックス 14">
              <a:extLst>
                <a:ext uri="{FF2B5EF4-FFF2-40B4-BE49-F238E27FC236}">
                  <a16:creationId xmlns:a16="http://schemas.microsoft.com/office/drawing/2014/main" id="{09842995-A336-FA44-0A76-B2EE361055A5}"/>
                </a:ext>
              </a:extLst>
            </p:cNvPr>
            <p:cNvSpPr txBox="1"/>
            <p:nvPr/>
          </p:nvSpPr>
          <p:spPr>
            <a:xfrm rot="16200000">
              <a:off x="1245564" y="1110636"/>
              <a:ext cx="1101558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Soluble</a:t>
              </a:r>
              <a:r>
                <a:rPr lang="ja-JP" altLang="en-US" sz="900" dirty="0">
                  <a:latin typeface="+mj-lt"/>
                  <a:cs typeface="Arial" panose="020B0604020202020204" pitchFamily="34" charset="0"/>
                </a:rPr>
                <a:t> </a:t>
              </a:r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fraction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39" name="テキスト ボックス 16">
              <a:extLst>
                <a:ext uri="{FF2B5EF4-FFF2-40B4-BE49-F238E27FC236}">
                  <a16:creationId xmlns:a16="http://schemas.microsoft.com/office/drawing/2014/main" id="{85BDF68F-347B-AAF1-F9DF-F4CC82DF4DA2}"/>
                </a:ext>
              </a:extLst>
            </p:cNvPr>
            <p:cNvSpPr txBox="1"/>
            <p:nvPr/>
          </p:nvSpPr>
          <p:spPr>
            <a:xfrm rot="16200000">
              <a:off x="1511467" y="1191702"/>
              <a:ext cx="939427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Inclusion body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40" name="テキスト ボックス 18">
              <a:extLst>
                <a:ext uri="{FF2B5EF4-FFF2-40B4-BE49-F238E27FC236}">
                  <a16:creationId xmlns:a16="http://schemas.microsoft.com/office/drawing/2014/main" id="{9795844F-D870-E44E-FC36-4895A4C28F5A}"/>
                </a:ext>
              </a:extLst>
            </p:cNvPr>
            <p:cNvSpPr txBox="1"/>
            <p:nvPr/>
          </p:nvSpPr>
          <p:spPr>
            <a:xfrm rot="16200000">
              <a:off x="1714068" y="1203572"/>
              <a:ext cx="915688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Purified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41" name="テキスト ボックス 20">
              <a:extLst>
                <a:ext uri="{FF2B5EF4-FFF2-40B4-BE49-F238E27FC236}">
                  <a16:creationId xmlns:a16="http://schemas.microsoft.com/office/drawing/2014/main" id="{9567CADE-1646-7BDC-455F-68C058A9C440}"/>
                </a:ext>
              </a:extLst>
            </p:cNvPr>
            <p:cNvSpPr txBox="1"/>
            <p:nvPr/>
          </p:nvSpPr>
          <p:spPr>
            <a:xfrm rot="16200000">
              <a:off x="1884139" y="1196015"/>
              <a:ext cx="930801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Concentrated</a:t>
              </a:r>
              <a:endParaRPr lang="ja-JP" altLang="en-US" sz="900">
                <a:latin typeface="+mj-lt"/>
                <a:cs typeface="Arial" panose="020B0604020202020204" pitchFamily="34" charset="0"/>
              </a:endParaRPr>
            </a:p>
          </p:txBody>
        </p:sp>
        <p:cxnSp>
          <p:nvCxnSpPr>
            <p:cNvPr id="142" name="Straight Connector 17">
              <a:extLst>
                <a:ext uri="{FF2B5EF4-FFF2-40B4-BE49-F238E27FC236}">
                  <a16:creationId xmlns:a16="http://schemas.microsoft.com/office/drawing/2014/main" id="{55184638-C694-AA36-77B1-5BD0802E339E}"/>
                </a:ext>
              </a:extLst>
            </p:cNvPr>
            <p:cNvCxnSpPr>
              <a:cxnSpLocks/>
            </p:cNvCxnSpPr>
            <p:nvPr/>
          </p:nvCxnSpPr>
          <p:spPr>
            <a:xfrm>
              <a:off x="1725845" y="806718"/>
              <a:ext cx="71213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3" name="TextBox 21">
              <a:extLst>
                <a:ext uri="{FF2B5EF4-FFF2-40B4-BE49-F238E27FC236}">
                  <a16:creationId xmlns:a16="http://schemas.microsoft.com/office/drawing/2014/main" id="{BCA1776D-D52A-5C04-93A5-F2FE5B9A1509}"/>
                </a:ext>
              </a:extLst>
            </p:cNvPr>
            <p:cNvSpPr txBox="1"/>
            <p:nvPr/>
          </p:nvSpPr>
          <p:spPr>
            <a:xfrm>
              <a:off x="1927356" y="605957"/>
              <a:ext cx="309110" cy="2076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+mj-lt"/>
                  <a:cs typeface="Arial" panose="020B0604020202020204" pitchFamily="34" charset="0"/>
                </a:rPr>
                <a:t>TFM</a:t>
              </a:r>
              <a:endParaRPr 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44" name="テキスト ボックス 14">
              <a:extLst>
                <a:ext uri="{FF2B5EF4-FFF2-40B4-BE49-F238E27FC236}">
                  <a16:creationId xmlns:a16="http://schemas.microsoft.com/office/drawing/2014/main" id="{70F1DA38-7AFA-374C-99B7-5318A1FE19D1}"/>
                </a:ext>
              </a:extLst>
            </p:cNvPr>
            <p:cNvSpPr txBox="1"/>
            <p:nvPr/>
          </p:nvSpPr>
          <p:spPr>
            <a:xfrm rot="16200000">
              <a:off x="2115297" y="1110636"/>
              <a:ext cx="1101558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Soluble</a:t>
              </a:r>
              <a:r>
                <a:rPr lang="ja-JP" altLang="en-US" sz="900" dirty="0">
                  <a:latin typeface="+mj-lt"/>
                  <a:cs typeface="Arial" panose="020B0604020202020204" pitchFamily="34" charset="0"/>
                </a:rPr>
                <a:t> </a:t>
              </a:r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fraction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45" name="テキスト ボックス 16">
              <a:extLst>
                <a:ext uri="{FF2B5EF4-FFF2-40B4-BE49-F238E27FC236}">
                  <a16:creationId xmlns:a16="http://schemas.microsoft.com/office/drawing/2014/main" id="{6666FC6C-144C-00E2-DCBA-F858CEAE23DB}"/>
                </a:ext>
              </a:extLst>
            </p:cNvPr>
            <p:cNvSpPr txBox="1"/>
            <p:nvPr/>
          </p:nvSpPr>
          <p:spPr>
            <a:xfrm rot="16200000">
              <a:off x="2361679" y="1155189"/>
              <a:ext cx="1012453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Inclusion body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46" name="テキスト ボックス 18">
              <a:extLst>
                <a:ext uri="{FF2B5EF4-FFF2-40B4-BE49-F238E27FC236}">
                  <a16:creationId xmlns:a16="http://schemas.microsoft.com/office/drawing/2014/main" id="{2AE654B0-7267-335D-CC4F-680CF9A5D069}"/>
                </a:ext>
              </a:extLst>
            </p:cNvPr>
            <p:cNvSpPr txBox="1"/>
            <p:nvPr/>
          </p:nvSpPr>
          <p:spPr>
            <a:xfrm rot="16200000">
              <a:off x="2686801" y="1260091"/>
              <a:ext cx="802649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Purified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47" name="テキスト ボックス 20">
              <a:extLst>
                <a:ext uri="{FF2B5EF4-FFF2-40B4-BE49-F238E27FC236}">
                  <a16:creationId xmlns:a16="http://schemas.microsoft.com/office/drawing/2014/main" id="{969AAF6B-99BA-2E73-6401-2AAEA9C3F50F}"/>
                </a:ext>
              </a:extLst>
            </p:cNvPr>
            <p:cNvSpPr txBox="1"/>
            <p:nvPr/>
          </p:nvSpPr>
          <p:spPr>
            <a:xfrm rot="16200000">
              <a:off x="2814394" y="1196015"/>
              <a:ext cx="930800" cy="169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Concentrated</a:t>
              </a:r>
              <a:endParaRPr lang="ja-JP" altLang="en-US" sz="900" dirty="0">
                <a:latin typeface="+mj-lt"/>
                <a:cs typeface="Arial" panose="020B0604020202020204" pitchFamily="34" charset="0"/>
              </a:endParaRPr>
            </a:p>
          </p:txBody>
        </p:sp>
        <p:cxnSp>
          <p:nvCxnSpPr>
            <p:cNvPr id="148" name="Straight Connector 17">
              <a:extLst>
                <a:ext uri="{FF2B5EF4-FFF2-40B4-BE49-F238E27FC236}">
                  <a16:creationId xmlns:a16="http://schemas.microsoft.com/office/drawing/2014/main" id="{5EF395D4-89DA-FBAA-2CF2-37F876BD38ED}"/>
                </a:ext>
              </a:extLst>
            </p:cNvPr>
            <p:cNvCxnSpPr>
              <a:cxnSpLocks/>
            </p:cNvCxnSpPr>
            <p:nvPr/>
          </p:nvCxnSpPr>
          <p:spPr>
            <a:xfrm>
              <a:off x="2617031" y="806718"/>
              <a:ext cx="71213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9" name="TextBox 21">
              <a:extLst>
                <a:ext uri="{FF2B5EF4-FFF2-40B4-BE49-F238E27FC236}">
                  <a16:creationId xmlns:a16="http://schemas.microsoft.com/office/drawing/2014/main" id="{32D4F95F-32C5-6B82-789A-14361B78556C}"/>
                </a:ext>
              </a:extLst>
            </p:cNvPr>
            <p:cNvSpPr txBox="1"/>
            <p:nvPr/>
          </p:nvSpPr>
          <p:spPr>
            <a:xfrm>
              <a:off x="2813844" y="605957"/>
              <a:ext cx="318505" cy="2076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+mj-lt"/>
                  <a:cs typeface="Arial" panose="020B0604020202020204" pitchFamily="34" charset="0"/>
                </a:rPr>
                <a:t>NFM</a:t>
              </a:r>
              <a:endParaRPr lang="en-US" sz="9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F5C897DC-2601-AF01-985C-311D4EDB3E73}"/>
                </a:ext>
              </a:extLst>
            </p:cNvPr>
            <p:cNvSpPr txBox="1"/>
            <p:nvPr/>
          </p:nvSpPr>
          <p:spPr>
            <a:xfrm>
              <a:off x="573235" y="1487275"/>
              <a:ext cx="365903" cy="2076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</a:rPr>
                <a:t>M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938741EE-49CC-9F33-3EAB-9ED071E22B48}"/>
                </a:ext>
              </a:extLst>
            </p:cNvPr>
            <p:cNvSpPr txBox="1"/>
            <p:nvPr/>
          </p:nvSpPr>
          <p:spPr>
            <a:xfrm>
              <a:off x="1528934" y="1487275"/>
              <a:ext cx="365903" cy="2076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</a:rPr>
                <a:t>M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90504385-1A91-2F5C-9F54-4CC1981F1A51}"/>
                </a:ext>
              </a:extLst>
            </p:cNvPr>
            <p:cNvSpPr txBox="1"/>
            <p:nvPr/>
          </p:nvSpPr>
          <p:spPr>
            <a:xfrm>
              <a:off x="3338667" y="1487275"/>
              <a:ext cx="365903" cy="2076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</a:rPr>
                <a:t>M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CE6A293A-F3CF-8057-42BC-5B3CA862F7A7}"/>
                </a:ext>
              </a:extLst>
            </p:cNvPr>
            <p:cNvSpPr txBox="1"/>
            <p:nvPr/>
          </p:nvSpPr>
          <p:spPr>
            <a:xfrm>
              <a:off x="2407956" y="1487275"/>
              <a:ext cx="365903" cy="2076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</a:rPr>
                <a:t>M</a:t>
              </a:r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CFF3DB77-58C3-7CE4-F32F-EB4E47534653}"/>
                </a:ext>
              </a:extLst>
            </p:cNvPr>
            <p:cNvSpPr/>
            <p:nvPr/>
          </p:nvSpPr>
          <p:spPr>
            <a:xfrm>
              <a:off x="560028" y="2692167"/>
              <a:ext cx="3054990" cy="135374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bg1"/>
                  </a:solidFill>
                </a:ln>
                <a:noFill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7D0BC3D-7AE9-0BF1-6DAC-BBD135FB2323}"/>
              </a:ext>
            </a:extLst>
          </p:cNvPr>
          <p:cNvSpPr txBox="1"/>
          <p:nvPr/>
        </p:nvSpPr>
        <p:spPr>
          <a:xfrm>
            <a:off x="61404" y="248493"/>
            <a:ext cx="4136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The uncropped figure for figure 3(a)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7EE9D5-6D3C-715E-3801-4A83A97132C5}"/>
              </a:ext>
            </a:extLst>
          </p:cNvPr>
          <p:cNvSpPr txBox="1"/>
          <p:nvPr/>
        </p:nvSpPr>
        <p:spPr>
          <a:xfrm>
            <a:off x="69919" y="4986744"/>
            <a:ext cx="4136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The uncropped figure for figure 3(b). </a:t>
            </a:r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E1369DDA-1104-4965-64DD-34530542FD03}"/>
              </a:ext>
            </a:extLst>
          </p:cNvPr>
          <p:cNvGrpSpPr/>
          <p:nvPr/>
        </p:nvGrpSpPr>
        <p:grpSpPr>
          <a:xfrm>
            <a:off x="61404" y="5418907"/>
            <a:ext cx="3812918" cy="4142545"/>
            <a:chOff x="39965" y="5395043"/>
            <a:chExt cx="3812918" cy="4142545"/>
          </a:xfrm>
        </p:grpSpPr>
        <p:grpSp>
          <p:nvGrpSpPr>
            <p:cNvPr id="166" name="Group 165">
              <a:extLst>
                <a:ext uri="{FF2B5EF4-FFF2-40B4-BE49-F238E27FC236}">
                  <a16:creationId xmlns:a16="http://schemas.microsoft.com/office/drawing/2014/main" id="{CAD61F9D-184D-44A8-C0EB-64F3B80EC545}"/>
                </a:ext>
              </a:extLst>
            </p:cNvPr>
            <p:cNvGrpSpPr/>
            <p:nvPr/>
          </p:nvGrpSpPr>
          <p:grpSpPr>
            <a:xfrm>
              <a:off x="548671" y="5395043"/>
              <a:ext cx="3304212" cy="4142545"/>
              <a:chOff x="673406" y="5313040"/>
              <a:chExt cx="3304212" cy="4142545"/>
            </a:xfrm>
          </p:grpSpPr>
          <p:pic>
            <p:nvPicPr>
              <p:cNvPr id="74" name="Picture 73" descr="A close-up of a test tube&#10;&#10;Description automatically generated">
                <a:extLst>
                  <a:ext uri="{FF2B5EF4-FFF2-40B4-BE49-F238E27FC236}">
                    <a16:creationId xmlns:a16="http://schemas.microsoft.com/office/drawing/2014/main" id="{A15DA48E-08CF-7485-7D81-F32452CE24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3406" y="6367961"/>
                <a:ext cx="2404872" cy="3087624"/>
              </a:xfrm>
              <a:prstGeom prst="rect">
                <a:avLst/>
              </a:prstGeom>
            </p:spPr>
          </p:pic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B680E381-68CC-92A5-CA0E-4BECB3A7E816}"/>
                  </a:ext>
                </a:extLst>
              </p:cNvPr>
              <p:cNvSpPr txBox="1"/>
              <p:nvPr/>
            </p:nvSpPr>
            <p:spPr>
              <a:xfrm>
                <a:off x="906222" y="5313040"/>
                <a:ext cx="45588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+mj-lt"/>
                  </a:rPr>
                  <a:t>PRM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1E163D41-6710-E64C-3CED-BE13453B1630}"/>
                  </a:ext>
                </a:extLst>
              </p:cNvPr>
              <p:cNvSpPr txBox="1"/>
              <p:nvPr/>
            </p:nvSpPr>
            <p:spPr>
              <a:xfrm flipH="1">
                <a:off x="1646499" y="5313040"/>
                <a:ext cx="455882" cy="228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+mj-lt"/>
                  </a:rPr>
                  <a:t>TFM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6688E404-5E00-B17D-CD2C-C6CACB3BF4B2}"/>
                  </a:ext>
                </a:extLst>
              </p:cNvPr>
              <p:cNvSpPr txBox="1"/>
              <p:nvPr/>
            </p:nvSpPr>
            <p:spPr>
              <a:xfrm>
                <a:off x="2398459" y="5313041"/>
                <a:ext cx="605909" cy="228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+mj-lt"/>
                  </a:rPr>
                  <a:t>NFM</a:t>
                </a:r>
              </a:p>
            </p:txBody>
          </p:sp>
          <p:sp>
            <p:nvSpPr>
              <p:cNvPr id="83" name="テキスト ボックス 18">
                <a:extLst>
                  <a:ext uri="{FF2B5EF4-FFF2-40B4-BE49-F238E27FC236}">
                    <a16:creationId xmlns:a16="http://schemas.microsoft.com/office/drawing/2014/main" id="{6236D678-88F0-FF2A-A815-074317FA7220}"/>
                  </a:ext>
                </a:extLst>
              </p:cNvPr>
              <p:cNvSpPr txBox="1"/>
              <p:nvPr/>
            </p:nvSpPr>
            <p:spPr>
              <a:xfrm rot="16200000">
                <a:off x="525495" y="5787174"/>
                <a:ext cx="1021921" cy="18113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900" dirty="0">
                    <a:latin typeface="+mj-lt"/>
                    <a:cs typeface="Arial" panose="020B0604020202020204" pitchFamily="34" charset="0"/>
                  </a:rPr>
                  <a:t>Purified</a:t>
                </a:r>
                <a:endParaRPr lang="ja-JP" altLang="en-US" sz="9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88" name="テキスト ボックス 20">
                <a:extLst>
                  <a:ext uri="{FF2B5EF4-FFF2-40B4-BE49-F238E27FC236}">
                    <a16:creationId xmlns:a16="http://schemas.microsoft.com/office/drawing/2014/main" id="{3CB9D237-3610-BC29-7A69-FF6CF35AA0D1}"/>
                  </a:ext>
                </a:extLst>
              </p:cNvPr>
              <p:cNvSpPr txBox="1"/>
              <p:nvPr/>
            </p:nvSpPr>
            <p:spPr>
              <a:xfrm rot="16200000">
                <a:off x="771384" y="5809568"/>
                <a:ext cx="1021918" cy="18113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900" dirty="0">
                    <a:latin typeface="+mj-lt"/>
                    <a:cs typeface="Arial" panose="020B0604020202020204" pitchFamily="34" charset="0"/>
                  </a:rPr>
                  <a:t>Concentrated</a:t>
                </a:r>
                <a:endParaRPr lang="ja-JP" altLang="en-US" sz="9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89" name="テキスト ボックス 18">
                <a:extLst>
                  <a:ext uri="{FF2B5EF4-FFF2-40B4-BE49-F238E27FC236}">
                    <a16:creationId xmlns:a16="http://schemas.microsoft.com/office/drawing/2014/main" id="{FC441C92-A87D-315A-8D91-6368BAA14E73}"/>
                  </a:ext>
                </a:extLst>
              </p:cNvPr>
              <p:cNvSpPr txBox="1"/>
              <p:nvPr/>
            </p:nvSpPr>
            <p:spPr>
              <a:xfrm rot="16200000">
                <a:off x="1270097" y="5793697"/>
                <a:ext cx="1021921" cy="18113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900" dirty="0">
                    <a:latin typeface="+mj-lt"/>
                    <a:cs typeface="Arial" panose="020B0604020202020204" pitchFamily="34" charset="0"/>
                  </a:rPr>
                  <a:t>Purified</a:t>
                </a:r>
                <a:endParaRPr lang="ja-JP" altLang="en-US" sz="9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90" name="テキスト ボックス 20">
                <a:extLst>
                  <a:ext uri="{FF2B5EF4-FFF2-40B4-BE49-F238E27FC236}">
                    <a16:creationId xmlns:a16="http://schemas.microsoft.com/office/drawing/2014/main" id="{B929C0CD-8193-691A-B0A9-D917BB3CA9C1}"/>
                  </a:ext>
                </a:extLst>
              </p:cNvPr>
              <p:cNvSpPr txBox="1"/>
              <p:nvPr/>
            </p:nvSpPr>
            <p:spPr>
              <a:xfrm rot="16200000">
                <a:off x="1492431" y="5787175"/>
                <a:ext cx="1021918" cy="18113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900" dirty="0">
                    <a:latin typeface="+mj-lt"/>
                    <a:cs typeface="Arial" panose="020B0604020202020204" pitchFamily="34" charset="0"/>
                  </a:rPr>
                  <a:t>Concentrated</a:t>
                </a:r>
                <a:endParaRPr lang="ja-JP" altLang="en-US" sz="9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105" name="テキスト ボックス 18">
                <a:extLst>
                  <a:ext uri="{FF2B5EF4-FFF2-40B4-BE49-F238E27FC236}">
                    <a16:creationId xmlns:a16="http://schemas.microsoft.com/office/drawing/2014/main" id="{50303C1D-699D-A0A2-7475-974B71101208}"/>
                  </a:ext>
                </a:extLst>
              </p:cNvPr>
              <p:cNvSpPr txBox="1"/>
              <p:nvPr/>
            </p:nvSpPr>
            <p:spPr>
              <a:xfrm rot="16200000">
                <a:off x="1948311" y="5787174"/>
                <a:ext cx="1021921" cy="18113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900" dirty="0">
                    <a:latin typeface="+mj-lt"/>
                    <a:cs typeface="Arial" panose="020B0604020202020204" pitchFamily="34" charset="0"/>
                  </a:rPr>
                  <a:t>Purified</a:t>
                </a:r>
                <a:endParaRPr lang="ja-JP" altLang="en-US" sz="9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109" name="テキスト ボックス 20">
                <a:extLst>
                  <a:ext uri="{FF2B5EF4-FFF2-40B4-BE49-F238E27FC236}">
                    <a16:creationId xmlns:a16="http://schemas.microsoft.com/office/drawing/2014/main" id="{2FDE83E2-04EF-0852-D4E3-C0DE292BF571}"/>
                  </a:ext>
                </a:extLst>
              </p:cNvPr>
              <p:cNvSpPr txBox="1"/>
              <p:nvPr/>
            </p:nvSpPr>
            <p:spPr>
              <a:xfrm rot="16200000">
                <a:off x="2178541" y="5762326"/>
                <a:ext cx="10403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900" dirty="0">
                    <a:latin typeface="+mj-lt"/>
                    <a:cs typeface="Arial" panose="020B0604020202020204" pitchFamily="34" charset="0"/>
                  </a:rPr>
                  <a:t>Concentrated</a:t>
                </a:r>
                <a:endParaRPr lang="ja-JP" altLang="en-US" sz="900" dirty="0">
                  <a:latin typeface="+mj-lt"/>
                  <a:cs typeface="Arial" panose="020B0604020202020204" pitchFamily="34" charset="0"/>
                </a:endParaRPr>
              </a:p>
            </p:txBody>
          </p:sp>
          <p:cxnSp>
            <p:nvCxnSpPr>
              <p:cNvPr id="110" name="Straight Connector 109">
                <a:extLst>
                  <a:ext uri="{FF2B5EF4-FFF2-40B4-BE49-F238E27FC236}">
                    <a16:creationId xmlns:a16="http://schemas.microsoft.com/office/drawing/2014/main" id="{C9401E81-B4BA-4BED-650D-31E614A6E7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9015" y="5539011"/>
                <a:ext cx="565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>
                <a:extLst>
                  <a:ext uri="{FF2B5EF4-FFF2-40B4-BE49-F238E27FC236}">
                    <a16:creationId xmlns:a16="http://schemas.microsoft.com/office/drawing/2014/main" id="{833CA6FC-7850-22BA-BF87-B148F5CB99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7675" y="5539011"/>
                <a:ext cx="565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>
                <a:extLst>
                  <a:ext uri="{FF2B5EF4-FFF2-40B4-BE49-F238E27FC236}">
                    <a16:creationId xmlns:a16="http://schemas.microsoft.com/office/drawing/2014/main" id="{74A54F5D-F53D-05D9-CD41-C78682CAF4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24650" y="5539011"/>
                <a:ext cx="565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B40FD145-B1F0-16D8-6367-EFBE237E76B9}"/>
                  </a:ext>
                </a:extLst>
              </p:cNvPr>
              <p:cNvSpPr txBox="1"/>
              <p:nvPr/>
            </p:nvSpPr>
            <p:spPr>
              <a:xfrm>
                <a:off x="719200" y="6137872"/>
                <a:ext cx="225418" cy="2280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+mj-lt"/>
                  </a:rPr>
                  <a:t>M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1C165301-5636-C55A-79EA-7296549142C6}"/>
                  </a:ext>
                </a:extLst>
              </p:cNvPr>
              <p:cNvSpPr txBox="1"/>
              <p:nvPr/>
            </p:nvSpPr>
            <p:spPr>
              <a:xfrm>
                <a:off x="1439735" y="6146930"/>
                <a:ext cx="225418" cy="2280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+mj-lt"/>
                  </a:rPr>
                  <a:t>M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3908002A-C3C8-74D8-D989-DC29DA59BDE2}"/>
                  </a:ext>
                </a:extLst>
              </p:cNvPr>
              <p:cNvSpPr txBox="1"/>
              <p:nvPr/>
            </p:nvSpPr>
            <p:spPr>
              <a:xfrm>
                <a:off x="2110235" y="6146930"/>
                <a:ext cx="225418" cy="2280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+mj-lt"/>
                  </a:rPr>
                  <a:t>M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E244F636-75C0-F1F3-C415-8F38BBA8F862}"/>
                  </a:ext>
                </a:extLst>
              </p:cNvPr>
              <p:cNvSpPr txBox="1"/>
              <p:nvPr/>
            </p:nvSpPr>
            <p:spPr>
              <a:xfrm>
                <a:off x="2845410" y="6137872"/>
                <a:ext cx="225418" cy="2280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+mj-lt"/>
                  </a:rPr>
                  <a:t>M</a:t>
                </a:r>
              </a:p>
            </p:txBody>
          </p:sp>
          <p:sp>
            <p:nvSpPr>
              <p:cNvPr id="118" name="テキスト ボックス 29">
                <a:extLst>
                  <a:ext uri="{FF2B5EF4-FFF2-40B4-BE49-F238E27FC236}">
                    <a16:creationId xmlns:a16="http://schemas.microsoft.com/office/drawing/2014/main" id="{C320658C-7E07-14A4-B764-4AD86D2B29E3}"/>
                  </a:ext>
                </a:extLst>
              </p:cNvPr>
              <p:cNvSpPr txBox="1"/>
              <p:nvPr/>
            </p:nvSpPr>
            <p:spPr>
              <a:xfrm>
                <a:off x="3276034" y="8555427"/>
                <a:ext cx="701584" cy="36484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900" dirty="0" err="1">
                    <a:latin typeface="+mj-lt"/>
                    <a:cs typeface="Arial" panose="020B0604020202020204" pitchFamily="34" charset="0"/>
                  </a:rPr>
                  <a:t>rGST</a:t>
                </a:r>
                <a:endParaRPr lang="en-US" altLang="ja-JP" sz="900" dirty="0">
                  <a:latin typeface="+mj-lt"/>
                  <a:cs typeface="Arial" panose="020B0604020202020204" pitchFamily="34" charset="0"/>
                </a:endParaRPr>
              </a:p>
              <a:p>
                <a:r>
                  <a:rPr lang="en-US" altLang="ja-JP" sz="900" dirty="0">
                    <a:latin typeface="+mj-lt"/>
                    <a:cs typeface="Arial" panose="020B0604020202020204" pitchFamily="34" charset="0"/>
                  </a:rPr>
                  <a:t> (27kDa)</a:t>
                </a:r>
                <a:endParaRPr lang="ja-JP" altLang="en-US" sz="9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119" name="三角形 30">
                <a:extLst>
                  <a:ext uri="{FF2B5EF4-FFF2-40B4-BE49-F238E27FC236}">
                    <a16:creationId xmlns:a16="http://schemas.microsoft.com/office/drawing/2014/main" id="{DFB9BEEA-0438-AFFC-2396-54D11C1FB090}"/>
                  </a:ext>
                </a:extLst>
              </p:cNvPr>
              <p:cNvSpPr/>
              <p:nvPr/>
            </p:nvSpPr>
            <p:spPr>
              <a:xfrm rot="16200000">
                <a:off x="3102138" y="8694451"/>
                <a:ext cx="73813" cy="136433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0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165" name="Rectangle 164">
                <a:extLst>
                  <a:ext uri="{FF2B5EF4-FFF2-40B4-BE49-F238E27FC236}">
                    <a16:creationId xmlns:a16="http://schemas.microsoft.com/office/drawing/2014/main" id="{6D681BD4-43B4-14A4-72E3-444F5BB5F1C1}"/>
                  </a:ext>
                </a:extLst>
              </p:cNvPr>
              <p:cNvSpPr/>
              <p:nvPr/>
            </p:nvSpPr>
            <p:spPr>
              <a:xfrm>
                <a:off x="719200" y="7800975"/>
                <a:ext cx="2351628" cy="154255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9B0BA800-0A4C-4931-48FF-F03F229109B0}"/>
                </a:ext>
              </a:extLst>
            </p:cNvPr>
            <p:cNvGrpSpPr/>
            <p:nvPr/>
          </p:nvGrpSpPr>
          <p:grpSpPr>
            <a:xfrm>
              <a:off x="39965" y="6167964"/>
              <a:ext cx="620412" cy="3265448"/>
              <a:chOff x="39965" y="6167964"/>
              <a:chExt cx="620412" cy="3265448"/>
            </a:xfrm>
          </p:grpSpPr>
          <p:sp>
            <p:nvSpPr>
              <p:cNvPr id="42" name="TextBox 25">
                <a:extLst>
                  <a:ext uri="{FF2B5EF4-FFF2-40B4-BE49-F238E27FC236}">
                    <a16:creationId xmlns:a16="http://schemas.microsoft.com/office/drawing/2014/main" id="{3D578E64-0F0C-C44D-66DB-20CC2B3E4A4B}"/>
                  </a:ext>
                </a:extLst>
              </p:cNvPr>
              <p:cNvSpPr txBox="1"/>
              <p:nvPr/>
            </p:nvSpPr>
            <p:spPr>
              <a:xfrm>
                <a:off x="156858" y="8867934"/>
                <a:ext cx="336009" cy="239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43" name="TextBox 26">
                <a:extLst>
                  <a:ext uri="{FF2B5EF4-FFF2-40B4-BE49-F238E27FC236}">
                    <a16:creationId xmlns:a16="http://schemas.microsoft.com/office/drawing/2014/main" id="{D3D28305-F710-31A1-EF2C-2B91AA872F9F}"/>
                  </a:ext>
                </a:extLst>
              </p:cNvPr>
              <p:cNvSpPr txBox="1"/>
              <p:nvPr/>
            </p:nvSpPr>
            <p:spPr>
              <a:xfrm>
                <a:off x="147556" y="7768068"/>
                <a:ext cx="336008" cy="239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44" name="TextBox 27">
                <a:extLst>
                  <a:ext uri="{FF2B5EF4-FFF2-40B4-BE49-F238E27FC236}">
                    <a16:creationId xmlns:a16="http://schemas.microsoft.com/office/drawing/2014/main" id="{4B76398E-1252-CE4B-6125-4D15CE7A7D3F}"/>
                  </a:ext>
                </a:extLst>
              </p:cNvPr>
              <p:cNvSpPr txBox="1"/>
              <p:nvPr/>
            </p:nvSpPr>
            <p:spPr>
              <a:xfrm>
                <a:off x="139127" y="8156771"/>
                <a:ext cx="336008" cy="239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37</a:t>
                </a:r>
              </a:p>
            </p:txBody>
          </p:sp>
          <p:cxnSp>
            <p:nvCxnSpPr>
              <p:cNvPr id="45" name="Straight Connector 32">
                <a:extLst>
                  <a:ext uri="{FF2B5EF4-FFF2-40B4-BE49-F238E27FC236}">
                    <a16:creationId xmlns:a16="http://schemas.microsoft.com/office/drawing/2014/main" id="{08C9D8AD-507E-FB37-EA6E-BDDB2FA523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8863" y="8985448"/>
                <a:ext cx="10306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33">
                <a:extLst>
                  <a:ext uri="{FF2B5EF4-FFF2-40B4-BE49-F238E27FC236}">
                    <a16:creationId xmlns:a16="http://schemas.microsoft.com/office/drawing/2014/main" id="{A5C5773B-75E2-63D5-CE18-A056F9CEB2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9748" y="8271319"/>
                <a:ext cx="107665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34">
                <a:extLst>
                  <a:ext uri="{FF2B5EF4-FFF2-40B4-BE49-F238E27FC236}">
                    <a16:creationId xmlns:a16="http://schemas.microsoft.com/office/drawing/2014/main" id="{118BA710-8D38-4A2D-4E02-FFEEB23079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9748" y="7887750"/>
                <a:ext cx="10306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39">
                <a:extLst>
                  <a:ext uri="{FF2B5EF4-FFF2-40B4-BE49-F238E27FC236}">
                    <a16:creationId xmlns:a16="http://schemas.microsoft.com/office/drawing/2014/main" id="{59F74619-998D-6DC0-F021-8E8977F736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9496" y="9201472"/>
                <a:ext cx="10306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9" name="TextBox 40">
                <a:extLst>
                  <a:ext uri="{FF2B5EF4-FFF2-40B4-BE49-F238E27FC236}">
                    <a16:creationId xmlns:a16="http://schemas.microsoft.com/office/drawing/2014/main" id="{354F1E04-327C-E120-A23A-5C27E344E44C}"/>
                  </a:ext>
                </a:extLst>
              </p:cNvPr>
              <p:cNvSpPr txBox="1"/>
              <p:nvPr/>
            </p:nvSpPr>
            <p:spPr>
              <a:xfrm>
                <a:off x="165338" y="9068933"/>
                <a:ext cx="3360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25242C6C-95AF-ED72-3C7C-0500889CBBD1}"/>
                  </a:ext>
                </a:extLst>
              </p:cNvPr>
              <p:cNvSpPr txBox="1"/>
              <p:nvPr/>
            </p:nvSpPr>
            <p:spPr>
              <a:xfrm>
                <a:off x="147556" y="6167964"/>
                <a:ext cx="512821" cy="239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err="1">
                    <a:latin typeface="+mj-lt"/>
                  </a:rPr>
                  <a:t>kDa</a:t>
                </a:r>
                <a:endParaRPr lang="en-US" sz="900" dirty="0">
                  <a:latin typeface="+mj-lt"/>
                </a:endParaRPr>
              </a:p>
            </p:txBody>
          </p:sp>
          <p:cxnSp>
            <p:nvCxnSpPr>
              <p:cNvPr id="51" name="Straight Connector 34">
                <a:extLst>
                  <a:ext uri="{FF2B5EF4-FFF2-40B4-BE49-F238E27FC236}">
                    <a16:creationId xmlns:a16="http://schemas.microsoft.com/office/drawing/2014/main" id="{C5DCF2E3-578F-F1C8-726E-4B9658B70C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2130" y="6456483"/>
                <a:ext cx="10306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34">
                <a:extLst>
                  <a:ext uri="{FF2B5EF4-FFF2-40B4-BE49-F238E27FC236}">
                    <a16:creationId xmlns:a16="http://schemas.microsoft.com/office/drawing/2014/main" id="{A1342A58-B724-0939-E8C8-B3C5078C90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7332" y="6681192"/>
                <a:ext cx="10306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34">
                <a:extLst>
                  <a:ext uri="{FF2B5EF4-FFF2-40B4-BE49-F238E27FC236}">
                    <a16:creationId xmlns:a16="http://schemas.microsoft.com/office/drawing/2014/main" id="{50592377-BDEC-E0FB-E5A9-FBDA170B89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1049" y="6960881"/>
                <a:ext cx="10306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34">
                <a:extLst>
                  <a:ext uri="{FF2B5EF4-FFF2-40B4-BE49-F238E27FC236}">
                    <a16:creationId xmlns:a16="http://schemas.microsoft.com/office/drawing/2014/main" id="{F3BA6159-CE71-D736-D939-E788B26B2D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9817" y="7229612"/>
                <a:ext cx="10306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39">
                <a:extLst>
                  <a:ext uri="{FF2B5EF4-FFF2-40B4-BE49-F238E27FC236}">
                    <a16:creationId xmlns:a16="http://schemas.microsoft.com/office/drawing/2014/main" id="{81F96D71-6B19-498C-1463-EBE8C95F61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371" y="9345488"/>
                <a:ext cx="10306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8" name="TextBox 40">
                <a:extLst>
                  <a:ext uri="{FF2B5EF4-FFF2-40B4-BE49-F238E27FC236}">
                    <a16:creationId xmlns:a16="http://schemas.microsoft.com/office/drawing/2014/main" id="{4DCC3A07-79FA-EFBD-BC23-5603D83C1355}"/>
                  </a:ext>
                </a:extLst>
              </p:cNvPr>
              <p:cNvSpPr txBox="1"/>
              <p:nvPr/>
            </p:nvSpPr>
            <p:spPr>
              <a:xfrm>
                <a:off x="156858" y="9202580"/>
                <a:ext cx="30601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60" name="TextBox 26">
                <a:extLst>
                  <a:ext uri="{FF2B5EF4-FFF2-40B4-BE49-F238E27FC236}">
                    <a16:creationId xmlns:a16="http://schemas.microsoft.com/office/drawing/2014/main" id="{975E567C-332C-F0A8-8AA7-98651509FF82}"/>
                  </a:ext>
                </a:extLst>
              </p:cNvPr>
              <p:cNvSpPr txBox="1"/>
              <p:nvPr/>
            </p:nvSpPr>
            <p:spPr>
              <a:xfrm>
                <a:off x="39965" y="6324383"/>
                <a:ext cx="42496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250</a:t>
                </a:r>
              </a:p>
            </p:txBody>
          </p:sp>
          <p:sp>
            <p:nvSpPr>
              <p:cNvPr id="61" name="TextBox 26">
                <a:extLst>
                  <a:ext uri="{FF2B5EF4-FFF2-40B4-BE49-F238E27FC236}">
                    <a16:creationId xmlns:a16="http://schemas.microsoft.com/office/drawing/2014/main" id="{85E8E0EB-783C-21FF-F7CB-578663EEF280}"/>
                  </a:ext>
                </a:extLst>
              </p:cNvPr>
              <p:cNvSpPr txBox="1"/>
              <p:nvPr/>
            </p:nvSpPr>
            <p:spPr>
              <a:xfrm>
                <a:off x="45696" y="6554792"/>
                <a:ext cx="3744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2" name="TextBox 26">
                <a:extLst>
                  <a:ext uri="{FF2B5EF4-FFF2-40B4-BE49-F238E27FC236}">
                    <a16:creationId xmlns:a16="http://schemas.microsoft.com/office/drawing/2014/main" id="{AEB56210-4B02-E64B-9031-8207300192FC}"/>
                  </a:ext>
                </a:extLst>
              </p:cNvPr>
              <p:cNvSpPr txBox="1"/>
              <p:nvPr/>
            </p:nvSpPr>
            <p:spPr>
              <a:xfrm>
                <a:off x="47228" y="6837831"/>
                <a:ext cx="41450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64" name="TextBox 26">
                <a:extLst>
                  <a:ext uri="{FF2B5EF4-FFF2-40B4-BE49-F238E27FC236}">
                    <a16:creationId xmlns:a16="http://schemas.microsoft.com/office/drawing/2014/main" id="{7B8A600F-87B5-D239-5819-D550960D777B}"/>
                  </a:ext>
                </a:extLst>
              </p:cNvPr>
              <p:cNvSpPr txBox="1"/>
              <p:nvPr/>
            </p:nvSpPr>
            <p:spPr>
              <a:xfrm>
                <a:off x="98911" y="7090587"/>
                <a:ext cx="3198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+mj-lt"/>
                    <a:cs typeface="Arial" panose="020B0604020202020204" pitchFamily="34" charset="0"/>
                  </a:rPr>
                  <a:t>75</a:t>
                </a:r>
              </a:p>
            </p:txBody>
          </p:sp>
        </p:grp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332FF9C2-2493-580D-5CA7-B562EAAE5FBE}"/>
              </a:ext>
            </a:extLst>
          </p:cNvPr>
          <p:cNvGrpSpPr/>
          <p:nvPr/>
        </p:nvGrpSpPr>
        <p:grpSpPr>
          <a:xfrm>
            <a:off x="176420" y="1433442"/>
            <a:ext cx="630542" cy="2615521"/>
            <a:chOff x="39965" y="6097155"/>
            <a:chExt cx="641567" cy="3324675"/>
          </a:xfrm>
        </p:grpSpPr>
        <p:sp>
          <p:nvSpPr>
            <p:cNvPr id="101" name="TextBox 25">
              <a:extLst>
                <a:ext uri="{FF2B5EF4-FFF2-40B4-BE49-F238E27FC236}">
                  <a16:creationId xmlns:a16="http://schemas.microsoft.com/office/drawing/2014/main" id="{87676956-8808-8491-7B7F-850E16FEB686}"/>
                </a:ext>
              </a:extLst>
            </p:cNvPr>
            <p:cNvSpPr txBox="1"/>
            <p:nvPr/>
          </p:nvSpPr>
          <p:spPr>
            <a:xfrm>
              <a:off x="156858" y="8867934"/>
              <a:ext cx="336009" cy="239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02" name="TextBox 26">
              <a:extLst>
                <a:ext uri="{FF2B5EF4-FFF2-40B4-BE49-F238E27FC236}">
                  <a16:creationId xmlns:a16="http://schemas.microsoft.com/office/drawing/2014/main" id="{E80D93CE-62F4-0CA6-9BAA-43808F8FCAE0}"/>
                </a:ext>
              </a:extLst>
            </p:cNvPr>
            <p:cNvSpPr txBox="1"/>
            <p:nvPr/>
          </p:nvSpPr>
          <p:spPr>
            <a:xfrm>
              <a:off x="95764" y="7549656"/>
              <a:ext cx="336008" cy="239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03" name="TextBox 27">
              <a:extLst>
                <a:ext uri="{FF2B5EF4-FFF2-40B4-BE49-F238E27FC236}">
                  <a16:creationId xmlns:a16="http://schemas.microsoft.com/office/drawing/2014/main" id="{B6506A3E-D5B0-0D0C-52C9-A74D866B9EEB}"/>
                </a:ext>
              </a:extLst>
            </p:cNvPr>
            <p:cNvSpPr txBox="1"/>
            <p:nvPr/>
          </p:nvSpPr>
          <p:spPr>
            <a:xfrm>
              <a:off x="133486" y="8055746"/>
              <a:ext cx="336008" cy="239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  <a:cs typeface="Arial" panose="020B0604020202020204" pitchFamily="34" charset="0"/>
                </a:rPr>
                <a:t>37</a:t>
              </a:r>
            </a:p>
          </p:txBody>
        </p:sp>
        <p:cxnSp>
          <p:nvCxnSpPr>
            <p:cNvPr id="104" name="Straight Connector 32">
              <a:extLst>
                <a:ext uri="{FF2B5EF4-FFF2-40B4-BE49-F238E27FC236}">
                  <a16:creationId xmlns:a16="http://schemas.microsoft.com/office/drawing/2014/main" id="{829FA189-DE28-2589-0060-14B1047252BF}"/>
                </a:ext>
              </a:extLst>
            </p:cNvPr>
            <p:cNvCxnSpPr>
              <a:cxnSpLocks/>
            </p:cNvCxnSpPr>
            <p:nvPr/>
          </p:nvCxnSpPr>
          <p:spPr>
            <a:xfrm>
              <a:off x="408863" y="8985448"/>
              <a:ext cx="10306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Straight Connector 33">
              <a:extLst>
                <a:ext uri="{FF2B5EF4-FFF2-40B4-BE49-F238E27FC236}">
                  <a16:creationId xmlns:a16="http://schemas.microsoft.com/office/drawing/2014/main" id="{4B938A82-3E92-5B52-F5C7-DC3F47DC714B}"/>
                </a:ext>
              </a:extLst>
            </p:cNvPr>
            <p:cNvCxnSpPr>
              <a:cxnSpLocks/>
            </p:cNvCxnSpPr>
            <p:nvPr/>
          </p:nvCxnSpPr>
          <p:spPr>
            <a:xfrm>
              <a:off x="385202" y="8191157"/>
              <a:ext cx="10766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Straight Connector 34">
              <a:extLst>
                <a:ext uri="{FF2B5EF4-FFF2-40B4-BE49-F238E27FC236}">
                  <a16:creationId xmlns:a16="http://schemas.microsoft.com/office/drawing/2014/main" id="{A880A33D-8DC1-5ECF-478E-698885A5D5FE}"/>
                </a:ext>
              </a:extLst>
            </p:cNvPr>
            <p:cNvCxnSpPr>
              <a:cxnSpLocks/>
            </p:cNvCxnSpPr>
            <p:nvPr/>
          </p:nvCxnSpPr>
          <p:spPr>
            <a:xfrm>
              <a:off x="380241" y="7730904"/>
              <a:ext cx="10306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8" name="Straight Connector 39">
              <a:extLst>
                <a:ext uri="{FF2B5EF4-FFF2-40B4-BE49-F238E27FC236}">
                  <a16:creationId xmlns:a16="http://schemas.microsoft.com/office/drawing/2014/main" id="{79A6B5F3-FCE1-2DBD-265A-EA3339B95BEB}"/>
                </a:ext>
              </a:extLst>
            </p:cNvPr>
            <p:cNvCxnSpPr>
              <a:cxnSpLocks/>
            </p:cNvCxnSpPr>
            <p:nvPr/>
          </p:nvCxnSpPr>
          <p:spPr>
            <a:xfrm>
              <a:off x="399496" y="9289539"/>
              <a:ext cx="10306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4" name="TextBox 40">
              <a:extLst>
                <a:ext uri="{FF2B5EF4-FFF2-40B4-BE49-F238E27FC236}">
                  <a16:creationId xmlns:a16="http://schemas.microsoft.com/office/drawing/2014/main" id="{8A230125-538A-717E-ED77-17435592DF02}"/>
                </a:ext>
              </a:extLst>
            </p:cNvPr>
            <p:cNvSpPr txBox="1"/>
            <p:nvPr/>
          </p:nvSpPr>
          <p:spPr>
            <a:xfrm>
              <a:off x="147295" y="9128412"/>
              <a:ext cx="336007" cy="293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83D3DF60-B34D-F59C-DAC7-F003533ACEE6}"/>
                </a:ext>
              </a:extLst>
            </p:cNvPr>
            <p:cNvSpPr txBox="1"/>
            <p:nvPr/>
          </p:nvSpPr>
          <p:spPr>
            <a:xfrm>
              <a:off x="168711" y="6097155"/>
              <a:ext cx="512821" cy="239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>
                  <a:latin typeface="+mj-lt"/>
                </a:rPr>
                <a:t>kDa</a:t>
              </a:r>
              <a:endParaRPr lang="en-US" sz="900" dirty="0">
                <a:latin typeface="+mj-lt"/>
              </a:endParaRPr>
            </a:p>
          </p:txBody>
        </p:sp>
        <p:cxnSp>
          <p:nvCxnSpPr>
            <p:cNvPr id="121" name="Straight Connector 34">
              <a:extLst>
                <a:ext uri="{FF2B5EF4-FFF2-40B4-BE49-F238E27FC236}">
                  <a16:creationId xmlns:a16="http://schemas.microsoft.com/office/drawing/2014/main" id="{FD7D4EE2-F18C-C37C-BAFF-E1295E8368C4}"/>
                </a:ext>
              </a:extLst>
            </p:cNvPr>
            <p:cNvCxnSpPr>
              <a:cxnSpLocks/>
            </p:cNvCxnSpPr>
            <p:nvPr/>
          </p:nvCxnSpPr>
          <p:spPr>
            <a:xfrm>
              <a:off x="352130" y="6456483"/>
              <a:ext cx="10306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5" name="Straight Connector 34">
              <a:extLst>
                <a:ext uri="{FF2B5EF4-FFF2-40B4-BE49-F238E27FC236}">
                  <a16:creationId xmlns:a16="http://schemas.microsoft.com/office/drawing/2014/main" id="{C6074FA6-F6FA-CB97-BC2C-756D448D765C}"/>
                </a:ext>
              </a:extLst>
            </p:cNvPr>
            <p:cNvCxnSpPr>
              <a:cxnSpLocks/>
            </p:cNvCxnSpPr>
            <p:nvPr/>
          </p:nvCxnSpPr>
          <p:spPr>
            <a:xfrm>
              <a:off x="357332" y="6681192"/>
              <a:ext cx="10306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6" name="Straight Connector 34">
              <a:extLst>
                <a:ext uri="{FF2B5EF4-FFF2-40B4-BE49-F238E27FC236}">
                  <a16:creationId xmlns:a16="http://schemas.microsoft.com/office/drawing/2014/main" id="{36CBC430-391A-A59F-053D-91EA2B76745E}"/>
                </a:ext>
              </a:extLst>
            </p:cNvPr>
            <p:cNvCxnSpPr>
              <a:cxnSpLocks/>
            </p:cNvCxnSpPr>
            <p:nvPr/>
          </p:nvCxnSpPr>
          <p:spPr>
            <a:xfrm>
              <a:off x="361049" y="6960881"/>
              <a:ext cx="10306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7" name="Straight Connector 34">
              <a:extLst>
                <a:ext uri="{FF2B5EF4-FFF2-40B4-BE49-F238E27FC236}">
                  <a16:creationId xmlns:a16="http://schemas.microsoft.com/office/drawing/2014/main" id="{F8E7AA93-A06C-E8A5-30FC-18DF8186D276}"/>
                </a:ext>
              </a:extLst>
            </p:cNvPr>
            <p:cNvCxnSpPr>
              <a:cxnSpLocks/>
            </p:cNvCxnSpPr>
            <p:nvPr/>
          </p:nvCxnSpPr>
          <p:spPr>
            <a:xfrm>
              <a:off x="349817" y="7229612"/>
              <a:ext cx="10306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64" name="TextBox 26">
              <a:extLst>
                <a:ext uri="{FF2B5EF4-FFF2-40B4-BE49-F238E27FC236}">
                  <a16:creationId xmlns:a16="http://schemas.microsoft.com/office/drawing/2014/main" id="{C0431B4D-4D27-F3FD-7FE2-5963D5CC9BAA}"/>
                </a:ext>
              </a:extLst>
            </p:cNvPr>
            <p:cNvSpPr txBox="1"/>
            <p:nvPr/>
          </p:nvSpPr>
          <p:spPr>
            <a:xfrm>
              <a:off x="39965" y="6324383"/>
              <a:ext cx="4249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67" name="TextBox 26">
              <a:extLst>
                <a:ext uri="{FF2B5EF4-FFF2-40B4-BE49-F238E27FC236}">
                  <a16:creationId xmlns:a16="http://schemas.microsoft.com/office/drawing/2014/main" id="{B91F89FB-F1F0-D788-C28F-62BBA3D40574}"/>
                </a:ext>
              </a:extLst>
            </p:cNvPr>
            <p:cNvSpPr txBox="1"/>
            <p:nvPr/>
          </p:nvSpPr>
          <p:spPr>
            <a:xfrm>
              <a:off x="45696" y="6554792"/>
              <a:ext cx="3744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68" name="TextBox 26">
              <a:extLst>
                <a:ext uri="{FF2B5EF4-FFF2-40B4-BE49-F238E27FC236}">
                  <a16:creationId xmlns:a16="http://schemas.microsoft.com/office/drawing/2014/main" id="{09D05309-6C9F-C19A-2DB8-82F1A6266161}"/>
                </a:ext>
              </a:extLst>
            </p:cNvPr>
            <p:cNvSpPr txBox="1"/>
            <p:nvPr/>
          </p:nvSpPr>
          <p:spPr>
            <a:xfrm>
              <a:off x="47228" y="6837831"/>
              <a:ext cx="4145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69" name="TextBox 26">
              <a:extLst>
                <a:ext uri="{FF2B5EF4-FFF2-40B4-BE49-F238E27FC236}">
                  <a16:creationId xmlns:a16="http://schemas.microsoft.com/office/drawing/2014/main" id="{0975E7B1-2B7D-6362-B994-FF4C7045CE7F}"/>
                </a:ext>
              </a:extLst>
            </p:cNvPr>
            <p:cNvSpPr txBox="1"/>
            <p:nvPr/>
          </p:nvSpPr>
          <p:spPr>
            <a:xfrm>
              <a:off x="98911" y="7090587"/>
              <a:ext cx="3198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+mj-lt"/>
                  <a:cs typeface="Arial" panose="020B0604020202020204" pitchFamily="34" charset="0"/>
                </a:rPr>
                <a:t>7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48221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0CDCEB3C-CB97-02BD-9A95-D126A8697740}"/>
              </a:ext>
            </a:extLst>
          </p:cNvPr>
          <p:cNvGrpSpPr/>
          <p:nvPr/>
        </p:nvGrpSpPr>
        <p:grpSpPr>
          <a:xfrm>
            <a:off x="836712" y="632520"/>
            <a:ext cx="5438070" cy="3518436"/>
            <a:chOff x="836712" y="488504"/>
            <a:chExt cx="5438070" cy="3518436"/>
          </a:xfrm>
        </p:grpSpPr>
        <p:sp>
          <p:nvSpPr>
            <p:cNvPr id="294" name="三角形 30">
              <a:extLst>
                <a:ext uri="{FF2B5EF4-FFF2-40B4-BE49-F238E27FC236}">
                  <a16:creationId xmlns:a16="http://schemas.microsoft.com/office/drawing/2014/main" id="{78327209-A0E2-BDF5-6F8D-88AEE5195A82}"/>
                </a:ext>
              </a:extLst>
            </p:cNvPr>
            <p:cNvSpPr/>
            <p:nvPr/>
          </p:nvSpPr>
          <p:spPr>
            <a:xfrm rot="16200000">
              <a:off x="5595018" y="2506328"/>
              <a:ext cx="63860" cy="13250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>
                <a:latin typeface="+mj-lt"/>
                <a:cs typeface="Arial" panose="020B0604020202020204" pitchFamily="34" charset="0"/>
              </a:endParaRPr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97B9F6A2-266B-1125-2999-F7E10784A0A5}"/>
                </a:ext>
              </a:extLst>
            </p:cNvPr>
            <p:cNvGrpSpPr/>
            <p:nvPr/>
          </p:nvGrpSpPr>
          <p:grpSpPr>
            <a:xfrm>
              <a:off x="836712" y="488504"/>
              <a:ext cx="5438070" cy="3518436"/>
              <a:chOff x="836712" y="488504"/>
              <a:chExt cx="5438070" cy="3518436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2B04773-D57A-2F72-F829-9A5A89D5AAE2}"/>
                  </a:ext>
                </a:extLst>
              </p:cNvPr>
              <p:cNvSpPr txBox="1"/>
              <p:nvPr/>
            </p:nvSpPr>
            <p:spPr>
              <a:xfrm>
                <a:off x="1201862" y="922046"/>
                <a:ext cx="688778" cy="1889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err="1">
                    <a:latin typeface="+mj-lt"/>
                  </a:rPr>
                  <a:t>kDa</a:t>
                </a:r>
                <a:endParaRPr lang="en-US" sz="900" dirty="0">
                  <a:latin typeface="+mj-lt"/>
                </a:endParaRPr>
              </a:p>
            </p:txBody>
          </p: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A1EBDA8E-4FD6-2323-2E89-CE88900376B5}"/>
                  </a:ext>
                </a:extLst>
              </p:cNvPr>
              <p:cNvGrpSpPr/>
              <p:nvPr/>
            </p:nvGrpSpPr>
            <p:grpSpPr>
              <a:xfrm>
                <a:off x="1244515" y="1267305"/>
                <a:ext cx="554726" cy="1846726"/>
                <a:chOff x="1244515" y="1267305"/>
                <a:chExt cx="554726" cy="1846726"/>
              </a:xfrm>
            </p:grpSpPr>
            <p:sp>
              <p:nvSpPr>
                <p:cNvPr id="6" name="TextBox 25">
                  <a:extLst>
                    <a:ext uri="{FF2B5EF4-FFF2-40B4-BE49-F238E27FC236}">
                      <a16:creationId xmlns:a16="http://schemas.microsoft.com/office/drawing/2014/main" id="{28150FAF-56C5-1A9A-570E-8432C8845DB4}"/>
                    </a:ext>
                  </a:extLst>
                </p:cNvPr>
                <p:cNvSpPr txBox="1"/>
                <p:nvPr/>
              </p:nvSpPr>
              <p:spPr>
                <a:xfrm>
                  <a:off x="1322345" y="2648744"/>
                  <a:ext cx="4512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+mj-lt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7" name="TextBox 26">
                  <a:extLst>
                    <a:ext uri="{FF2B5EF4-FFF2-40B4-BE49-F238E27FC236}">
                      <a16:creationId xmlns:a16="http://schemas.microsoft.com/office/drawing/2014/main" id="{0B589461-5EFE-186A-DE5E-2133A212AED1}"/>
                    </a:ext>
                  </a:extLst>
                </p:cNvPr>
                <p:cNvSpPr txBox="1"/>
                <p:nvPr/>
              </p:nvSpPr>
              <p:spPr>
                <a:xfrm>
                  <a:off x="1309851" y="1801985"/>
                  <a:ext cx="451298" cy="1889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+mj-lt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8" name="TextBox 27">
                  <a:extLst>
                    <a:ext uri="{FF2B5EF4-FFF2-40B4-BE49-F238E27FC236}">
                      <a16:creationId xmlns:a16="http://schemas.microsoft.com/office/drawing/2014/main" id="{AC9BE8A6-607F-B06A-5EE1-35DBCBFC0AB7}"/>
                    </a:ext>
                  </a:extLst>
                </p:cNvPr>
                <p:cNvSpPr txBox="1"/>
                <p:nvPr/>
              </p:nvSpPr>
              <p:spPr>
                <a:xfrm>
                  <a:off x="1298530" y="2108756"/>
                  <a:ext cx="451298" cy="1889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+mj-lt"/>
                      <a:cs typeface="Arial" panose="020B0604020202020204" pitchFamily="34" charset="0"/>
                    </a:rPr>
                    <a:t>37</a:t>
                  </a:r>
                </a:p>
              </p:txBody>
            </p:sp>
            <p:cxnSp>
              <p:nvCxnSpPr>
                <p:cNvPr id="9" name="Straight Connector 32">
                  <a:extLst>
                    <a:ext uri="{FF2B5EF4-FFF2-40B4-BE49-F238E27FC236}">
                      <a16:creationId xmlns:a16="http://schemas.microsoft.com/office/drawing/2014/main" id="{A8A32F0C-2334-FA0F-9BB5-B8AB4EF2066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60817" y="2762762"/>
                  <a:ext cx="138424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Connector 33">
                  <a:extLst>
                    <a:ext uri="{FF2B5EF4-FFF2-40B4-BE49-F238E27FC236}">
                      <a16:creationId xmlns:a16="http://schemas.microsoft.com/office/drawing/2014/main" id="{DD7EA5A4-4254-EF8B-34D4-AB94D41368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35143" y="2199159"/>
                  <a:ext cx="144607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Connector 34">
                  <a:extLst>
                    <a:ext uri="{FF2B5EF4-FFF2-40B4-BE49-F238E27FC236}">
                      <a16:creationId xmlns:a16="http://schemas.microsoft.com/office/drawing/2014/main" id="{349B71BD-CA1A-9FA6-E2A7-642FA03657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35143" y="1896440"/>
                  <a:ext cx="138424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39">
                  <a:extLst>
                    <a:ext uri="{FF2B5EF4-FFF2-40B4-BE49-F238E27FC236}">
                      <a16:creationId xmlns:a16="http://schemas.microsoft.com/office/drawing/2014/main" id="{0A507B0E-C0A1-71F9-F6AE-814B669A49C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48236" y="3008784"/>
                  <a:ext cx="138424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3" name="TextBox 40">
                  <a:extLst>
                    <a:ext uri="{FF2B5EF4-FFF2-40B4-BE49-F238E27FC236}">
                      <a16:creationId xmlns:a16="http://schemas.microsoft.com/office/drawing/2014/main" id="{2279F579-DB2F-B954-6365-91AC1E2891C3}"/>
                    </a:ext>
                  </a:extLst>
                </p:cNvPr>
                <p:cNvSpPr txBox="1"/>
                <p:nvPr/>
              </p:nvSpPr>
              <p:spPr>
                <a:xfrm>
                  <a:off x="1332861" y="2883199"/>
                  <a:ext cx="3153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+mj-lt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cxnSp>
              <p:nvCxnSpPr>
                <p:cNvPr id="18" name="Straight Connector 34">
                  <a:extLst>
                    <a:ext uri="{FF2B5EF4-FFF2-40B4-BE49-F238E27FC236}">
                      <a16:creationId xmlns:a16="http://schemas.microsoft.com/office/drawing/2014/main" id="{22F42C39-A1D0-DC0F-CB64-098483F5241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81511" y="1377026"/>
                  <a:ext cx="138424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6" name="TextBox 26">
                  <a:extLst>
                    <a:ext uri="{FF2B5EF4-FFF2-40B4-BE49-F238E27FC236}">
                      <a16:creationId xmlns:a16="http://schemas.microsoft.com/office/drawing/2014/main" id="{BCE25979-A10D-D564-839E-BFE1FDF67BAF}"/>
                    </a:ext>
                  </a:extLst>
                </p:cNvPr>
                <p:cNvSpPr txBox="1"/>
                <p:nvPr/>
              </p:nvSpPr>
              <p:spPr>
                <a:xfrm>
                  <a:off x="1244515" y="1267305"/>
                  <a:ext cx="429548" cy="1821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+mj-lt"/>
                      <a:cs typeface="Arial" panose="020B0604020202020204" pitchFamily="34" charset="0"/>
                    </a:rPr>
                    <a:t>75</a:t>
                  </a:r>
                </a:p>
              </p:txBody>
            </p:sp>
          </p:grpSp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C3B75965-3499-1A8D-CAF2-962C04170404}"/>
                  </a:ext>
                </a:extLst>
              </p:cNvPr>
              <p:cNvGrpSpPr/>
              <p:nvPr/>
            </p:nvGrpSpPr>
            <p:grpSpPr>
              <a:xfrm>
                <a:off x="836712" y="488504"/>
                <a:ext cx="5438070" cy="3518436"/>
                <a:chOff x="876183" y="488504"/>
                <a:chExt cx="5438070" cy="3518436"/>
              </a:xfrm>
            </p:grpSpPr>
            <p:grpSp>
              <p:nvGrpSpPr>
                <p:cNvPr id="27" name="Group 26">
                  <a:extLst>
                    <a:ext uri="{FF2B5EF4-FFF2-40B4-BE49-F238E27FC236}">
                      <a16:creationId xmlns:a16="http://schemas.microsoft.com/office/drawing/2014/main" id="{75DFC522-FDDC-E37D-8F3B-DB3C4ACA0625}"/>
                    </a:ext>
                  </a:extLst>
                </p:cNvPr>
                <p:cNvGrpSpPr/>
                <p:nvPr/>
              </p:nvGrpSpPr>
              <p:grpSpPr>
                <a:xfrm>
                  <a:off x="876183" y="488504"/>
                  <a:ext cx="5105633" cy="3518436"/>
                  <a:chOff x="867589" y="470327"/>
                  <a:chExt cx="5105633" cy="3518436"/>
                </a:xfrm>
              </p:grpSpPr>
              <p:sp>
                <p:nvSpPr>
                  <p:cNvPr id="293" name="テキスト ボックス 29">
                    <a:extLst>
                      <a:ext uri="{FF2B5EF4-FFF2-40B4-BE49-F238E27FC236}">
                        <a16:creationId xmlns:a16="http://schemas.microsoft.com/office/drawing/2014/main" id="{A41EECCF-0CBB-7812-5499-6C45CA159CD0}"/>
                      </a:ext>
                    </a:extLst>
                  </p:cNvPr>
                  <p:cNvSpPr txBox="1"/>
                  <p:nvPr/>
                </p:nvSpPr>
                <p:spPr>
                  <a:xfrm>
                    <a:off x="4879141" y="2406841"/>
                    <a:ext cx="1094081" cy="36783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 err="1">
                        <a:latin typeface="+mj-lt"/>
                        <a:cs typeface="Arial" panose="020B0604020202020204" pitchFamily="34" charset="0"/>
                      </a:rPr>
                      <a:t>rGST</a:t>
                    </a:r>
                    <a:endParaRPr lang="en-US" altLang="ja-JP" sz="900" dirty="0">
                      <a:latin typeface="+mj-lt"/>
                      <a:cs typeface="Arial" panose="020B0604020202020204" pitchFamily="34" charset="0"/>
                    </a:endParaRPr>
                  </a:p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(27 </a:t>
                    </a:r>
                    <a:r>
                      <a:rPr lang="en-US" altLang="ja-JP" sz="900" dirty="0" err="1">
                        <a:latin typeface="+mj-lt"/>
                        <a:cs typeface="Arial" panose="020B0604020202020204" pitchFamily="34" charset="0"/>
                      </a:rPr>
                      <a:t>kDa</a:t>
                    </a:r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)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3" name="Picture 2" descr="A close-up of several black and white images&#10;&#10;Description automatically generated">
                    <a:extLst>
                      <a:ext uri="{FF2B5EF4-FFF2-40B4-BE49-F238E27FC236}">
                        <a16:creationId xmlns:a16="http://schemas.microsoft.com/office/drawing/2014/main" id="{C060B6BE-6F68-75AA-7C70-D051D726090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0838"/>
                  <a:stretch/>
                </p:blipFill>
                <p:spPr>
                  <a:xfrm>
                    <a:off x="1946632" y="1132618"/>
                    <a:ext cx="3660371" cy="2574350"/>
                  </a:xfrm>
                  <a:prstGeom prst="rect">
                    <a:avLst/>
                  </a:prstGeom>
                </p:spPr>
              </p:pic>
              <p:sp>
                <p:nvSpPr>
                  <p:cNvPr id="300" name="テキスト ボックス 8">
                    <a:extLst>
                      <a:ext uri="{FF2B5EF4-FFF2-40B4-BE49-F238E27FC236}">
                        <a16:creationId xmlns:a16="http://schemas.microsoft.com/office/drawing/2014/main" id="{5A7EF698-4E3A-1B74-87FB-C6FA63BBD28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695855" y="745522"/>
                    <a:ext cx="700548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NF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1" name="テキスト ボックス 14">
                    <a:extLst>
                      <a:ext uri="{FF2B5EF4-FFF2-40B4-BE49-F238E27FC236}">
                        <a16:creationId xmlns:a16="http://schemas.microsoft.com/office/drawing/2014/main" id="{BCD88551-9DE8-1B2B-F41F-4C9A65CDD9C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038113" y="853094"/>
                    <a:ext cx="485405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TF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2" name="テキスト ボックス 15">
                    <a:extLst>
                      <a:ext uri="{FF2B5EF4-FFF2-40B4-BE49-F238E27FC236}">
                        <a16:creationId xmlns:a16="http://schemas.microsoft.com/office/drawing/2014/main" id="{E920523F-8227-7EFB-4AB9-AB0E3C52971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61292" y="745524"/>
                    <a:ext cx="700548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PR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3" name="テキスト ボックス 25">
                    <a:extLst>
                      <a:ext uri="{FF2B5EF4-FFF2-40B4-BE49-F238E27FC236}">
                        <a16:creationId xmlns:a16="http://schemas.microsoft.com/office/drawing/2014/main" id="{6B09C737-5C30-FB69-D12D-9719FD2FF08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608742" y="721104"/>
                    <a:ext cx="700548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NF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4" name="テキスト ボックス 26">
                    <a:extLst>
                      <a:ext uri="{FF2B5EF4-FFF2-40B4-BE49-F238E27FC236}">
                        <a16:creationId xmlns:a16="http://schemas.microsoft.com/office/drawing/2014/main" id="{F613464E-8C00-1BDD-B97D-43A6B1FBBA0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919231" y="831344"/>
                    <a:ext cx="485406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TF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5" name="テキスト ボックス 27">
                    <a:extLst>
                      <a:ext uri="{FF2B5EF4-FFF2-40B4-BE49-F238E27FC236}">
                        <a16:creationId xmlns:a16="http://schemas.microsoft.com/office/drawing/2014/main" id="{530A5715-31B2-10B7-3140-66089FCB9DED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025582" y="724847"/>
                    <a:ext cx="661226" cy="230832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PR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6" name="テキスト ボックス 30">
                    <a:extLst>
                      <a:ext uri="{FF2B5EF4-FFF2-40B4-BE49-F238E27FC236}">
                        <a16:creationId xmlns:a16="http://schemas.microsoft.com/office/drawing/2014/main" id="{916CF88E-03D1-56D7-3A55-FA62692B1C8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551948" y="817236"/>
                    <a:ext cx="557120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NF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7" name="テキスト ボックス 31">
                    <a:extLst>
                      <a:ext uri="{FF2B5EF4-FFF2-40B4-BE49-F238E27FC236}">
                        <a16:creationId xmlns:a16="http://schemas.microsoft.com/office/drawing/2014/main" id="{EC53BCBE-604C-4785-BC98-4EED3186604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767972" y="817236"/>
                    <a:ext cx="557120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TF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8" name="テキスト ボックス 32">
                    <a:extLst>
                      <a:ext uri="{FF2B5EF4-FFF2-40B4-BE49-F238E27FC236}">
                        <a16:creationId xmlns:a16="http://schemas.microsoft.com/office/drawing/2014/main" id="{A87D49F0-F2A4-8DD6-2497-39E2E7102DE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834948" y="745521"/>
                    <a:ext cx="700548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PR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9" name="テキスト ボックス 35">
                    <a:extLst>
                      <a:ext uri="{FF2B5EF4-FFF2-40B4-BE49-F238E27FC236}">
                        <a16:creationId xmlns:a16="http://schemas.microsoft.com/office/drawing/2014/main" id="{E6210A63-971D-15AC-D6FE-07DD222F5C15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281609" y="745521"/>
                    <a:ext cx="700548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NF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0" name="テキスト ボックス 36">
                    <a:extLst>
                      <a:ext uri="{FF2B5EF4-FFF2-40B4-BE49-F238E27FC236}">
                        <a16:creationId xmlns:a16="http://schemas.microsoft.com/office/drawing/2014/main" id="{19279BC0-2D5C-09CF-110C-080DC2FAA057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552887" y="817237"/>
                    <a:ext cx="557121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TF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1" name="テキスト ボックス 37">
                    <a:extLst>
                      <a:ext uri="{FF2B5EF4-FFF2-40B4-BE49-F238E27FC236}">
                        <a16:creationId xmlns:a16="http://schemas.microsoft.com/office/drawing/2014/main" id="{2D5ABE94-225A-0040-739A-AD47343F347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686343" y="745523"/>
                    <a:ext cx="700548" cy="19899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ja-JP" sz="900" dirty="0">
                        <a:latin typeface="+mj-lt"/>
                        <a:cs typeface="Arial" panose="020B0604020202020204" pitchFamily="34" charset="0"/>
                      </a:rPr>
                      <a:t>PRM</a:t>
                    </a:r>
                    <a:endParaRPr lang="ja-JP" alt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2" name="TextBox 21">
                    <a:extLst>
                      <a:ext uri="{FF2B5EF4-FFF2-40B4-BE49-F238E27FC236}">
                        <a16:creationId xmlns:a16="http://schemas.microsoft.com/office/drawing/2014/main" id="{A5C9FD29-C0A5-D0B1-DDC6-62A57D3733E3}"/>
                      </a:ext>
                    </a:extLst>
                  </p:cNvPr>
                  <p:cNvSpPr txBox="1"/>
                  <p:nvPr/>
                </p:nvSpPr>
                <p:spPr>
                  <a:xfrm>
                    <a:off x="1532086" y="902725"/>
                    <a:ext cx="691890" cy="2298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 err="1">
                        <a:latin typeface="+mj-lt"/>
                        <a:cs typeface="Arial" panose="020B0604020202020204" pitchFamily="34" charset="0"/>
                      </a:rPr>
                      <a:t>rGST</a:t>
                    </a:r>
                    <a:endParaRPr 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3" name="TextBox 21">
                    <a:extLst>
                      <a:ext uri="{FF2B5EF4-FFF2-40B4-BE49-F238E27FC236}">
                        <a16:creationId xmlns:a16="http://schemas.microsoft.com/office/drawing/2014/main" id="{980C0958-70F4-A818-13F3-076831F2264A}"/>
                      </a:ext>
                    </a:extLst>
                  </p:cNvPr>
                  <p:cNvSpPr txBox="1"/>
                  <p:nvPr/>
                </p:nvSpPr>
                <p:spPr>
                  <a:xfrm>
                    <a:off x="3020118" y="3733307"/>
                    <a:ext cx="336077" cy="229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900" dirty="0">
                        <a:latin typeface="+mj-lt"/>
                        <a:cs typeface="Arial" panose="020B0604020202020204" pitchFamily="34" charset="0"/>
                      </a:rPr>
                      <a:t>PBS</a:t>
                    </a:r>
                  </a:p>
                </p:txBody>
              </p:sp>
              <p:sp>
                <p:nvSpPr>
                  <p:cNvPr id="314" name="TextBox 21">
                    <a:extLst>
                      <a:ext uri="{FF2B5EF4-FFF2-40B4-BE49-F238E27FC236}">
                        <a16:creationId xmlns:a16="http://schemas.microsoft.com/office/drawing/2014/main" id="{163B882B-C3B3-CFD3-2B7F-25EF6C18BCBC}"/>
                      </a:ext>
                    </a:extLst>
                  </p:cNvPr>
                  <p:cNvSpPr txBox="1"/>
                  <p:nvPr/>
                </p:nvSpPr>
                <p:spPr>
                  <a:xfrm>
                    <a:off x="2030658" y="3733307"/>
                    <a:ext cx="480908" cy="2298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dirty="0"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PRM</a:t>
                    </a:r>
                    <a:endParaRPr 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5" name="TextBox 314">
                    <a:extLst>
                      <a:ext uri="{FF2B5EF4-FFF2-40B4-BE49-F238E27FC236}">
                        <a16:creationId xmlns:a16="http://schemas.microsoft.com/office/drawing/2014/main" id="{63A95C92-6CB8-85E2-F65F-89302EF4A4BC}"/>
                      </a:ext>
                    </a:extLst>
                  </p:cNvPr>
                  <p:cNvSpPr txBox="1"/>
                  <p:nvPr/>
                </p:nvSpPr>
                <p:spPr>
                  <a:xfrm>
                    <a:off x="3818096" y="3757931"/>
                    <a:ext cx="45687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dirty="0"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TFM</a:t>
                    </a:r>
                    <a:endParaRPr 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6" name="TextBox 21">
                    <a:extLst>
                      <a:ext uri="{FF2B5EF4-FFF2-40B4-BE49-F238E27FC236}">
                        <a16:creationId xmlns:a16="http://schemas.microsoft.com/office/drawing/2014/main" id="{64EE6064-D2B7-6362-D12A-CFCFCAC982CF}"/>
                      </a:ext>
                    </a:extLst>
                  </p:cNvPr>
                  <p:cNvSpPr txBox="1"/>
                  <p:nvPr/>
                </p:nvSpPr>
                <p:spPr>
                  <a:xfrm>
                    <a:off x="4747780" y="3757931"/>
                    <a:ext cx="507574" cy="2298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dirty="0"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NFM</a:t>
                    </a:r>
                    <a:endParaRPr lang="en-US" sz="900" dirty="0">
                      <a:latin typeface="+mj-lt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7" name="TextBox 21">
                    <a:extLst>
                      <a:ext uri="{FF2B5EF4-FFF2-40B4-BE49-F238E27FC236}">
                        <a16:creationId xmlns:a16="http://schemas.microsoft.com/office/drawing/2014/main" id="{FB1901DE-8C13-A7AB-D91C-C014009028D3}"/>
                      </a:ext>
                    </a:extLst>
                  </p:cNvPr>
                  <p:cNvSpPr txBox="1"/>
                  <p:nvPr/>
                </p:nvSpPr>
                <p:spPr>
                  <a:xfrm>
                    <a:off x="867589" y="3706968"/>
                    <a:ext cx="965765" cy="2298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>
                        <a:latin typeface="+mj-lt"/>
                        <a:cs typeface="Arial" panose="020B0604020202020204" pitchFamily="34" charset="0"/>
                      </a:rPr>
                      <a:t>Immune plasma</a:t>
                    </a:r>
                  </a:p>
                </p:txBody>
              </p:sp>
            </p:grpSp>
            <p:sp>
              <p:nvSpPr>
                <p:cNvPr id="29" name="テキスト ボックス 29">
                  <a:extLst>
                    <a:ext uri="{FF2B5EF4-FFF2-40B4-BE49-F238E27FC236}">
                      <a16:creationId xmlns:a16="http://schemas.microsoft.com/office/drawing/2014/main" id="{D8EA4BC2-88D0-9971-221A-8F75F66AFDBE}"/>
                    </a:ext>
                  </a:extLst>
                </p:cNvPr>
                <p:cNvSpPr txBox="1"/>
                <p:nvPr/>
              </p:nvSpPr>
              <p:spPr>
                <a:xfrm>
                  <a:off x="5659229" y="2387912"/>
                  <a:ext cx="655024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900" dirty="0" err="1">
                      <a:latin typeface="+mj-lt"/>
                      <a:cs typeface="Arial" panose="020B0604020202020204" pitchFamily="34" charset="0"/>
                    </a:rPr>
                    <a:t>rGST</a:t>
                  </a:r>
                  <a:r>
                    <a:rPr lang="en-US" altLang="ja-JP" sz="900" dirty="0">
                      <a:latin typeface="+mj-lt"/>
                      <a:cs typeface="Arial" panose="020B0604020202020204" pitchFamily="34" charset="0"/>
                    </a:rPr>
                    <a:t> (27kDa)</a:t>
                  </a:r>
                  <a:endParaRPr lang="ja-JP" altLang="en-US" sz="900" dirty="0">
                    <a:latin typeface="+mj-lt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18" name="Rectangle 317">
              <a:extLst>
                <a:ext uri="{FF2B5EF4-FFF2-40B4-BE49-F238E27FC236}">
                  <a16:creationId xmlns:a16="http://schemas.microsoft.com/office/drawing/2014/main" id="{F8FB25D9-602E-82F8-6C3E-E0DC89A5A9A7}"/>
                </a:ext>
              </a:extLst>
            </p:cNvPr>
            <p:cNvSpPr/>
            <p:nvPr/>
          </p:nvSpPr>
          <p:spPr>
            <a:xfrm>
              <a:off x="2010676" y="1416229"/>
              <a:ext cx="3288815" cy="179157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A728A989-642B-1BF2-8300-14E1475681A3}"/>
              </a:ext>
            </a:extLst>
          </p:cNvPr>
          <p:cNvSpPr txBox="1"/>
          <p:nvPr/>
        </p:nvSpPr>
        <p:spPr>
          <a:xfrm>
            <a:off x="26449" y="37950"/>
            <a:ext cx="3002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+mj-lt"/>
              </a:rPr>
              <a:t>Supplementary Figure S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3872034-5352-713C-B00C-E5F397378865}"/>
              </a:ext>
            </a:extLst>
          </p:cNvPr>
          <p:cNvSpPr txBox="1"/>
          <p:nvPr/>
        </p:nvSpPr>
        <p:spPr>
          <a:xfrm>
            <a:off x="0" y="260902"/>
            <a:ext cx="4136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The uncropped figure for figure 5. </a:t>
            </a:r>
          </a:p>
        </p:txBody>
      </p:sp>
    </p:spTree>
    <p:extLst>
      <p:ext uri="{BB962C8B-B14F-4D97-AF65-F5344CB8AC3E}">
        <p14:creationId xmlns:p14="http://schemas.microsoft.com/office/powerpoint/2010/main" val="11328068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2E92D118-D050-E5DA-EE95-CBF07948417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64990" y="995658"/>
            <a:ext cx="3045368" cy="2950881"/>
            <a:chOff x="-123" y="1026"/>
            <a:chExt cx="1676" cy="1624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5656F92E-55FF-EF00-C8B6-B28A1B609F4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123" y="1026"/>
              <a:ext cx="1676" cy="16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Line 5">
              <a:extLst>
                <a:ext uri="{FF2B5EF4-FFF2-40B4-BE49-F238E27FC236}">
                  <a16:creationId xmlns:a16="http://schemas.microsoft.com/office/drawing/2014/main" id="{DE5297AB-425D-8040-2000-65E8A5792E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" y="2172"/>
              <a:ext cx="107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" name="Line 6">
              <a:extLst>
                <a:ext uri="{FF2B5EF4-FFF2-40B4-BE49-F238E27FC236}">
                  <a16:creationId xmlns:a16="http://schemas.microsoft.com/office/drawing/2014/main" id="{0894503B-6FC8-403B-5C2C-FF9359E712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" y="2172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" name="Line 7">
              <a:extLst>
                <a:ext uri="{FF2B5EF4-FFF2-40B4-BE49-F238E27FC236}">
                  <a16:creationId xmlns:a16="http://schemas.microsoft.com/office/drawing/2014/main" id="{35EACEE0-A07B-5665-2B4C-9C8C3F717F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1" y="2172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0" name="Line 8">
              <a:extLst>
                <a:ext uri="{FF2B5EF4-FFF2-40B4-BE49-F238E27FC236}">
                  <a16:creationId xmlns:a16="http://schemas.microsoft.com/office/drawing/2014/main" id="{0E5C557F-427D-2843-CD7F-6A17B2A83F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" y="2172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1" name="Line 9">
              <a:extLst>
                <a:ext uri="{FF2B5EF4-FFF2-40B4-BE49-F238E27FC236}">
                  <a16:creationId xmlns:a16="http://schemas.microsoft.com/office/drawing/2014/main" id="{4033D81B-0A4F-476C-610A-D6EDA1483B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9" y="2172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2" name="Line 10">
              <a:extLst>
                <a:ext uri="{FF2B5EF4-FFF2-40B4-BE49-F238E27FC236}">
                  <a16:creationId xmlns:a16="http://schemas.microsoft.com/office/drawing/2014/main" id="{AE8697D7-352B-46F1-95E9-2D7B61BB0F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" y="2172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3" name="Line 11">
              <a:extLst>
                <a:ext uri="{FF2B5EF4-FFF2-40B4-BE49-F238E27FC236}">
                  <a16:creationId xmlns:a16="http://schemas.microsoft.com/office/drawing/2014/main" id="{66BDBA91-63A9-B067-9B8E-AD3F10ADFE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95" y="2172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4" name="Line 12">
              <a:extLst>
                <a:ext uri="{FF2B5EF4-FFF2-40B4-BE49-F238E27FC236}">
                  <a16:creationId xmlns:a16="http://schemas.microsoft.com/office/drawing/2014/main" id="{654117B5-1658-88C2-ACA7-63037E5DC0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51" y="2172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" name="Line 13">
              <a:extLst>
                <a:ext uri="{FF2B5EF4-FFF2-40B4-BE49-F238E27FC236}">
                  <a16:creationId xmlns:a16="http://schemas.microsoft.com/office/drawing/2014/main" id="{07539CDD-426A-BBAC-1110-62B226879A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04" y="2172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" name="Rectangle 14">
              <a:extLst>
                <a:ext uri="{FF2B5EF4-FFF2-40B4-BE49-F238E27FC236}">
                  <a16:creationId xmlns:a16="http://schemas.microsoft.com/office/drawing/2014/main" id="{5FBE072F-25AA-7B84-0490-0DC8F31083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" y="2221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7" name="Rectangle 15">
              <a:extLst>
                <a:ext uri="{FF2B5EF4-FFF2-40B4-BE49-F238E27FC236}">
                  <a16:creationId xmlns:a16="http://schemas.microsoft.com/office/drawing/2014/main" id="{4663909A-C3C5-9FBC-FBB3-C56EE6D2FF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" y="2221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8" name="Rectangle 16">
              <a:extLst>
                <a:ext uri="{FF2B5EF4-FFF2-40B4-BE49-F238E27FC236}">
                  <a16:creationId xmlns:a16="http://schemas.microsoft.com/office/drawing/2014/main" id="{4E9ACB45-74D2-0D7D-EF55-198E91EA1D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" y="2221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9" name="Rectangle 17">
              <a:extLst>
                <a:ext uri="{FF2B5EF4-FFF2-40B4-BE49-F238E27FC236}">
                  <a16:creationId xmlns:a16="http://schemas.microsoft.com/office/drawing/2014/main" id="{40D98106-F1D2-2BA9-45F8-8F99D225F4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" y="2221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0" name="Rectangle 18">
              <a:extLst>
                <a:ext uri="{FF2B5EF4-FFF2-40B4-BE49-F238E27FC236}">
                  <a16:creationId xmlns:a16="http://schemas.microsoft.com/office/drawing/2014/main" id="{542415F1-380A-16AB-8F56-58EDCA073D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2" y="2221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1" name="Rectangle 19">
              <a:extLst>
                <a:ext uri="{FF2B5EF4-FFF2-40B4-BE49-F238E27FC236}">
                  <a16:creationId xmlns:a16="http://schemas.microsoft.com/office/drawing/2014/main" id="{F5453169-7A95-AD64-2DF7-572AABC17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5" y="2221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2" name="Rectangle 20">
              <a:extLst>
                <a:ext uri="{FF2B5EF4-FFF2-40B4-BE49-F238E27FC236}">
                  <a16:creationId xmlns:a16="http://schemas.microsoft.com/office/drawing/2014/main" id="{66F75ABE-06DE-D5D3-B20F-6F3E0E0C76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2221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3" name="Rectangle 21">
              <a:extLst>
                <a:ext uri="{FF2B5EF4-FFF2-40B4-BE49-F238E27FC236}">
                  <a16:creationId xmlns:a16="http://schemas.microsoft.com/office/drawing/2014/main" id="{1481C484-B1E8-E127-40B9-ACDDC26EC5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4" y="2221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4" name="Line 22">
              <a:extLst>
                <a:ext uri="{FF2B5EF4-FFF2-40B4-BE49-F238E27FC236}">
                  <a16:creationId xmlns:a16="http://schemas.microsoft.com/office/drawing/2014/main" id="{B7A69E72-E7B1-0330-DB60-0D371DCB00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4" y="1181"/>
              <a:ext cx="0" cy="95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5" name="Line 23">
              <a:extLst>
                <a:ext uri="{FF2B5EF4-FFF2-40B4-BE49-F238E27FC236}">
                  <a16:creationId xmlns:a16="http://schemas.microsoft.com/office/drawing/2014/main" id="{38D750C4-CC30-80D7-8B13-7F730348B7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2" y="2132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6" name="Line 24">
              <a:extLst>
                <a:ext uri="{FF2B5EF4-FFF2-40B4-BE49-F238E27FC236}">
                  <a16:creationId xmlns:a16="http://schemas.microsoft.com/office/drawing/2014/main" id="{7DB45F2E-3345-EBA0-20C2-D347EFB3DD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2" y="1944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7" name="Line 25">
              <a:extLst>
                <a:ext uri="{FF2B5EF4-FFF2-40B4-BE49-F238E27FC236}">
                  <a16:creationId xmlns:a16="http://schemas.microsoft.com/office/drawing/2014/main" id="{8D8C0EE3-8EB9-DF34-1BB4-B14F7563B8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2" y="1753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8" name="Line 26">
              <a:extLst>
                <a:ext uri="{FF2B5EF4-FFF2-40B4-BE49-F238E27FC236}">
                  <a16:creationId xmlns:a16="http://schemas.microsoft.com/office/drawing/2014/main" id="{8A974B3C-32C7-D347-C49D-93D5B9C3F7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2" y="1562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9" name="Line 27">
              <a:extLst>
                <a:ext uri="{FF2B5EF4-FFF2-40B4-BE49-F238E27FC236}">
                  <a16:creationId xmlns:a16="http://schemas.microsoft.com/office/drawing/2014/main" id="{6CCF3D27-63ED-DCF9-A348-7A46FC4994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2" y="1372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30" name="Line 28">
              <a:extLst>
                <a:ext uri="{FF2B5EF4-FFF2-40B4-BE49-F238E27FC236}">
                  <a16:creationId xmlns:a16="http://schemas.microsoft.com/office/drawing/2014/main" id="{84385FB2-ADEB-F3F2-4158-B2983FAB0A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2" y="1181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31" name="Rectangle 29">
              <a:extLst>
                <a:ext uri="{FF2B5EF4-FFF2-40B4-BE49-F238E27FC236}">
                  <a16:creationId xmlns:a16="http://schemas.microsoft.com/office/drawing/2014/main" id="{1645C340-0DC9-58A9-5744-0E96226C4F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" y="2088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2" name="Rectangle 30">
              <a:extLst>
                <a:ext uri="{FF2B5EF4-FFF2-40B4-BE49-F238E27FC236}">
                  <a16:creationId xmlns:a16="http://schemas.microsoft.com/office/drawing/2014/main" id="{41615EDE-78AE-E5D3-5EFC-67EF1196FA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" y="1893"/>
              <a:ext cx="7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3" name="Rectangle 31">
              <a:extLst>
                <a:ext uri="{FF2B5EF4-FFF2-40B4-BE49-F238E27FC236}">
                  <a16:creationId xmlns:a16="http://schemas.microsoft.com/office/drawing/2014/main" id="{64DB3393-7E6E-DCA1-5A09-07D7470D27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" y="1706"/>
              <a:ext cx="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4" name="Rectangle 32">
              <a:extLst>
                <a:ext uri="{FF2B5EF4-FFF2-40B4-BE49-F238E27FC236}">
                  <a16:creationId xmlns:a16="http://schemas.microsoft.com/office/drawing/2014/main" id="{8F310F3B-E1FA-189E-6366-B5946E0D9F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" y="1508"/>
              <a:ext cx="7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5" name="Rectangle 33">
              <a:extLst>
                <a:ext uri="{FF2B5EF4-FFF2-40B4-BE49-F238E27FC236}">
                  <a16:creationId xmlns:a16="http://schemas.microsoft.com/office/drawing/2014/main" id="{0BB20054-42DE-F1FC-EF55-1AF79DB43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" y="1320"/>
              <a:ext cx="7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dirty="0">
                  <a:solidFill>
                    <a:srgbClr val="000000"/>
                  </a:solidFill>
                  <a:latin typeface="+mn-lt"/>
                </a:rPr>
                <a:t>8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6" name="Rectangle 34">
              <a:extLst>
                <a:ext uri="{FF2B5EF4-FFF2-40B4-BE49-F238E27FC236}">
                  <a16:creationId xmlns:a16="http://schemas.microsoft.com/office/drawing/2014/main" id="{4C256D73-9D57-95E4-1F9C-BB8821C07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" y="1132"/>
              <a:ext cx="10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0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7" name="Freeform 35">
              <a:extLst>
                <a:ext uri="{FF2B5EF4-FFF2-40B4-BE49-F238E27FC236}">
                  <a16:creationId xmlns:a16="http://schemas.microsoft.com/office/drawing/2014/main" id="{375DDC66-29D0-727E-644A-52F483A0957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" y="1143"/>
              <a:ext cx="1162" cy="1028"/>
            </a:xfrm>
            <a:custGeom>
              <a:avLst/>
              <a:gdLst>
                <a:gd name="T0" fmla="*/ 0 w 494"/>
                <a:gd name="T1" fmla="*/ 0 h 437"/>
                <a:gd name="T2" fmla="*/ 0 w 494"/>
                <a:gd name="T3" fmla="*/ 437 h 437"/>
                <a:gd name="T4" fmla="*/ 494 w 494"/>
                <a:gd name="T5" fmla="*/ 437 h 4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4" h="437">
                  <a:moveTo>
                    <a:pt x="0" y="0"/>
                  </a:moveTo>
                  <a:lnTo>
                    <a:pt x="0" y="437"/>
                  </a:lnTo>
                  <a:lnTo>
                    <a:pt x="494" y="437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38" name="Rectangle 36">
              <a:extLst>
                <a:ext uri="{FF2B5EF4-FFF2-40B4-BE49-F238E27FC236}">
                  <a16:creationId xmlns:a16="http://schemas.microsoft.com/office/drawing/2014/main" id="{B909928D-0D8B-DE80-B24E-D9CB057A0F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" y="2295"/>
              <a:ext cx="53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Days-post feeding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39" name="Rectangle 37">
              <a:extLst>
                <a:ext uri="{FF2B5EF4-FFF2-40B4-BE49-F238E27FC236}">
                  <a16:creationId xmlns:a16="http://schemas.microsoft.com/office/drawing/2014/main" id="{895F56DE-A38E-83A7-7F09-4812D324662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301" y="1564"/>
              <a:ext cx="52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ortality rate (%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0" name="Freeform 38">
              <a:extLst>
                <a:ext uri="{FF2B5EF4-FFF2-40B4-BE49-F238E27FC236}">
                  <a16:creationId xmlns:a16="http://schemas.microsoft.com/office/drawing/2014/main" id="{D8D6DDF0-F6A4-8E5B-A429-7F92284C40E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" y="1181"/>
              <a:ext cx="1076" cy="313"/>
            </a:xfrm>
            <a:custGeom>
              <a:avLst/>
              <a:gdLst>
                <a:gd name="T0" fmla="*/ 0 w 457"/>
                <a:gd name="T1" fmla="*/ 0 h 133"/>
                <a:gd name="T2" fmla="*/ 65 w 457"/>
                <a:gd name="T3" fmla="*/ 0 h 133"/>
                <a:gd name="T4" fmla="*/ 65 w 457"/>
                <a:gd name="T5" fmla="*/ 3 h 133"/>
                <a:gd name="T6" fmla="*/ 130 w 457"/>
                <a:gd name="T7" fmla="*/ 3 h 133"/>
                <a:gd name="T8" fmla="*/ 130 w 457"/>
                <a:gd name="T9" fmla="*/ 5 h 133"/>
                <a:gd name="T10" fmla="*/ 196 w 457"/>
                <a:gd name="T11" fmla="*/ 5 h 133"/>
                <a:gd name="T12" fmla="*/ 196 w 457"/>
                <a:gd name="T13" fmla="*/ 9 h 133"/>
                <a:gd name="T14" fmla="*/ 261 w 457"/>
                <a:gd name="T15" fmla="*/ 9 h 133"/>
                <a:gd name="T16" fmla="*/ 261 w 457"/>
                <a:gd name="T17" fmla="*/ 16 h 133"/>
                <a:gd name="T18" fmla="*/ 326 w 457"/>
                <a:gd name="T19" fmla="*/ 16 h 133"/>
                <a:gd name="T20" fmla="*/ 326 w 457"/>
                <a:gd name="T21" fmla="*/ 27 h 133"/>
                <a:gd name="T22" fmla="*/ 392 w 457"/>
                <a:gd name="T23" fmla="*/ 27 h 133"/>
                <a:gd name="T24" fmla="*/ 392 w 457"/>
                <a:gd name="T25" fmla="*/ 57 h 133"/>
                <a:gd name="T26" fmla="*/ 457 w 457"/>
                <a:gd name="T27" fmla="*/ 57 h 133"/>
                <a:gd name="T28" fmla="*/ 457 w 457"/>
                <a:gd name="T29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57" h="133">
                  <a:moveTo>
                    <a:pt x="0" y="0"/>
                  </a:moveTo>
                  <a:lnTo>
                    <a:pt x="65" y="0"/>
                  </a:lnTo>
                  <a:lnTo>
                    <a:pt x="65" y="3"/>
                  </a:lnTo>
                  <a:lnTo>
                    <a:pt x="130" y="3"/>
                  </a:lnTo>
                  <a:lnTo>
                    <a:pt x="130" y="5"/>
                  </a:lnTo>
                  <a:lnTo>
                    <a:pt x="196" y="5"/>
                  </a:lnTo>
                  <a:lnTo>
                    <a:pt x="196" y="9"/>
                  </a:lnTo>
                  <a:lnTo>
                    <a:pt x="261" y="9"/>
                  </a:lnTo>
                  <a:lnTo>
                    <a:pt x="261" y="16"/>
                  </a:lnTo>
                  <a:lnTo>
                    <a:pt x="326" y="16"/>
                  </a:lnTo>
                  <a:lnTo>
                    <a:pt x="326" y="27"/>
                  </a:lnTo>
                  <a:lnTo>
                    <a:pt x="392" y="27"/>
                  </a:lnTo>
                  <a:lnTo>
                    <a:pt x="392" y="57"/>
                  </a:lnTo>
                  <a:lnTo>
                    <a:pt x="457" y="57"/>
                  </a:lnTo>
                  <a:lnTo>
                    <a:pt x="457" y="133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1" name="Line 39">
              <a:extLst>
                <a:ext uri="{FF2B5EF4-FFF2-40B4-BE49-F238E27FC236}">
                  <a16:creationId xmlns:a16="http://schemas.microsoft.com/office/drawing/2014/main" id="{4143108C-2276-6F6F-6014-E5AD133BC7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" y="1186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2" name="Line 40">
              <a:extLst>
                <a:ext uri="{FF2B5EF4-FFF2-40B4-BE49-F238E27FC236}">
                  <a16:creationId xmlns:a16="http://schemas.microsoft.com/office/drawing/2014/main" id="{B5BF7502-BDAA-9EB9-F4C2-99C9B563DE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" y="1172"/>
              <a:ext cx="0" cy="26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3" name="Line 41">
              <a:extLst>
                <a:ext uri="{FF2B5EF4-FFF2-40B4-BE49-F238E27FC236}">
                  <a16:creationId xmlns:a16="http://schemas.microsoft.com/office/drawing/2014/main" id="{C4EF5167-97A3-2373-1861-850475618D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" y="1191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4" name="Line 42">
              <a:extLst>
                <a:ext uri="{FF2B5EF4-FFF2-40B4-BE49-F238E27FC236}">
                  <a16:creationId xmlns:a16="http://schemas.microsoft.com/office/drawing/2014/main" id="{EADD55F5-7ADB-30A4-FF16-79772D7EFC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" y="1179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5" name="Line 43">
              <a:extLst>
                <a:ext uri="{FF2B5EF4-FFF2-40B4-BE49-F238E27FC236}">
                  <a16:creationId xmlns:a16="http://schemas.microsoft.com/office/drawing/2014/main" id="{68023F96-4452-8740-6964-DB249D489D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" y="1198"/>
              <a:ext cx="2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6" name="Line 44">
              <a:extLst>
                <a:ext uri="{FF2B5EF4-FFF2-40B4-BE49-F238E27FC236}">
                  <a16:creationId xmlns:a16="http://schemas.microsoft.com/office/drawing/2014/main" id="{786099B2-592B-8682-2E1D-664D0EE4A4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9" y="1186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7" name="Line 45">
              <a:extLst>
                <a:ext uri="{FF2B5EF4-FFF2-40B4-BE49-F238E27FC236}">
                  <a16:creationId xmlns:a16="http://schemas.microsoft.com/office/drawing/2014/main" id="{30699E1C-AD52-5080-9D86-DD9BA63277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1" y="1212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8" name="Line 46">
              <a:extLst>
                <a:ext uri="{FF2B5EF4-FFF2-40B4-BE49-F238E27FC236}">
                  <a16:creationId xmlns:a16="http://schemas.microsoft.com/office/drawing/2014/main" id="{7BF8A861-106D-652F-201E-EB1818BAD3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2" y="1198"/>
              <a:ext cx="0" cy="26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49" name="Line 47">
              <a:extLst>
                <a:ext uri="{FF2B5EF4-FFF2-40B4-BE49-F238E27FC236}">
                  <a16:creationId xmlns:a16="http://schemas.microsoft.com/office/drawing/2014/main" id="{40894047-25DA-56C8-F9B7-76CEEC63BB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4" y="1233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0" name="Line 48">
              <a:extLst>
                <a:ext uri="{FF2B5EF4-FFF2-40B4-BE49-F238E27FC236}">
                  <a16:creationId xmlns:a16="http://schemas.microsoft.com/office/drawing/2014/main" id="{898ED9E0-4306-FF66-B378-1C6BEF0BBE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5" y="1221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1" name="Line 49">
              <a:extLst>
                <a:ext uri="{FF2B5EF4-FFF2-40B4-BE49-F238E27FC236}">
                  <a16:creationId xmlns:a16="http://schemas.microsoft.com/office/drawing/2014/main" id="{E179C186-0BBF-E093-028B-D8288B8B21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7" y="1280"/>
              <a:ext cx="25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2" name="Line 50">
              <a:extLst>
                <a:ext uri="{FF2B5EF4-FFF2-40B4-BE49-F238E27FC236}">
                  <a16:creationId xmlns:a16="http://schemas.microsoft.com/office/drawing/2014/main" id="{15AD1735-760D-883B-4250-6F2B6B433D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51" y="1268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3" name="Line 51">
              <a:extLst>
                <a:ext uri="{FF2B5EF4-FFF2-40B4-BE49-F238E27FC236}">
                  <a16:creationId xmlns:a16="http://schemas.microsoft.com/office/drawing/2014/main" id="{A9EEFB3D-DED3-BFB7-C93B-092961654D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92" y="1405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4" name="Line 52">
              <a:extLst>
                <a:ext uri="{FF2B5EF4-FFF2-40B4-BE49-F238E27FC236}">
                  <a16:creationId xmlns:a16="http://schemas.microsoft.com/office/drawing/2014/main" id="{3E5898A2-DE25-D13A-18AE-9D788B5856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04" y="1393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5" name="Freeform 53">
              <a:extLst>
                <a:ext uri="{FF2B5EF4-FFF2-40B4-BE49-F238E27FC236}">
                  <a16:creationId xmlns:a16="http://schemas.microsoft.com/office/drawing/2014/main" id="{682573FA-1E2B-90C7-3A0D-5552047935E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8" y="1181"/>
              <a:ext cx="1066" cy="438"/>
            </a:xfrm>
            <a:custGeom>
              <a:avLst/>
              <a:gdLst>
                <a:gd name="T0" fmla="*/ 8 w 453"/>
                <a:gd name="T1" fmla="*/ 0 h 186"/>
                <a:gd name="T2" fmla="*/ 20 w 453"/>
                <a:gd name="T3" fmla="*/ 0 h 186"/>
                <a:gd name="T4" fmla="*/ 32 w 453"/>
                <a:gd name="T5" fmla="*/ 0 h 186"/>
                <a:gd name="T6" fmla="*/ 44 w 453"/>
                <a:gd name="T7" fmla="*/ 0 h 186"/>
                <a:gd name="T8" fmla="*/ 56 w 453"/>
                <a:gd name="T9" fmla="*/ 0 h 186"/>
                <a:gd name="T10" fmla="*/ 61 w 453"/>
                <a:gd name="T11" fmla="*/ 3 h 186"/>
                <a:gd name="T12" fmla="*/ 69 w 453"/>
                <a:gd name="T13" fmla="*/ 3 h 186"/>
                <a:gd name="T14" fmla="*/ 81 w 453"/>
                <a:gd name="T15" fmla="*/ 3 h 186"/>
                <a:gd name="T16" fmla="*/ 93 w 453"/>
                <a:gd name="T17" fmla="*/ 3 h 186"/>
                <a:gd name="T18" fmla="*/ 105 w 453"/>
                <a:gd name="T19" fmla="*/ 3 h 186"/>
                <a:gd name="T20" fmla="*/ 117 w 453"/>
                <a:gd name="T21" fmla="*/ 3 h 186"/>
                <a:gd name="T22" fmla="*/ 126 w 453"/>
                <a:gd name="T23" fmla="*/ 6 h 186"/>
                <a:gd name="T24" fmla="*/ 133 w 453"/>
                <a:gd name="T25" fmla="*/ 11 h 186"/>
                <a:gd name="T26" fmla="*/ 145 w 453"/>
                <a:gd name="T27" fmla="*/ 11 h 186"/>
                <a:gd name="T28" fmla="*/ 157 w 453"/>
                <a:gd name="T29" fmla="*/ 11 h 186"/>
                <a:gd name="T30" fmla="*/ 169 w 453"/>
                <a:gd name="T31" fmla="*/ 11 h 186"/>
                <a:gd name="T32" fmla="*/ 181 w 453"/>
                <a:gd name="T33" fmla="*/ 11 h 186"/>
                <a:gd name="T34" fmla="*/ 192 w 453"/>
                <a:gd name="T35" fmla="*/ 12 h 186"/>
                <a:gd name="T36" fmla="*/ 192 w 453"/>
                <a:gd name="T37" fmla="*/ 24 h 186"/>
                <a:gd name="T38" fmla="*/ 200 w 453"/>
                <a:gd name="T39" fmla="*/ 24 h 186"/>
                <a:gd name="T40" fmla="*/ 212 w 453"/>
                <a:gd name="T41" fmla="*/ 24 h 186"/>
                <a:gd name="T42" fmla="*/ 224 w 453"/>
                <a:gd name="T43" fmla="*/ 24 h 186"/>
                <a:gd name="T44" fmla="*/ 236 w 453"/>
                <a:gd name="T45" fmla="*/ 24 h 186"/>
                <a:gd name="T46" fmla="*/ 248 w 453"/>
                <a:gd name="T47" fmla="*/ 24 h 186"/>
                <a:gd name="T48" fmla="*/ 257 w 453"/>
                <a:gd name="T49" fmla="*/ 27 h 186"/>
                <a:gd name="T50" fmla="*/ 257 w 453"/>
                <a:gd name="T51" fmla="*/ 39 h 186"/>
                <a:gd name="T52" fmla="*/ 260 w 453"/>
                <a:gd name="T53" fmla="*/ 44 h 186"/>
                <a:gd name="T54" fmla="*/ 272 w 453"/>
                <a:gd name="T55" fmla="*/ 44 h 186"/>
                <a:gd name="T56" fmla="*/ 284 w 453"/>
                <a:gd name="T57" fmla="*/ 44 h 186"/>
                <a:gd name="T58" fmla="*/ 296 w 453"/>
                <a:gd name="T59" fmla="*/ 44 h 186"/>
                <a:gd name="T60" fmla="*/ 308 w 453"/>
                <a:gd name="T61" fmla="*/ 44 h 186"/>
                <a:gd name="T62" fmla="*/ 320 w 453"/>
                <a:gd name="T63" fmla="*/ 44 h 186"/>
                <a:gd name="T64" fmla="*/ 322 w 453"/>
                <a:gd name="T65" fmla="*/ 50 h 186"/>
                <a:gd name="T66" fmla="*/ 322 w 453"/>
                <a:gd name="T67" fmla="*/ 62 h 186"/>
                <a:gd name="T68" fmla="*/ 322 w 453"/>
                <a:gd name="T69" fmla="*/ 70 h 186"/>
                <a:gd name="T70" fmla="*/ 334 w 453"/>
                <a:gd name="T71" fmla="*/ 70 h 186"/>
                <a:gd name="T72" fmla="*/ 346 w 453"/>
                <a:gd name="T73" fmla="*/ 70 h 186"/>
                <a:gd name="T74" fmla="*/ 358 w 453"/>
                <a:gd name="T75" fmla="*/ 70 h 186"/>
                <a:gd name="T76" fmla="*/ 370 w 453"/>
                <a:gd name="T77" fmla="*/ 70 h 186"/>
                <a:gd name="T78" fmla="*/ 382 w 453"/>
                <a:gd name="T79" fmla="*/ 70 h 186"/>
                <a:gd name="T80" fmla="*/ 388 w 453"/>
                <a:gd name="T81" fmla="*/ 76 h 186"/>
                <a:gd name="T82" fmla="*/ 388 w 453"/>
                <a:gd name="T83" fmla="*/ 88 h 186"/>
                <a:gd name="T84" fmla="*/ 388 w 453"/>
                <a:gd name="T85" fmla="*/ 100 h 186"/>
                <a:gd name="T86" fmla="*/ 391 w 453"/>
                <a:gd name="T87" fmla="*/ 109 h 186"/>
                <a:gd name="T88" fmla="*/ 403 w 453"/>
                <a:gd name="T89" fmla="*/ 109 h 186"/>
                <a:gd name="T90" fmla="*/ 415 w 453"/>
                <a:gd name="T91" fmla="*/ 109 h 186"/>
                <a:gd name="T92" fmla="*/ 427 w 453"/>
                <a:gd name="T93" fmla="*/ 109 h 186"/>
                <a:gd name="T94" fmla="*/ 439 w 453"/>
                <a:gd name="T95" fmla="*/ 109 h 186"/>
                <a:gd name="T96" fmla="*/ 451 w 453"/>
                <a:gd name="T97" fmla="*/ 109 h 186"/>
                <a:gd name="T98" fmla="*/ 453 w 453"/>
                <a:gd name="T99" fmla="*/ 119 h 186"/>
                <a:gd name="T100" fmla="*/ 453 w 453"/>
                <a:gd name="T101" fmla="*/ 131 h 186"/>
                <a:gd name="T102" fmla="*/ 453 w 453"/>
                <a:gd name="T103" fmla="*/ 143 h 186"/>
                <a:gd name="T104" fmla="*/ 453 w 453"/>
                <a:gd name="T105" fmla="*/ 155 h 186"/>
                <a:gd name="T106" fmla="*/ 453 w 453"/>
                <a:gd name="T107" fmla="*/ 167 h 186"/>
                <a:gd name="T108" fmla="*/ 453 w 453"/>
                <a:gd name="T109" fmla="*/ 179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53" h="186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1" y="0"/>
                  </a:lnTo>
                  <a:lnTo>
                    <a:pt x="61" y="3"/>
                  </a:lnTo>
                  <a:lnTo>
                    <a:pt x="61" y="3"/>
                  </a:lnTo>
                  <a:moveTo>
                    <a:pt x="65" y="3"/>
                  </a:moveTo>
                  <a:lnTo>
                    <a:pt x="69" y="3"/>
                  </a:lnTo>
                  <a:moveTo>
                    <a:pt x="73" y="3"/>
                  </a:moveTo>
                  <a:lnTo>
                    <a:pt x="77" y="3"/>
                  </a:lnTo>
                  <a:moveTo>
                    <a:pt x="81" y="3"/>
                  </a:moveTo>
                  <a:lnTo>
                    <a:pt x="85" y="3"/>
                  </a:lnTo>
                  <a:moveTo>
                    <a:pt x="89" y="3"/>
                  </a:moveTo>
                  <a:lnTo>
                    <a:pt x="93" y="3"/>
                  </a:lnTo>
                  <a:moveTo>
                    <a:pt x="97" y="3"/>
                  </a:moveTo>
                  <a:lnTo>
                    <a:pt x="101" y="3"/>
                  </a:lnTo>
                  <a:moveTo>
                    <a:pt x="105" y="3"/>
                  </a:moveTo>
                  <a:lnTo>
                    <a:pt x="109" y="3"/>
                  </a:lnTo>
                  <a:moveTo>
                    <a:pt x="113" y="3"/>
                  </a:moveTo>
                  <a:lnTo>
                    <a:pt x="117" y="3"/>
                  </a:lnTo>
                  <a:moveTo>
                    <a:pt x="121" y="3"/>
                  </a:moveTo>
                  <a:lnTo>
                    <a:pt x="125" y="3"/>
                  </a:lnTo>
                  <a:moveTo>
                    <a:pt x="126" y="6"/>
                  </a:moveTo>
                  <a:lnTo>
                    <a:pt x="126" y="10"/>
                  </a:lnTo>
                  <a:moveTo>
                    <a:pt x="129" y="11"/>
                  </a:moveTo>
                  <a:lnTo>
                    <a:pt x="133" y="11"/>
                  </a:lnTo>
                  <a:moveTo>
                    <a:pt x="137" y="11"/>
                  </a:moveTo>
                  <a:lnTo>
                    <a:pt x="141" y="11"/>
                  </a:lnTo>
                  <a:moveTo>
                    <a:pt x="145" y="11"/>
                  </a:moveTo>
                  <a:lnTo>
                    <a:pt x="149" y="11"/>
                  </a:lnTo>
                  <a:moveTo>
                    <a:pt x="153" y="11"/>
                  </a:moveTo>
                  <a:lnTo>
                    <a:pt x="157" y="11"/>
                  </a:lnTo>
                  <a:moveTo>
                    <a:pt x="161" y="11"/>
                  </a:moveTo>
                  <a:lnTo>
                    <a:pt x="165" y="11"/>
                  </a:lnTo>
                  <a:moveTo>
                    <a:pt x="169" y="11"/>
                  </a:moveTo>
                  <a:lnTo>
                    <a:pt x="173" y="11"/>
                  </a:lnTo>
                  <a:moveTo>
                    <a:pt x="177" y="11"/>
                  </a:moveTo>
                  <a:lnTo>
                    <a:pt x="181" y="11"/>
                  </a:lnTo>
                  <a:moveTo>
                    <a:pt x="185" y="11"/>
                  </a:moveTo>
                  <a:lnTo>
                    <a:pt x="189" y="11"/>
                  </a:lnTo>
                  <a:moveTo>
                    <a:pt x="192" y="12"/>
                  </a:moveTo>
                  <a:lnTo>
                    <a:pt x="192" y="16"/>
                  </a:lnTo>
                  <a:moveTo>
                    <a:pt x="192" y="20"/>
                  </a:moveTo>
                  <a:lnTo>
                    <a:pt x="192" y="24"/>
                  </a:lnTo>
                  <a:lnTo>
                    <a:pt x="192" y="24"/>
                  </a:lnTo>
                  <a:moveTo>
                    <a:pt x="196" y="24"/>
                  </a:moveTo>
                  <a:lnTo>
                    <a:pt x="200" y="24"/>
                  </a:lnTo>
                  <a:moveTo>
                    <a:pt x="204" y="24"/>
                  </a:moveTo>
                  <a:lnTo>
                    <a:pt x="208" y="24"/>
                  </a:lnTo>
                  <a:moveTo>
                    <a:pt x="212" y="24"/>
                  </a:moveTo>
                  <a:lnTo>
                    <a:pt x="216" y="24"/>
                  </a:lnTo>
                  <a:moveTo>
                    <a:pt x="220" y="24"/>
                  </a:moveTo>
                  <a:lnTo>
                    <a:pt x="224" y="24"/>
                  </a:lnTo>
                  <a:moveTo>
                    <a:pt x="228" y="24"/>
                  </a:moveTo>
                  <a:lnTo>
                    <a:pt x="232" y="24"/>
                  </a:lnTo>
                  <a:moveTo>
                    <a:pt x="236" y="24"/>
                  </a:moveTo>
                  <a:lnTo>
                    <a:pt x="240" y="24"/>
                  </a:lnTo>
                  <a:moveTo>
                    <a:pt x="244" y="24"/>
                  </a:moveTo>
                  <a:lnTo>
                    <a:pt x="248" y="24"/>
                  </a:lnTo>
                  <a:moveTo>
                    <a:pt x="252" y="24"/>
                  </a:moveTo>
                  <a:lnTo>
                    <a:pt x="256" y="24"/>
                  </a:lnTo>
                  <a:moveTo>
                    <a:pt x="257" y="27"/>
                  </a:moveTo>
                  <a:lnTo>
                    <a:pt x="257" y="31"/>
                  </a:lnTo>
                  <a:moveTo>
                    <a:pt x="257" y="35"/>
                  </a:moveTo>
                  <a:lnTo>
                    <a:pt x="257" y="39"/>
                  </a:lnTo>
                  <a:moveTo>
                    <a:pt x="257" y="43"/>
                  </a:moveTo>
                  <a:lnTo>
                    <a:pt x="257" y="44"/>
                  </a:lnTo>
                  <a:lnTo>
                    <a:pt x="260" y="44"/>
                  </a:lnTo>
                  <a:moveTo>
                    <a:pt x="264" y="44"/>
                  </a:moveTo>
                  <a:lnTo>
                    <a:pt x="268" y="44"/>
                  </a:lnTo>
                  <a:moveTo>
                    <a:pt x="272" y="44"/>
                  </a:moveTo>
                  <a:lnTo>
                    <a:pt x="276" y="44"/>
                  </a:lnTo>
                  <a:moveTo>
                    <a:pt x="280" y="44"/>
                  </a:moveTo>
                  <a:lnTo>
                    <a:pt x="284" y="44"/>
                  </a:lnTo>
                  <a:moveTo>
                    <a:pt x="288" y="44"/>
                  </a:moveTo>
                  <a:lnTo>
                    <a:pt x="292" y="44"/>
                  </a:lnTo>
                  <a:moveTo>
                    <a:pt x="296" y="44"/>
                  </a:moveTo>
                  <a:lnTo>
                    <a:pt x="300" y="44"/>
                  </a:lnTo>
                  <a:moveTo>
                    <a:pt x="304" y="44"/>
                  </a:moveTo>
                  <a:lnTo>
                    <a:pt x="308" y="44"/>
                  </a:lnTo>
                  <a:moveTo>
                    <a:pt x="312" y="44"/>
                  </a:moveTo>
                  <a:lnTo>
                    <a:pt x="316" y="44"/>
                  </a:lnTo>
                  <a:moveTo>
                    <a:pt x="320" y="44"/>
                  </a:moveTo>
                  <a:lnTo>
                    <a:pt x="322" y="44"/>
                  </a:lnTo>
                  <a:lnTo>
                    <a:pt x="322" y="46"/>
                  </a:lnTo>
                  <a:moveTo>
                    <a:pt x="322" y="50"/>
                  </a:moveTo>
                  <a:lnTo>
                    <a:pt x="322" y="54"/>
                  </a:lnTo>
                  <a:moveTo>
                    <a:pt x="322" y="58"/>
                  </a:moveTo>
                  <a:lnTo>
                    <a:pt x="322" y="62"/>
                  </a:lnTo>
                  <a:moveTo>
                    <a:pt x="322" y="66"/>
                  </a:moveTo>
                  <a:lnTo>
                    <a:pt x="322" y="70"/>
                  </a:lnTo>
                  <a:lnTo>
                    <a:pt x="322" y="70"/>
                  </a:lnTo>
                  <a:moveTo>
                    <a:pt x="326" y="70"/>
                  </a:moveTo>
                  <a:lnTo>
                    <a:pt x="330" y="70"/>
                  </a:lnTo>
                  <a:moveTo>
                    <a:pt x="334" y="70"/>
                  </a:moveTo>
                  <a:lnTo>
                    <a:pt x="338" y="70"/>
                  </a:lnTo>
                  <a:moveTo>
                    <a:pt x="342" y="70"/>
                  </a:moveTo>
                  <a:lnTo>
                    <a:pt x="346" y="70"/>
                  </a:lnTo>
                  <a:moveTo>
                    <a:pt x="350" y="70"/>
                  </a:moveTo>
                  <a:lnTo>
                    <a:pt x="354" y="70"/>
                  </a:lnTo>
                  <a:moveTo>
                    <a:pt x="358" y="70"/>
                  </a:moveTo>
                  <a:lnTo>
                    <a:pt x="362" y="70"/>
                  </a:lnTo>
                  <a:moveTo>
                    <a:pt x="366" y="70"/>
                  </a:moveTo>
                  <a:lnTo>
                    <a:pt x="370" y="70"/>
                  </a:lnTo>
                  <a:moveTo>
                    <a:pt x="374" y="70"/>
                  </a:moveTo>
                  <a:lnTo>
                    <a:pt x="378" y="70"/>
                  </a:lnTo>
                  <a:moveTo>
                    <a:pt x="382" y="70"/>
                  </a:moveTo>
                  <a:lnTo>
                    <a:pt x="386" y="70"/>
                  </a:lnTo>
                  <a:moveTo>
                    <a:pt x="388" y="72"/>
                  </a:moveTo>
                  <a:lnTo>
                    <a:pt x="388" y="76"/>
                  </a:lnTo>
                  <a:moveTo>
                    <a:pt x="388" y="80"/>
                  </a:moveTo>
                  <a:lnTo>
                    <a:pt x="388" y="84"/>
                  </a:lnTo>
                  <a:moveTo>
                    <a:pt x="388" y="88"/>
                  </a:moveTo>
                  <a:lnTo>
                    <a:pt x="388" y="92"/>
                  </a:lnTo>
                  <a:moveTo>
                    <a:pt x="388" y="96"/>
                  </a:moveTo>
                  <a:lnTo>
                    <a:pt x="388" y="100"/>
                  </a:lnTo>
                  <a:moveTo>
                    <a:pt x="388" y="104"/>
                  </a:moveTo>
                  <a:lnTo>
                    <a:pt x="388" y="108"/>
                  </a:lnTo>
                  <a:moveTo>
                    <a:pt x="391" y="109"/>
                  </a:moveTo>
                  <a:lnTo>
                    <a:pt x="395" y="109"/>
                  </a:lnTo>
                  <a:moveTo>
                    <a:pt x="399" y="109"/>
                  </a:moveTo>
                  <a:lnTo>
                    <a:pt x="403" y="109"/>
                  </a:lnTo>
                  <a:moveTo>
                    <a:pt x="407" y="109"/>
                  </a:moveTo>
                  <a:lnTo>
                    <a:pt x="411" y="109"/>
                  </a:lnTo>
                  <a:moveTo>
                    <a:pt x="415" y="109"/>
                  </a:moveTo>
                  <a:lnTo>
                    <a:pt x="419" y="109"/>
                  </a:lnTo>
                  <a:moveTo>
                    <a:pt x="423" y="109"/>
                  </a:moveTo>
                  <a:lnTo>
                    <a:pt x="427" y="109"/>
                  </a:lnTo>
                  <a:moveTo>
                    <a:pt x="431" y="109"/>
                  </a:moveTo>
                  <a:lnTo>
                    <a:pt x="435" y="109"/>
                  </a:lnTo>
                  <a:moveTo>
                    <a:pt x="439" y="109"/>
                  </a:moveTo>
                  <a:lnTo>
                    <a:pt x="443" y="109"/>
                  </a:lnTo>
                  <a:moveTo>
                    <a:pt x="447" y="109"/>
                  </a:moveTo>
                  <a:lnTo>
                    <a:pt x="451" y="109"/>
                  </a:lnTo>
                  <a:moveTo>
                    <a:pt x="453" y="111"/>
                  </a:moveTo>
                  <a:lnTo>
                    <a:pt x="453" y="115"/>
                  </a:lnTo>
                  <a:moveTo>
                    <a:pt x="453" y="119"/>
                  </a:moveTo>
                  <a:lnTo>
                    <a:pt x="453" y="123"/>
                  </a:lnTo>
                  <a:moveTo>
                    <a:pt x="453" y="127"/>
                  </a:moveTo>
                  <a:lnTo>
                    <a:pt x="453" y="131"/>
                  </a:lnTo>
                  <a:moveTo>
                    <a:pt x="453" y="135"/>
                  </a:moveTo>
                  <a:lnTo>
                    <a:pt x="453" y="139"/>
                  </a:lnTo>
                  <a:moveTo>
                    <a:pt x="453" y="143"/>
                  </a:moveTo>
                  <a:lnTo>
                    <a:pt x="453" y="147"/>
                  </a:lnTo>
                  <a:moveTo>
                    <a:pt x="453" y="151"/>
                  </a:moveTo>
                  <a:lnTo>
                    <a:pt x="453" y="155"/>
                  </a:lnTo>
                  <a:moveTo>
                    <a:pt x="453" y="159"/>
                  </a:moveTo>
                  <a:lnTo>
                    <a:pt x="453" y="163"/>
                  </a:lnTo>
                  <a:moveTo>
                    <a:pt x="453" y="167"/>
                  </a:moveTo>
                  <a:lnTo>
                    <a:pt x="453" y="171"/>
                  </a:lnTo>
                  <a:moveTo>
                    <a:pt x="453" y="175"/>
                  </a:moveTo>
                  <a:lnTo>
                    <a:pt x="453" y="179"/>
                  </a:lnTo>
                  <a:moveTo>
                    <a:pt x="453" y="183"/>
                  </a:move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dirty="0"/>
            </a:p>
          </p:txBody>
        </p:sp>
        <p:sp>
          <p:nvSpPr>
            <p:cNvPr id="56" name="Line 54">
              <a:extLst>
                <a:ext uri="{FF2B5EF4-FFF2-40B4-BE49-F238E27FC236}">
                  <a16:creationId xmlns:a16="http://schemas.microsoft.com/office/drawing/2014/main" id="{A5F4E13F-EC5A-DBCC-1549-E297B479D9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" y="1186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7" name="Line 55">
              <a:extLst>
                <a:ext uri="{FF2B5EF4-FFF2-40B4-BE49-F238E27FC236}">
                  <a16:creationId xmlns:a16="http://schemas.microsoft.com/office/drawing/2014/main" id="{72803AF2-000B-86CC-9F46-EC3902F615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" y="1174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8" name="Line 56">
              <a:extLst>
                <a:ext uri="{FF2B5EF4-FFF2-40B4-BE49-F238E27FC236}">
                  <a16:creationId xmlns:a16="http://schemas.microsoft.com/office/drawing/2014/main" id="{F91F14CF-0503-BA5C-BAE3-CE7484D9C6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" y="1198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59" name="Line 57">
              <a:extLst>
                <a:ext uri="{FF2B5EF4-FFF2-40B4-BE49-F238E27FC236}">
                  <a16:creationId xmlns:a16="http://schemas.microsoft.com/office/drawing/2014/main" id="{554196EE-377C-B2ED-AF47-7D1ECECE9B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" y="1186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0" name="Line 58">
              <a:extLst>
                <a:ext uri="{FF2B5EF4-FFF2-40B4-BE49-F238E27FC236}">
                  <a16:creationId xmlns:a16="http://schemas.microsoft.com/office/drawing/2014/main" id="{4D5D1C4C-E9DB-A8C1-6CB9-8E6055F4F3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" y="1221"/>
              <a:ext cx="2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1" name="Line 59">
              <a:extLst>
                <a:ext uri="{FF2B5EF4-FFF2-40B4-BE49-F238E27FC236}">
                  <a16:creationId xmlns:a16="http://schemas.microsoft.com/office/drawing/2014/main" id="{B469AD36-A640-A075-F57C-705AE110AD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9" y="1209"/>
              <a:ext cx="0" cy="26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2" name="Line 60">
              <a:extLst>
                <a:ext uri="{FF2B5EF4-FFF2-40B4-BE49-F238E27FC236}">
                  <a16:creationId xmlns:a16="http://schemas.microsoft.com/office/drawing/2014/main" id="{CD1B8DD8-5224-7A6D-4875-C3C9F4D8A0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1" y="1261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3" name="Line 61">
              <a:extLst>
                <a:ext uri="{FF2B5EF4-FFF2-40B4-BE49-F238E27FC236}">
                  <a16:creationId xmlns:a16="http://schemas.microsoft.com/office/drawing/2014/main" id="{96FE29C0-A411-E75B-CB38-DB215DADC4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2" y="1249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4" name="Line 62">
              <a:extLst>
                <a:ext uri="{FF2B5EF4-FFF2-40B4-BE49-F238E27FC236}">
                  <a16:creationId xmlns:a16="http://schemas.microsoft.com/office/drawing/2014/main" id="{C7B82398-4F9E-A7B7-AA28-387C6A7F3D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4" y="1315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5" name="Line 63">
              <a:extLst>
                <a:ext uri="{FF2B5EF4-FFF2-40B4-BE49-F238E27FC236}">
                  <a16:creationId xmlns:a16="http://schemas.microsoft.com/office/drawing/2014/main" id="{71B0B258-50B9-084F-3B58-02E8995EA8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5" y="1304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6" name="Line 64">
              <a:extLst>
                <a:ext uri="{FF2B5EF4-FFF2-40B4-BE49-F238E27FC236}">
                  <a16:creationId xmlns:a16="http://schemas.microsoft.com/office/drawing/2014/main" id="{955E6A04-3583-6009-850E-649FD3B145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7" y="1391"/>
              <a:ext cx="25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7" name="Line 65">
              <a:extLst>
                <a:ext uri="{FF2B5EF4-FFF2-40B4-BE49-F238E27FC236}">
                  <a16:creationId xmlns:a16="http://schemas.microsoft.com/office/drawing/2014/main" id="{9B2E5960-450D-E63A-4635-7F1D11383B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51" y="1379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8" name="Line 66">
              <a:extLst>
                <a:ext uri="{FF2B5EF4-FFF2-40B4-BE49-F238E27FC236}">
                  <a16:creationId xmlns:a16="http://schemas.microsoft.com/office/drawing/2014/main" id="{F2F08080-D3E9-7AB5-7A88-131536FE82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92" y="1527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69" name="Line 67">
              <a:extLst>
                <a:ext uri="{FF2B5EF4-FFF2-40B4-BE49-F238E27FC236}">
                  <a16:creationId xmlns:a16="http://schemas.microsoft.com/office/drawing/2014/main" id="{11730BF9-4323-5F35-9170-FEE00268E0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04" y="1515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0" name="Freeform 68">
              <a:extLst>
                <a:ext uri="{FF2B5EF4-FFF2-40B4-BE49-F238E27FC236}">
                  <a16:creationId xmlns:a16="http://schemas.microsoft.com/office/drawing/2014/main" id="{AA76FEB9-CBBF-389F-50A8-AB0C762BFE7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1" y="1181"/>
              <a:ext cx="1073" cy="476"/>
            </a:xfrm>
            <a:custGeom>
              <a:avLst/>
              <a:gdLst>
                <a:gd name="T0" fmla="*/ 11 w 456"/>
                <a:gd name="T1" fmla="*/ 0 h 202"/>
                <a:gd name="T2" fmla="*/ 23 w 456"/>
                <a:gd name="T3" fmla="*/ 0 h 202"/>
                <a:gd name="T4" fmla="*/ 35 w 456"/>
                <a:gd name="T5" fmla="*/ 0 h 202"/>
                <a:gd name="T6" fmla="*/ 47 w 456"/>
                <a:gd name="T7" fmla="*/ 0 h 202"/>
                <a:gd name="T8" fmla="*/ 59 w 456"/>
                <a:gd name="T9" fmla="*/ 0 h 202"/>
                <a:gd name="T10" fmla="*/ 64 w 456"/>
                <a:gd name="T11" fmla="*/ 4 h 202"/>
                <a:gd name="T12" fmla="*/ 74 w 456"/>
                <a:gd name="T13" fmla="*/ 6 h 202"/>
                <a:gd name="T14" fmla="*/ 86 w 456"/>
                <a:gd name="T15" fmla="*/ 6 h 202"/>
                <a:gd name="T16" fmla="*/ 98 w 456"/>
                <a:gd name="T17" fmla="*/ 6 h 202"/>
                <a:gd name="T18" fmla="*/ 110 w 456"/>
                <a:gd name="T19" fmla="*/ 6 h 202"/>
                <a:gd name="T20" fmla="*/ 122 w 456"/>
                <a:gd name="T21" fmla="*/ 6 h 202"/>
                <a:gd name="T22" fmla="*/ 129 w 456"/>
                <a:gd name="T23" fmla="*/ 11 h 202"/>
                <a:gd name="T24" fmla="*/ 136 w 456"/>
                <a:gd name="T25" fmla="*/ 15 h 202"/>
                <a:gd name="T26" fmla="*/ 148 w 456"/>
                <a:gd name="T27" fmla="*/ 15 h 202"/>
                <a:gd name="T28" fmla="*/ 160 w 456"/>
                <a:gd name="T29" fmla="*/ 15 h 202"/>
                <a:gd name="T30" fmla="*/ 172 w 456"/>
                <a:gd name="T31" fmla="*/ 15 h 202"/>
                <a:gd name="T32" fmla="*/ 184 w 456"/>
                <a:gd name="T33" fmla="*/ 15 h 202"/>
                <a:gd name="T34" fmla="*/ 195 w 456"/>
                <a:gd name="T35" fmla="*/ 16 h 202"/>
                <a:gd name="T36" fmla="*/ 195 w 456"/>
                <a:gd name="T37" fmla="*/ 28 h 202"/>
                <a:gd name="T38" fmla="*/ 205 w 456"/>
                <a:gd name="T39" fmla="*/ 30 h 202"/>
                <a:gd name="T40" fmla="*/ 217 w 456"/>
                <a:gd name="T41" fmla="*/ 30 h 202"/>
                <a:gd name="T42" fmla="*/ 229 w 456"/>
                <a:gd name="T43" fmla="*/ 30 h 202"/>
                <a:gd name="T44" fmla="*/ 241 w 456"/>
                <a:gd name="T45" fmla="*/ 30 h 202"/>
                <a:gd name="T46" fmla="*/ 253 w 456"/>
                <a:gd name="T47" fmla="*/ 30 h 202"/>
                <a:gd name="T48" fmla="*/ 260 w 456"/>
                <a:gd name="T49" fmla="*/ 35 h 202"/>
                <a:gd name="T50" fmla="*/ 260 w 456"/>
                <a:gd name="T51" fmla="*/ 47 h 202"/>
                <a:gd name="T52" fmla="*/ 268 w 456"/>
                <a:gd name="T53" fmla="*/ 48 h 202"/>
                <a:gd name="T54" fmla="*/ 280 w 456"/>
                <a:gd name="T55" fmla="*/ 48 h 202"/>
                <a:gd name="T56" fmla="*/ 292 w 456"/>
                <a:gd name="T57" fmla="*/ 48 h 202"/>
                <a:gd name="T58" fmla="*/ 304 w 456"/>
                <a:gd name="T59" fmla="*/ 48 h 202"/>
                <a:gd name="T60" fmla="*/ 316 w 456"/>
                <a:gd name="T61" fmla="*/ 48 h 202"/>
                <a:gd name="T62" fmla="*/ 325 w 456"/>
                <a:gd name="T63" fmla="*/ 51 h 202"/>
                <a:gd name="T64" fmla="*/ 325 w 456"/>
                <a:gd name="T65" fmla="*/ 63 h 202"/>
                <a:gd name="T66" fmla="*/ 327 w 456"/>
                <a:gd name="T67" fmla="*/ 73 h 202"/>
                <a:gd name="T68" fmla="*/ 339 w 456"/>
                <a:gd name="T69" fmla="*/ 73 h 202"/>
                <a:gd name="T70" fmla="*/ 351 w 456"/>
                <a:gd name="T71" fmla="*/ 73 h 202"/>
                <a:gd name="T72" fmla="*/ 363 w 456"/>
                <a:gd name="T73" fmla="*/ 73 h 202"/>
                <a:gd name="T74" fmla="*/ 375 w 456"/>
                <a:gd name="T75" fmla="*/ 73 h 202"/>
                <a:gd name="T76" fmla="*/ 387 w 456"/>
                <a:gd name="T77" fmla="*/ 73 h 202"/>
                <a:gd name="T78" fmla="*/ 391 w 456"/>
                <a:gd name="T79" fmla="*/ 80 h 202"/>
                <a:gd name="T80" fmla="*/ 391 w 456"/>
                <a:gd name="T81" fmla="*/ 92 h 202"/>
                <a:gd name="T82" fmla="*/ 391 w 456"/>
                <a:gd name="T83" fmla="*/ 104 h 202"/>
                <a:gd name="T84" fmla="*/ 392 w 456"/>
                <a:gd name="T85" fmla="*/ 115 h 202"/>
                <a:gd name="T86" fmla="*/ 404 w 456"/>
                <a:gd name="T87" fmla="*/ 115 h 202"/>
                <a:gd name="T88" fmla="*/ 416 w 456"/>
                <a:gd name="T89" fmla="*/ 115 h 202"/>
                <a:gd name="T90" fmla="*/ 428 w 456"/>
                <a:gd name="T91" fmla="*/ 115 h 202"/>
                <a:gd name="T92" fmla="*/ 440 w 456"/>
                <a:gd name="T93" fmla="*/ 115 h 202"/>
                <a:gd name="T94" fmla="*/ 452 w 456"/>
                <a:gd name="T95" fmla="*/ 115 h 202"/>
                <a:gd name="T96" fmla="*/ 456 w 456"/>
                <a:gd name="T97" fmla="*/ 123 h 202"/>
                <a:gd name="T98" fmla="*/ 456 w 456"/>
                <a:gd name="T99" fmla="*/ 135 h 202"/>
                <a:gd name="T100" fmla="*/ 456 w 456"/>
                <a:gd name="T101" fmla="*/ 147 h 202"/>
                <a:gd name="T102" fmla="*/ 456 w 456"/>
                <a:gd name="T103" fmla="*/ 159 h 202"/>
                <a:gd name="T104" fmla="*/ 456 w 456"/>
                <a:gd name="T105" fmla="*/ 171 h 202"/>
                <a:gd name="T106" fmla="*/ 456 w 456"/>
                <a:gd name="T107" fmla="*/ 183 h 202"/>
                <a:gd name="T108" fmla="*/ 456 w 456"/>
                <a:gd name="T109" fmla="*/ 195 h 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56" h="202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lnTo>
                    <a:pt x="64" y="0"/>
                  </a:lnTo>
                  <a:moveTo>
                    <a:pt x="64" y="3"/>
                  </a:moveTo>
                  <a:lnTo>
                    <a:pt x="64" y="4"/>
                  </a:lnTo>
                  <a:moveTo>
                    <a:pt x="65" y="6"/>
                  </a:moveTo>
                  <a:lnTo>
                    <a:pt x="66" y="6"/>
                  </a:lnTo>
                  <a:moveTo>
                    <a:pt x="69" y="6"/>
                  </a:moveTo>
                  <a:lnTo>
                    <a:pt x="70" y="6"/>
                  </a:lnTo>
                  <a:moveTo>
                    <a:pt x="73" y="6"/>
                  </a:moveTo>
                  <a:lnTo>
                    <a:pt x="74" y="6"/>
                  </a:lnTo>
                  <a:moveTo>
                    <a:pt x="77" y="6"/>
                  </a:moveTo>
                  <a:lnTo>
                    <a:pt x="78" y="6"/>
                  </a:lnTo>
                  <a:moveTo>
                    <a:pt x="81" y="6"/>
                  </a:moveTo>
                  <a:lnTo>
                    <a:pt x="82" y="6"/>
                  </a:lnTo>
                  <a:moveTo>
                    <a:pt x="85" y="6"/>
                  </a:moveTo>
                  <a:lnTo>
                    <a:pt x="86" y="6"/>
                  </a:lnTo>
                  <a:moveTo>
                    <a:pt x="89" y="6"/>
                  </a:moveTo>
                  <a:lnTo>
                    <a:pt x="90" y="6"/>
                  </a:lnTo>
                  <a:moveTo>
                    <a:pt x="93" y="6"/>
                  </a:moveTo>
                  <a:lnTo>
                    <a:pt x="94" y="6"/>
                  </a:lnTo>
                  <a:moveTo>
                    <a:pt x="97" y="6"/>
                  </a:moveTo>
                  <a:lnTo>
                    <a:pt x="98" y="6"/>
                  </a:lnTo>
                  <a:moveTo>
                    <a:pt x="101" y="6"/>
                  </a:moveTo>
                  <a:lnTo>
                    <a:pt x="102" y="6"/>
                  </a:lnTo>
                  <a:moveTo>
                    <a:pt x="105" y="6"/>
                  </a:moveTo>
                  <a:lnTo>
                    <a:pt x="106" y="6"/>
                  </a:lnTo>
                  <a:moveTo>
                    <a:pt x="109" y="6"/>
                  </a:moveTo>
                  <a:lnTo>
                    <a:pt x="110" y="6"/>
                  </a:lnTo>
                  <a:moveTo>
                    <a:pt x="113" y="6"/>
                  </a:moveTo>
                  <a:lnTo>
                    <a:pt x="114" y="6"/>
                  </a:lnTo>
                  <a:moveTo>
                    <a:pt x="117" y="6"/>
                  </a:moveTo>
                  <a:lnTo>
                    <a:pt x="118" y="6"/>
                  </a:lnTo>
                  <a:moveTo>
                    <a:pt x="121" y="6"/>
                  </a:moveTo>
                  <a:lnTo>
                    <a:pt x="122" y="6"/>
                  </a:lnTo>
                  <a:moveTo>
                    <a:pt x="125" y="6"/>
                  </a:moveTo>
                  <a:lnTo>
                    <a:pt x="126" y="6"/>
                  </a:lnTo>
                  <a:moveTo>
                    <a:pt x="129" y="6"/>
                  </a:moveTo>
                  <a:lnTo>
                    <a:pt x="129" y="7"/>
                  </a:lnTo>
                  <a:moveTo>
                    <a:pt x="129" y="10"/>
                  </a:moveTo>
                  <a:lnTo>
                    <a:pt x="129" y="11"/>
                  </a:lnTo>
                  <a:moveTo>
                    <a:pt x="129" y="14"/>
                  </a:moveTo>
                  <a:lnTo>
                    <a:pt x="129" y="15"/>
                  </a:lnTo>
                  <a:lnTo>
                    <a:pt x="129" y="15"/>
                  </a:lnTo>
                  <a:moveTo>
                    <a:pt x="132" y="15"/>
                  </a:moveTo>
                  <a:lnTo>
                    <a:pt x="133" y="15"/>
                  </a:lnTo>
                  <a:moveTo>
                    <a:pt x="136" y="15"/>
                  </a:moveTo>
                  <a:lnTo>
                    <a:pt x="137" y="15"/>
                  </a:lnTo>
                  <a:moveTo>
                    <a:pt x="140" y="15"/>
                  </a:moveTo>
                  <a:lnTo>
                    <a:pt x="141" y="15"/>
                  </a:lnTo>
                  <a:moveTo>
                    <a:pt x="144" y="15"/>
                  </a:moveTo>
                  <a:lnTo>
                    <a:pt x="145" y="15"/>
                  </a:lnTo>
                  <a:moveTo>
                    <a:pt x="148" y="15"/>
                  </a:moveTo>
                  <a:lnTo>
                    <a:pt x="149" y="15"/>
                  </a:lnTo>
                  <a:moveTo>
                    <a:pt x="152" y="15"/>
                  </a:moveTo>
                  <a:lnTo>
                    <a:pt x="153" y="15"/>
                  </a:lnTo>
                  <a:moveTo>
                    <a:pt x="156" y="15"/>
                  </a:moveTo>
                  <a:lnTo>
                    <a:pt x="157" y="15"/>
                  </a:lnTo>
                  <a:moveTo>
                    <a:pt x="160" y="15"/>
                  </a:moveTo>
                  <a:lnTo>
                    <a:pt x="161" y="15"/>
                  </a:lnTo>
                  <a:moveTo>
                    <a:pt x="164" y="15"/>
                  </a:moveTo>
                  <a:lnTo>
                    <a:pt x="165" y="15"/>
                  </a:lnTo>
                  <a:moveTo>
                    <a:pt x="168" y="15"/>
                  </a:moveTo>
                  <a:lnTo>
                    <a:pt x="169" y="15"/>
                  </a:lnTo>
                  <a:moveTo>
                    <a:pt x="172" y="15"/>
                  </a:moveTo>
                  <a:lnTo>
                    <a:pt x="173" y="15"/>
                  </a:lnTo>
                  <a:moveTo>
                    <a:pt x="176" y="15"/>
                  </a:moveTo>
                  <a:lnTo>
                    <a:pt x="177" y="15"/>
                  </a:lnTo>
                  <a:moveTo>
                    <a:pt x="180" y="15"/>
                  </a:moveTo>
                  <a:lnTo>
                    <a:pt x="181" y="15"/>
                  </a:lnTo>
                  <a:moveTo>
                    <a:pt x="184" y="15"/>
                  </a:moveTo>
                  <a:lnTo>
                    <a:pt x="185" y="15"/>
                  </a:lnTo>
                  <a:moveTo>
                    <a:pt x="188" y="15"/>
                  </a:moveTo>
                  <a:lnTo>
                    <a:pt x="189" y="15"/>
                  </a:lnTo>
                  <a:moveTo>
                    <a:pt x="192" y="15"/>
                  </a:moveTo>
                  <a:lnTo>
                    <a:pt x="193" y="15"/>
                  </a:lnTo>
                  <a:moveTo>
                    <a:pt x="195" y="16"/>
                  </a:moveTo>
                  <a:lnTo>
                    <a:pt x="195" y="17"/>
                  </a:lnTo>
                  <a:moveTo>
                    <a:pt x="195" y="20"/>
                  </a:moveTo>
                  <a:lnTo>
                    <a:pt x="195" y="21"/>
                  </a:lnTo>
                  <a:moveTo>
                    <a:pt x="195" y="24"/>
                  </a:moveTo>
                  <a:lnTo>
                    <a:pt x="195" y="25"/>
                  </a:lnTo>
                  <a:moveTo>
                    <a:pt x="195" y="28"/>
                  </a:moveTo>
                  <a:lnTo>
                    <a:pt x="195" y="29"/>
                  </a:lnTo>
                  <a:moveTo>
                    <a:pt x="197" y="30"/>
                  </a:moveTo>
                  <a:lnTo>
                    <a:pt x="198" y="30"/>
                  </a:lnTo>
                  <a:moveTo>
                    <a:pt x="201" y="30"/>
                  </a:moveTo>
                  <a:lnTo>
                    <a:pt x="202" y="30"/>
                  </a:lnTo>
                  <a:moveTo>
                    <a:pt x="205" y="30"/>
                  </a:moveTo>
                  <a:lnTo>
                    <a:pt x="206" y="30"/>
                  </a:lnTo>
                  <a:moveTo>
                    <a:pt x="209" y="30"/>
                  </a:moveTo>
                  <a:lnTo>
                    <a:pt x="210" y="30"/>
                  </a:lnTo>
                  <a:moveTo>
                    <a:pt x="213" y="30"/>
                  </a:moveTo>
                  <a:lnTo>
                    <a:pt x="214" y="30"/>
                  </a:lnTo>
                  <a:moveTo>
                    <a:pt x="217" y="30"/>
                  </a:moveTo>
                  <a:lnTo>
                    <a:pt x="218" y="30"/>
                  </a:lnTo>
                  <a:moveTo>
                    <a:pt x="221" y="30"/>
                  </a:moveTo>
                  <a:lnTo>
                    <a:pt x="222" y="30"/>
                  </a:lnTo>
                  <a:moveTo>
                    <a:pt x="225" y="30"/>
                  </a:moveTo>
                  <a:lnTo>
                    <a:pt x="226" y="30"/>
                  </a:lnTo>
                  <a:moveTo>
                    <a:pt x="229" y="30"/>
                  </a:moveTo>
                  <a:lnTo>
                    <a:pt x="230" y="30"/>
                  </a:lnTo>
                  <a:moveTo>
                    <a:pt x="233" y="30"/>
                  </a:moveTo>
                  <a:lnTo>
                    <a:pt x="234" y="30"/>
                  </a:lnTo>
                  <a:moveTo>
                    <a:pt x="237" y="30"/>
                  </a:moveTo>
                  <a:lnTo>
                    <a:pt x="238" y="30"/>
                  </a:lnTo>
                  <a:moveTo>
                    <a:pt x="241" y="30"/>
                  </a:moveTo>
                  <a:lnTo>
                    <a:pt x="242" y="30"/>
                  </a:lnTo>
                  <a:moveTo>
                    <a:pt x="245" y="30"/>
                  </a:moveTo>
                  <a:lnTo>
                    <a:pt x="246" y="30"/>
                  </a:lnTo>
                  <a:moveTo>
                    <a:pt x="249" y="30"/>
                  </a:moveTo>
                  <a:lnTo>
                    <a:pt x="250" y="30"/>
                  </a:lnTo>
                  <a:moveTo>
                    <a:pt x="253" y="30"/>
                  </a:moveTo>
                  <a:lnTo>
                    <a:pt x="254" y="30"/>
                  </a:lnTo>
                  <a:moveTo>
                    <a:pt x="257" y="30"/>
                  </a:moveTo>
                  <a:lnTo>
                    <a:pt x="258" y="30"/>
                  </a:lnTo>
                  <a:moveTo>
                    <a:pt x="260" y="31"/>
                  </a:moveTo>
                  <a:lnTo>
                    <a:pt x="260" y="32"/>
                  </a:lnTo>
                  <a:moveTo>
                    <a:pt x="260" y="35"/>
                  </a:moveTo>
                  <a:lnTo>
                    <a:pt x="260" y="36"/>
                  </a:lnTo>
                  <a:moveTo>
                    <a:pt x="260" y="39"/>
                  </a:moveTo>
                  <a:lnTo>
                    <a:pt x="260" y="40"/>
                  </a:lnTo>
                  <a:moveTo>
                    <a:pt x="260" y="43"/>
                  </a:moveTo>
                  <a:lnTo>
                    <a:pt x="260" y="44"/>
                  </a:lnTo>
                  <a:moveTo>
                    <a:pt x="260" y="47"/>
                  </a:moveTo>
                  <a:lnTo>
                    <a:pt x="260" y="48"/>
                  </a:lnTo>
                  <a:lnTo>
                    <a:pt x="260" y="48"/>
                  </a:lnTo>
                  <a:moveTo>
                    <a:pt x="263" y="48"/>
                  </a:moveTo>
                  <a:lnTo>
                    <a:pt x="264" y="48"/>
                  </a:lnTo>
                  <a:moveTo>
                    <a:pt x="267" y="48"/>
                  </a:moveTo>
                  <a:lnTo>
                    <a:pt x="268" y="48"/>
                  </a:lnTo>
                  <a:moveTo>
                    <a:pt x="271" y="48"/>
                  </a:moveTo>
                  <a:lnTo>
                    <a:pt x="272" y="48"/>
                  </a:lnTo>
                  <a:moveTo>
                    <a:pt x="275" y="48"/>
                  </a:moveTo>
                  <a:lnTo>
                    <a:pt x="276" y="48"/>
                  </a:lnTo>
                  <a:moveTo>
                    <a:pt x="279" y="48"/>
                  </a:moveTo>
                  <a:lnTo>
                    <a:pt x="280" y="48"/>
                  </a:lnTo>
                  <a:moveTo>
                    <a:pt x="283" y="48"/>
                  </a:moveTo>
                  <a:lnTo>
                    <a:pt x="284" y="48"/>
                  </a:lnTo>
                  <a:moveTo>
                    <a:pt x="287" y="48"/>
                  </a:moveTo>
                  <a:lnTo>
                    <a:pt x="288" y="48"/>
                  </a:lnTo>
                  <a:moveTo>
                    <a:pt x="291" y="48"/>
                  </a:moveTo>
                  <a:lnTo>
                    <a:pt x="292" y="48"/>
                  </a:lnTo>
                  <a:moveTo>
                    <a:pt x="295" y="48"/>
                  </a:moveTo>
                  <a:lnTo>
                    <a:pt x="296" y="48"/>
                  </a:lnTo>
                  <a:moveTo>
                    <a:pt x="299" y="48"/>
                  </a:moveTo>
                  <a:lnTo>
                    <a:pt x="300" y="48"/>
                  </a:lnTo>
                  <a:moveTo>
                    <a:pt x="303" y="48"/>
                  </a:moveTo>
                  <a:lnTo>
                    <a:pt x="304" y="48"/>
                  </a:lnTo>
                  <a:moveTo>
                    <a:pt x="307" y="48"/>
                  </a:moveTo>
                  <a:lnTo>
                    <a:pt x="308" y="48"/>
                  </a:lnTo>
                  <a:moveTo>
                    <a:pt x="311" y="48"/>
                  </a:moveTo>
                  <a:lnTo>
                    <a:pt x="312" y="48"/>
                  </a:lnTo>
                  <a:moveTo>
                    <a:pt x="315" y="48"/>
                  </a:moveTo>
                  <a:lnTo>
                    <a:pt x="316" y="48"/>
                  </a:lnTo>
                  <a:moveTo>
                    <a:pt x="319" y="48"/>
                  </a:moveTo>
                  <a:lnTo>
                    <a:pt x="320" y="48"/>
                  </a:lnTo>
                  <a:moveTo>
                    <a:pt x="323" y="48"/>
                  </a:moveTo>
                  <a:lnTo>
                    <a:pt x="324" y="48"/>
                  </a:lnTo>
                  <a:moveTo>
                    <a:pt x="325" y="50"/>
                  </a:moveTo>
                  <a:lnTo>
                    <a:pt x="325" y="51"/>
                  </a:lnTo>
                  <a:moveTo>
                    <a:pt x="325" y="54"/>
                  </a:moveTo>
                  <a:lnTo>
                    <a:pt x="325" y="55"/>
                  </a:lnTo>
                  <a:moveTo>
                    <a:pt x="325" y="58"/>
                  </a:moveTo>
                  <a:lnTo>
                    <a:pt x="325" y="59"/>
                  </a:lnTo>
                  <a:moveTo>
                    <a:pt x="325" y="62"/>
                  </a:moveTo>
                  <a:lnTo>
                    <a:pt x="325" y="63"/>
                  </a:lnTo>
                  <a:moveTo>
                    <a:pt x="325" y="66"/>
                  </a:moveTo>
                  <a:lnTo>
                    <a:pt x="325" y="67"/>
                  </a:lnTo>
                  <a:moveTo>
                    <a:pt x="325" y="70"/>
                  </a:moveTo>
                  <a:lnTo>
                    <a:pt x="325" y="71"/>
                  </a:lnTo>
                  <a:moveTo>
                    <a:pt x="326" y="73"/>
                  </a:moveTo>
                  <a:lnTo>
                    <a:pt x="327" y="73"/>
                  </a:lnTo>
                  <a:moveTo>
                    <a:pt x="330" y="73"/>
                  </a:moveTo>
                  <a:lnTo>
                    <a:pt x="331" y="73"/>
                  </a:lnTo>
                  <a:moveTo>
                    <a:pt x="334" y="73"/>
                  </a:moveTo>
                  <a:lnTo>
                    <a:pt x="335" y="73"/>
                  </a:lnTo>
                  <a:moveTo>
                    <a:pt x="338" y="73"/>
                  </a:moveTo>
                  <a:lnTo>
                    <a:pt x="339" y="73"/>
                  </a:lnTo>
                  <a:moveTo>
                    <a:pt x="342" y="73"/>
                  </a:moveTo>
                  <a:lnTo>
                    <a:pt x="343" y="73"/>
                  </a:lnTo>
                  <a:moveTo>
                    <a:pt x="346" y="73"/>
                  </a:moveTo>
                  <a:lnTo>
                    <a:pt x="347" y="73"/>
                  </a:lnTo>
                  <a:moveTo>
                    <a:pt x="350" y="73"/>
                  </a:moveTo>
                  <a:lnTo>
                    <a:pt x="351" y="73"/>
                  </a:lnTo>
                  <a:moveTo>
                    <a:pt x="354" y="73"/>
                  </a:moveTo>
                  <a:lnTo>
                    <a:pt x="355" y="73"/>
                  </a:lnTo>
                  <a:moveTo>
                    <a:pt x="358" y="73"/>
                  </a:moveTo>
                  <a:lnTo>
                    <a:pt x="359" y="73"/>
                  </a:lnTo>
                  <a:moveTo>
                    <a:pt x="362" y="73"/>
                  </a:moveTo>
                  <a:lnTo>
                    <a:pt x="363" y="73"/>
                  </a:lnTo>
                  <a:moveTo>
                    <a:pt x="366" y="73"/>
                  </a:moveTo>
                  <a:lnTo>
                    <a:pt x="367" y="73"/>
                  </a:lnTo>
                  <a:moveTo>
                    <a:pt x="370" y="73"/>
                  </a:moveTo>
                  <a:lnTo>
                    <a:pt x="371" y="73"/>
                  </a:lnTo>
                  <a:moveTo>
                    <a:pt x="374" y="73"/>
                  </a:moveTo>
                  <a:lnTo>
                    <a:pt x="375" y="73"/>
                  </a:lnTo>
                  <a:moveTo>
                    <a:pt x="378" y="73"/>
                  </a:moveTo>
                  <a:lnTo>
                    <a:pt x="379" y="73"/>
                  </a:lnTo>
                  <a:moveTo>
                    <a:pt x="382" y="73"/>
                  </a:moveTo>
                  <a:lnTo>
                    <a:pt x="383" y="73"/>
                  </a:lnTo>
                  <a:moveTo>
                    <a:pt x="386" y="73"/>
                  </a:moveTo>
                  <a:lnTo>
                    <a:pt x="387" y="73"/>
                  </a:lnTo>
                  <a:moveTo>
                    <a:pt x="390" y="73"/>
                  </a:moveTo>
                  <a:lnTo>
                    <a:pt x="391" y="73"/>
                  </a:lnTo>
                  <a:lnTo>
                    <a:pt x="391" y="73"/>
                  </a:lnTo>
                  <a:moveTo>
                    <a:pt x="391" y="76"/>
                  </a:moveTo>
                  <a:lnTo>
                    <a:pt x="391" y="77"/>
                  </a:lnTo>
                  <a:moveTo>
                    <a:pt x="391" y="80"/>
                  </a:moveTo>
                  <a:lnTo>
                    <a:pt x="391" y="81"/>
                  </a:lnTo>
                  <a:moveTo>
                    <a:pt x="391" y="84"/>
                  </a:moveTo>
                  <a:lnTo>
                    <a:pt x="391" y="85"/>
                  </a:lnTo>
                  <a:moveTo>
                    <a:pt x="391" y="88"/>
                  </a:moveTo>
                  <a:lnTo>
                    <a:pt x="391" y="89"/>
                  </a:lnTo>
                  <a:moveTo>
                    <a:pt x="391" y="92"/>
                  </a:moveTo>
                  <a:lnTo>
                    <a:pt x="391" y="93"/>
                  </a:lnTo>
                  <a:moveTo>
                    <a:pt x="391" y="96"/>
                  </a:moveTo>
                  <a:lnTo>
                    <a:pt x="391" y="97"/>
                  </a:lnTo>
                  <a:moveTo>
                    <a:pt x="391" y="100"/>
                  </a:moveTo>
                  <a:lnTo>
                    <a:pt x="391" y="101"/>
                  </a:lnTo>
                  <a:moveTo>
                    <a:pt x="391" y="104"/>
                  </a:moveTo>
                  <a:lnTo>
                    <a:pt x="391" y="105"/>
                  </a:lnTo>
                  <a:moveTo>
                    <a:pt x="391" y="108"/>
                  </a:moveTo>
                  <a:lnTo>
                    <a:pt x="391" y="109"/>
                  </a:lnTo>
                  <a:moveTo>
                    <a:pt x="391" y="112"/>
                  </a:moveTo>
                  <a:lnTo>
                    <a:pt x="391" y="113"/>
                  </a:lnTo>
                  <a:moveTo>
                    <a:pt x="392" y="115"/>
                  </a:moveTo>
                  <a:lnTo>
                    <a:pt x="393" y="115"/>
                  </a:lnTo>
                  <a:moveTo>
                    <a:pt x="396" y="115"/>
                  </a:moveTo>
                  <a:lnTo>
                    <a:pt x="397" y="115"/>
                  </a:lnTo>
                  <a:moveTo>
                    <a:pt x="400" y="115"/>
                  </a:moveTo>
                  <a:lnTo>
                    <a:pt x="401" y="115"/>
                  </a:lnTo>
                  <a:moveTo>
                    <a:pt x="404" y="115"/>
                  </a:moveTo>
                  <a:lnTo>
                    <a:pt x="405" y="115"/>
                  </a:lnTo>
                  <a:moveTo>
                    <a:pt x="408" y="115"/>
                  </a:moveTo>
                  <a:lnTo>
                    <a:pt x="409" y="115"/>
                  </a:lnTo>
                  <a:moveTo>
                    <a:pt x="412" y="115"/>
                  </a:moveTo>
                  <a:lnTo>
                    <a:pt x="413" y="115"/>
                  </a:lnTo>
                  <a:moveTo>
                    <a:pt x="416" y="115"/>
                  </a:moveTo>
                  <a:lnTo>
                    <a:pt x="417" y="115"/>
                  </a:lnTo>
                  <a:moveTo>
                    <a:pt x="420" y="115"/>
                  </a:moveTo>
                  <a:lnTo>
                    <a:pt x="421" y="115"/>
                  </a:lnTo>
                  <a:moveTo>
                    <a:pt x="424" y="115"/>
                  </a:moveTo>
                  <a:lnTo>
                    <a:pt x="425" y="115"/>
                  </a:lnTo>
                  <a:moveTo>
                    <a:pt x="428" y="115"/>
                  </a:moveTo>
                  <a:lnTo>
                    <a:pt x="429" y="115"/>
                  </a:lnTo>
                  <a:moveTo>
                    <a:pt x="432" y="115"/>
                  </a:moveTo>
                  <a:lnTo>
                    <a:pt x="433" y="115"/>
                  </a:lnTo>
                  <a:moveTo>
                    <a:pt x="436" y="115"/>
                  </a:moveTo>
                  <a:lnTo>
                    <a:pt x="437" y="115"/>
                  </a:lnTo>
                  <a:moveTo>
                    <a:pt x="440" y="115"/>
                  </a:moveTo>
                  <a:lnTo>
                    <a:pt x="441" y="115"/>
                  </a:lnTo>
                  <a:moveTo>
                    <a:pt x="444" y="115"/>
                  </a:moveTo>
                  <a:lnTo>
                    <a:pt x="445" y="115"/>
                  </a:lnTo>
                  <a:moveTo>
                    <a:pt x="448" y="115"/>
                  </a:moveTo>
                  <a:lnTo>
                    <a:pt x="449" y="115"/>
                  </a:lnTo>
                  <a:moveTo>
                    <a:pt x="452" y="115"/>
                  </a:moveTo>
                  <a:lnTo>
                    <a:pt x="453" y="115"/>
                  </a:lnTo>
                  <a:moveTo>
                    <a:pt x="456" y="115"/>
                  </a:moveTo>
                  <a:lnTo>
                    <a:pt x="456" y="116"/>
                  </a:lnTo>
                  <a:moveTo>
                    <a:pt x="456" y="119"/>
                  </a:moveTo>
                  <a:lnTo>
                    <a:pt x="456" y="120"/>
                  </a:lnTo>
                  <a:moveTo>
                    <a:pt x="456" y="123"/>
                  </a:moveTo>
                  <a:lnTo>
                    <a:pt x="456" y="124"/>
                  </a:lnTo>
                  <a:moveTo>
                    <a:pt x="456" y="127"/>
                  </a:moveTo>
                  <a:lnTo>
                    <a:pt x="456" y="128"/>
                  </a:lnTo>
                  <a:moveTo>
                    <a:pt x="456" y="131"/>
                  </a:moveTo>
                  <a:lnTo>
                    <a:pt x="456" y="132"/>
                  </a:lnTo>
                  <a:moveTo>
                    <a:pt x="456" y="135"/>
                  </a:moveTo>
                  <a:lnTo>
                    <a:pt x="456" y="136"/>
                  </a:lnTo>
                  <a:moveTo>
                    <a:pt x="456" y="139"/>
                  </a:moveTo>
                  <a:lnTo>
                    <a:pt x="456" y="140"/>
                  </a:lnTo>
                  <a:moveTo>
                    <a:pt x="456" y="143"/>
                  </a:moveTo>
                  <a:lnTo>
                    <a:pt x="456" y="144"/>
                  </a:lnTo>
                  <a:moveTo>
                    <a:pt x="456" y="147"/>
                  </a:moveTo>
                  <a:lnTo>
                    <a:pt x="456" y="148"/>
                  </a:lnTo>
                  <a:moveTo>
                    <a:pt x="456" y="151"/>
                  </a:moveTo>
                  <a:lnTo>
                    <a:pt x="456" y="152"/>
                  </a:lnTo>
                  <a:moveTo>
                    <a:pt x="456" y="155"/>
                  </a:moveTo>
                  <a:lnTo>
                    <a:pt x="456" y="156"/>
                  </a:lnTo>
                  <a:moveTo>
                    <a:pt x="456" y="159"/>
                  </a:moveTo>
                  <a:lnTo>
                    <a:pt x="456" y="160"/>
                  </a:lnTo>
                  <a:moveTo>
                    <a:pt x="456" y="163"/>
                  </a:moveTo>
                  <a:lnTo>
                    <a:pt x="456" y="164"/>
                  </a:lnTo>
                  <a:moveTo>
                    <a:pt x="456" y="167"/>
                  </a:moveTo>
                  <a:lnTo>
                    <a:pt x="456" y="168"/>
                  </a:lnTo>
                  <a:moveTo>
                    <a:pt x="456" y="171"/>
                  </a:moveTo>
                  <a:lnTo>
                    <a:pt x="456" y="172"/>
                  </a:lnTo>
                  <a:moveTo>
                    <a:pt x="456" y="175"/>
                  </a:moveTo>
                  <a:lnTo>
                    <a:pt x="456" y="176"/>
                  </a:lnTo>
                  <a:moveTo>
                    <a:pt x="456" y="179"/>
                  </a:moveTo>
                  <a:lnTo>
                    <a:pt x="456" y="180"/>
                  </a:lnTo>
                  <a:moveTo>
                    <a:pt x="456" y="183"/>
                  </a:moveTo>
                  <a:lnTo>
                    <a:pt x="456" y="184"/>
                  </a:lnTo>
                  <a:moveTo>
                    <a:pt x="456" y="187"/>
                  </a:moveTo>
                  <a:lnTo>
                    <a:pt x="456" y="188"/>
                  </a:lnTo>
                  <a:moveTo>
                    <a:pt x="456" y="191"/>
                  </a:moveTo>
                  <a:lnTo>
                    <a:pt x="456" y="192"/>
                  </a:lnTo>
                  <a:moveTo>
                    <a:pt x="456" y="195"/>
                  </a:moveTo>
                  <a:lnTo>
                    <a:pt x="456" y="196"/>
                  </a:lnTo>
                  <a:moveTo>
                    <a:pt x="456" y="199"/>
                  </a:moveTo>
                  <a:lnTo>
                    <a:pt x="456" y="200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1" name="Line 69">
              <a:extLst>
                <a:ext uri="{FF2B5EF4-FFF2-40B4-BE49-F238E27FC236}">
                  <a16:creationId xmlns:a16="http://schemas.microsoft.com/office/drawing/2014/main" id="{F6AACEF4-7A06-D890-2516-F049C8B058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" y="1188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2" name="Line 70">
              <a:extLst>
                <a:ext uri="{FF2B5EF4-FFF2-40B4-BE49-F238E27FC236}">
                  <a16:creationId xmlns:a16="http://schemas.microsoft.com/office/drawing/2014/main" id="{2AC3228B-E304-3436-D739-B2CDEB635A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" y="1177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3" name="Line 71">
              <a:extLst>
                <a:ext uri="{FF2B5EF4-FFF2-40B4-BE49-F238E27FC236}">
                  <a16:creationId xmlns:a16="http://schemas.microsoft.com/office/drawing/2014/main" id="{0801D130-FB77-D7EE-DBB3-10CEF1200F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" y="1207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4" name="Line 72">
              <a:extLst>
                <a:ext uri="{FF2B5EF4-FFF2-40B4-BE49-F238E27FC236}">
                  <a16:creationId xmlns:a16="http://schemas.microsoft.com/office/drawing/2014/main" id="{56B3AF15-FEB0-1E0B-32E6-1B50476B70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" y="1193"/>
              <a:ext cx="0" cy="26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5" name="Line 73">
              <a:extLst>
                <a:ext uri="{FF2B5EF4-FFF2-40B4-BE49-F238E27FC236}">
                  <a16:creationId xmlns:a16="http://schemas.microsoft.com/office/drawing/2014/main" id="{3ACE3876-6D21-3045-5E1F-6098291F31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" y="1233"/>
              <a:ext cx="2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6" name="Line 74">
              <a:extLst>
                <a:ext uri="{FF2B5EF4-FFF2-40B4-BE49-F238E27FC236}">
                  <a16:creationId xmlns:a16="http://schemas.microsoft.com/office/drawing/2014/main" id="{04CE9092-D770-C231-CCC0-659BA9E41E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9" y="1221"/>
              <a:ext cx="0" cy="26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7" name="Line 75">
              <a:extLst>
                <a:ext uri="{FF2B5EF4-FFF2-40B4-BE49-F238E27FC236}">
                  <a16:creationId xmlns:a16="http://schemas.microsoft.com/office/drawing/2014/main" id="{AEED9C30-D224-01A8-F5C8-18B2EB39BA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1" y="1273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8" name="Line 76">
              <a:extLst>
                <a:ext uri="{FF2B5EF4-FFF2-40B4-BE49-F238E27FC236}">
                  <a16:creationId xmlns:a16="http://schemas.microsoft.com/office/drawing/2014/main" id="{34AC8B9C-D630-9836-B2FB-46CC979E5A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2" y="1261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79" name="Line 77">
              <a:extLst>
                <a:ext uri="{FF2B5EF4-FFF2-40B4-BE49-F238E27FC236}">
                  <a16:creationId xmlns:a16="http://schemas.microsoft.com/office/drawing/2014/main" id="{F7104C97-0C96-9B80-DA54-37E2F8936E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4" y="1325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0" name="Line 78">
              <a:extLst>
                <a:ext uri="{FF2B5EF4-FFF2-40B4-BE49-F238E27FC236}">
                  <a16:creationId xmlns:a16="http://schemas.microsoft.com/office/drawing/2014/main" id="{9EAF670E-C609-F1AE-B702-8882C6205D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5" y="1313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1" name="Line 79">
              <a:extLst>
                <a:ext uri="{FF2B5EF4-FFF2-40B4-BE49-F238E27FC236}">
                  <a16:creationId xmlns:a16="http://schemas.microsoft.com/office/drawing/2014/main" id="{01A6D243-DE70-B935-AFAB-9B362C08E8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7" y="1402"/>
              <a:ext cx="25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2" name="Line 80">
              <a:extLst>
                <a:ext uri="{FF2B5EF4-FFF2-40B4-BE49-F238E27FC236}">
                  <a16:creationId xmlns:a16="http://schemas.microsoft.com/office/drawing/2014/main" id="{FB0D4FEC-D60F-D689-6B6B-E5870D9FC2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51" y="1391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3" name="Line 81">
              <a:extLst>
                <a:ext uri="{FF2B5EF4-FFF2-40B4-BE49-F238E27FC236}">
                  <a16:creationId xmlns:a16="http://schemas.microsoft.com/office/drawing/2014/main" id="{BC281EC0-9476-6AA4-2757-81CD1678C5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92" y="1553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4" name="Line 82">
              <a:extLst>
                <a:ext uri="{FF2B5EF4-FFF2-40B4-BE49-F238E27FC236}">
                  <a16:creationId xmlns:a16="http://schemas.microsoft.com/office/drawing/2014/main" id="{2EB2B1AB-2F80-281D-A240-5B8E09C515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04" y="1541"/>
              <a:ext cx="0" cy="26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5" name="Freeform 83">
              <a:extLst>
                <a:ext uri="{FF2B5EF4-FFF2-40B4-BE49-F238E27FC236}">
                  <a16:creationId xmlns:a16="http://schemas.microsoft.com/office/drawing/2014/main" id="{3E1DF3ED-FB9C-6085-AF40-F0D51C64C53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1" y="1181"/>
              <a:ext cx="1073" cy="530"/>
            </a:xfrm>
            <a:custGeom>
              <a:avLst/>
              <a:gdLst>
                <a:gd name="T0" fmla="*/ 10 w 456"/>
                <a:gd name="T1" fmla="*/ 0 h 225"/>
                <a:gd name="T2" fmla="*/ 21 w 456"/>
                <a:gd name="T3" fmla="*/ 0 h 225"/>
                <a:gd name="T4" fmla="*/ 32 w 456"/>
                <a:gd name="T5" fmla="*/ 0 h 225"/>
                <a:gd name="T6" fmla="*/ 43 w 456"/>
                <a:gd name="T7" fmla="*/ 0 h 225"/>
                <a:gd name="T8" fmla="*/ 54 w 456"/>
                <a:gd name="T9" fmla="*/ 0 h 225"/>
                <a:gd name="T10" fmla="*/ 64 w 456"/>
                <a:gd name="T11" fmla="*/ 1 h 225"/>
                <a:gd name="T12" fmla="*/ 73 w 456"/>
                <a:gd name="T13" fmla="*/ 3 h 225"/>
                <a:gd name="T14" fmla="*/ 84 w 456"/>
                <a:gd name="T15" fmla="*/ 3 h 225"/>
                <a:gd name="T16" fmla="*/ 95 w 456"/>
                <a:gd name="T17" fmla="*/ 3 h 225"/>
                <a:gd name="T18" fmla="*/ 106 w 456"/>
                <a:gd name="T19" fmla="*/ 3 h 225"/>
                <a:gd name="T20" fmla="*/ 117 w 456"/>
                <a:gd name="T21" fmla="*/ 3 h 225"/>
                <a:gd name="T22" fmla="*/ 128 w 456"/>
                <a:gd name="T23" fmla="*/ 3 h 225"/>
                <a:gd name="T24" fmla="*/ 129 w 456"/>
                <a:gd name="T25" fmla="*/ 10 h 225"/>
                <a:gd name="T26" fmla="*/ 136 w 456"/>
                <a:gd name="T27" fmla="*/ 10 h 225"/>
                <a:gd name="T28" fmla="*/ 147 w 456"/>
                <a:gd name="T29" fmla="*/ 10 h 225"/>
                <a:gd name="T30" fmla="*/ 158 w 456"/>
                <a:gd name="T31" fmla="*/ 10 h 225"/>
                <a:gd name="T32" fmla="*/ 169 w 456"/>
                <a:gd name="T33" fmla="*/ 10 h 225"/>
                <a:gd name="T34" fmla="*/ 180 w 456"/>
                <a:gd name="T35" fmla="*/ 10 h 225"/>
                <a:gd name="T36" fmla="*/ 191 w 456"/>
                <a:gd name="T37" fmla="*/ 10 h 225"/>
                <a:gd name="T38" fmla="*/ 195 w 456"/>
                <a:gd name="T39" fmla="*/ 14 h 225"/>
                <a:gd name="T40" fmla="*/ 196 w 456"/>
                <a:gd name="T41" fmla="*/ 24 h 225"/>
                <a:gd name="T42" fmla="*/ 207 w 456"/>
                <a:gd name="T43" fmla="*/ 24 h 225"/>
                <a:gd name="T44" fmla="*/ 218 w 456"/>
                <a:gd name="T45" fmla="*/ 24 h 225"/>
                <a:gd name="T46" fmla="*/ 229 w 456"/>
                <a:gd name="T47" fmla="*/ 24 h 225"/>
                <a:gd name="T48" fmla="*/ 240 w 456"/>
                <a:gd name="T49" fmla="*/ 24 h 225"/>
                <a:gd name="T50" fmla="*/ 251 w 456"/>
                <a:gd name="T51" fmla="*/ 24 h 225"/>
                <a:gd name="T52" fmla="*/ 260 w 456"/>
                <a:gd name="T53" fmla="*/ 26 h 225"/>
                <a:gd name="T54" fmla="*/ 260 w 456"/>
                <a:gd name="T55" fmla="*/ 37 h 225"/>
                <a:gd name="T56" fmla="*/ 268 w 456"/>
                <a:gd name="T57" fmla="*/ 40 h 225"/>
                <a:gd name="T58" fmla="*/ 279 w 456"/>
                <a:gd name="T59" fmla="*/ 40 h 225"/>
                <a:gd name="T60" fmla="*/ 290 w 456"/>
                <a:gd name="T61" fmla="*/ 40 h 225"/>
                <a:gd name="T62" fmla="*/ 301 w 456"/>
                <a:gd name="T63" fmla="*/ 40 h 225"/>
                <a:gd name="T64" fmla="*/ 312 w 456"/>
                <a:gd name="T65" fmla="*/ 40 h 225"/>
                <a:gd name="T66" fmla="*/ 323 w 456"/>
                <a:gd name="T67" fmla="*/ 40 h 225"/>
                <a:gd name="T68" fmla="*/ 325 w 456"/>
                <a:gd name="T69" fmla="*/ 49 h 225"/>
                <a:gd name="T70" fmla="*/ 325 w 456"/>
                <a:gd name="T71" fmla="*/ 60 h 225"/>
                <a:gd name="T72" fmla="*/ 333 w 456"/>
                <a:gd name="T73" fmla="*/ 63 h 225"/>
                <a:gd name="T74" fmla="*/ 344 w 456"/>
                <a:gd name="T75" fmla="*/ 63 h 225"/>
                <a:gd name="T76" fmla="*/ 355 w 456"/>
                <a:gd name="T77" fmla="*/ 63 h 225"/>
                <a:gd name="T78" fmla="*/ 366 w 456"/>
                <a:gd name="T79" fmla="*/ 63 h 225"/>
                <a:gd name="T80" fmla="*/ 377 w 456"/>
                <a:gd name="T81" fmla="*/ 63 h 225"/>
                <a:gd name="T82" fmla="*/ 388 w 456"/>
                <a:gd name="T83" fmla="*/ 63 h 225"/>
                <a:gd name="T84" fmla="*/ 391 w 456"/>
                <a:gd name="T85" fmla="*/ 71 h 225"/>
                <a:gd name="T86" fmla="*/ 391 w 456"/>
                <a:gd name="T87" fmla="*/ 82 h 225"/>
                <a:gd name="T88" fmla="*/ 391 w 456"/>
                <a:gd name="T89" fmla="*/ 93 h 225"/>
                <a:gd name="T90" fmla="*/ 391 w 456"/>
                <a:gd name="T91" fmla="*/ 104 h 225"/>
                <a:gd name="T92" fmla="*/ 399 w 456"/>
                <a:gd name="T93" fmla="*/ 107 h 225"/>
                <a:gd name="T94" fmla="*/ 410 w 456"/>
                <a:gd name="T95" fmla="*/ 107 h 225"/>
                <a:gd name="T96" fmla="*/ 421 w 456"/>
                <a:gd name="T97" fmla="*/ 107 h 225"/>
                <a:gd name="T98" fmla="*/ 432 w 456"/>
                <a:gd name="T99" fmla="*/ 107 h 225"/>
                <a:gd name="T100" fmla="*/ 443 w 456"/>
                <a:gd name="T101" fmla="*/ 107 h 225"/>
                <a:gd name="T102" fmla="*/ 454 w 456"/>
                <a:gd name="T103" fmla="*/ 107 h 225"/>
                <a:gd name="T104" fmla="*/ 456 w 456"/>
                <a:gd name="T105" fmla="*/ 116 h 225"/>
                <a:gd name="T106" fmla="*/ 456 w 456"/>
                <a:gd name="T107" fmla="*/ 127 h 225"/>
                <a:gd name="T108" fmla="*/ 456 w 456"/>
                <a:gd name="T109" fmla="*/ 138 h 225"/>
                <a:gd name="T110" fmla="*/ 456 w 456"/>
                <a:gd name="T111" fmla="*/ 149 h 225"/>
                <a:gd name="T112" fmla="*/ 456 w 456"/>
                <a:gd name="T113" fmla="*/ 160 h 225"/>
                <a:gd name="T114" fmla="*/ 456 w 456"/>
                <a:gd name="T115" fmla="*/ 171 h 225"/>
                <a:gd name="T116" fmla="*/ 456 w 456"/>
                <a:gd name="T117" fmla="*/ 182 h 225"/>
                <a:gd name="T118" fmla="*/ 456 w 456"/>
                <a:gd name="T119" fmla="*/ 193 h 225"/>
                <a:gd name="T120" fmla="*/ 456 w 456"/>
                <a:gd name="T121" fmla="*/ 204 h 225"/>
                <a:gd name="T122" fmla="*/ 456 w 456"/>
                <a:gd name="T123" fmla="*/ 215 h 2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456" h="225">
                  <a:moveTo>
                    <a:pt x="3" y="0"/>
                  </a:moveTo>
                  <a:lnTo>
                    <a:pt x="7" y="0"/>
                  </a:lnTo>
                  <a:moveTo>
                    <a:pt x="10" y="0"/>
                  </a:moveTo>
                  <a:lnTo>
                    <a:pt x="11" y="0"/>
                  </a:lnTo>
                  <a:moveTo>
                    <a:pt x="14" y="0"/>
                  </a:moveTo>
                  <a:lnTo>
                    <a:pt x="18" y="0"/>
                  </a:lnTo>
                  <a:moveTo>
                    <a:pt x="21" y="0"/>
                  </a:moveTo>
                  <a:lnTo>
                    <a:pt x="22" y="0"/>
                  </a:lnTo>
                  <a:moveTo>
                    <a:pt x="25" y="0"/>
                  </a:moveTo>
                  <a:lnTo>
                    <a:pt x="29" y="0"/>
                  </a:lnTo>
                  <a:moveTo>
                    <a:pt x="32" y="0"/>
                  </a:moveTo>
                  <a:lnTo>
                    <a:pt x="33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51" y="0"/>
                  </a:lnTo>
                  <a:moveTo>
                    <a:pt x="54" y="0"/>
                  </a:moveTo>
                  <a:lnTo>
                    <a:pt x="55" y="0"/>
                  </a:lnTo>
                  <a:moveTo>
                    <a:pt x="58" y="0"/>
                  </a:moveTo>
                  <a:lnTo>
                    <a:pt x="62" y="0"/>
                  </a:lnTo>
                  <a:moveTo>
                    <a:pt x="64" y="1"/>
                  </a:moveTo>
                  <a:lnTo>
                    <a:pt x="64" y="2"/>
                  </a:lnTo>
                  <a:moveTo>
                    <a:pt x="66" y="3"/>
                  </a:moveTo>
                  <a:lnTo>
                    <a:pt x="70" y="3"/>
                  </a:lnTo>
                  <a:moveTo>
                    <a:pt x="73" y="3"/>
                  </a:moveTo>
                  <a:lnTo>
                    <a:pt x="74" y="3"/>
                  </a:lnTo>
                  <a:moveTo>
                    <a:pt x="77" y="3"/>
                  </a:moveTo>
                  <a:lnTo>
                    <a:pt x="81" y="3"/>
                  </a:lnTo>
                  <a:moveTo>
                    <a:pt x="84" y="3"/>
                  </a:moveTo>
                  <a:lnTo>
                    <a:pt x="85" y="3"/>
                  </a:lnTo>
                  <a:moveTo>
                    <a:pt x="88" y="3"/>
                  </a:moveTo>
                  <a:lnTo>
                    <a:pt x="92" y="3"/>
                  </a:lnTo>
                  <a:moveTo>
                    <a:pt x="95" y="3"/>
                  </a:moveTo>
                  <a:lnTo>
                    <a:pt x="96" y="3"/>
                  </a:lnTo>
                  <a:moveTo>
                    <a:pt x="99" y="3"/>
                  </a:moveTo>
                  <a:lnTo>
                    <a:pt x="103" y="3"/>
                  </a:lnTo>
                  <a:moveTo>
                    <a:pt x="106" y="3"/>
                  </a:moveTo>
                  <a:lnTo>
                    <a:pt x="107" y="3"/>
                  </a:lnTo>
                  <a:moveTo>
                    <a:pt x="110" y="3"/>
                  </a:moveTo>
                  <a:lnTo>
                    <a:pt x="114" y="3"/>
                  </a:lnTo>
                  <a:moveTo>
                    <a:pt x="117" y="3"/>
                  </a:moveTo>
                  <a:lnTo>
                    <a:pt x="118" y="3"/>
                  </a:lnTo>
                  <a:moveTo>
                    <a:pt x="121" y="3"/>
                  </a:moveTo>
                  <a:lnTo>
                    <a:pt x="125" y="3"/>
                  </a:lnTo>
                  <a:moveTo>
                    <a:pt x="128" y="3"/>
                  </a:moveTo>
                  <a:lnTo>
                    <a:pt x="129" y="3"/>
                  </a:lnTo>
                  <a:lnTo>
                    <a:pt x="129" y="3"/>
                  </a:lnTo>
                  <a:moveTo>
                    <a:pt x="129" y="6"/>
                  </a:moveTo>
                  <a:lnTo>
                    <a:pt x="129" y="10"/>
                  </a:lnTo>
                  <a:lnTo>
                    <a:pt x="129" y="10"/>
                  </a:lnTo>
                  <a:moveTo>
                    <a:pt x="132" y="10"/>
                  </a:moveTo>
                  <a:lnTo>
                    <a:pt x="133" y="10"/>
                  </a:lnTo>
                  <a:moveTo>
                    <a:pt x="136" y="10"/>
                  </a:moveTo>
                  <a:lnTo>
                    <a:pt x="140" y="10"/>
                  </a:lnTo>
                  <a:moveTo>
                    <a:pt x="143" y="10"/>
                  </a:moveTo>
                  <a:lnTo>
                    <a:pt x="144" y="10"/>
                  </a:lnTo>
                  <a:moveTo>
                    <a:pt x="147" y="10"/>
                  </a:moveTo>
                  <a:lnTo>
                    <a:pt x="151" y="10"/>
                  </a:lnTo>
                  <a:moveTo>
                    <a:pt x="154" y="10"/>
                  </a:moveTo>
                  <a:lnTo>
                    <a:pt x="155" y="10"/>
                  </a:lnTo>
                  <a:moveTo>
                    <a:pt x="158" y="10"/>
                  </a:moveTo>
                  <a:lnTo>
                    <a:pt x="162" y="10"/>
                  </a:lnTo>
                  <a:moveTo>
                    <a:pt x="165" y="10"/>
                  </a:moveTo>
                  <a:lnTo>
                    <a:pt x="166" y="10"/>
                  </a:lnTo>
                  <a:moveTo>
                    <a:pt x="169" y="10"/>
                  </a:moveTo>
                  <a:lnTo>
                    <a:pt x="173" y="10"/>
                  </a:lnTo>
                  <a:moveTo>
                    <a:pt x="176" y="10"/>
                  </a:moveTo>
                  <a:lnTo>
                    <a:pt x="177" y="10"/>
                  </a:lnTo>
                  <a:moveTo>
                    <a:pt x="180" y="10"/>
                  </a:moveTo>
                  <a:lnTo>
                    <a:pt x="184" y="10"/>
                  </a:lnTo>
                  <a:moveTo>
                    <a:pt x="187" y="10"/>
                  </a:moveTo>
                  <a:lnTo>
                    <a:pt x="188" y="10"/>
                  </a:lnTo>
                  <a:moveTo>
                    <a:pt x="191" y="10"/>
                  </a:moveTo>
                  <a:lnTo>
                    <a:pt x="195" y="10"/>
                  </a:lnTo>
                  <a:lnTo>
                    <a:pt x="195" y="10"/>
                  </a:lnTo>
                  <a:moveTo>
                    <a:pt x="195" y="13"/>
                  </a:moveTo>
                  <a:lnTo>
                    <a:pt x="195" y="14"/>
                  </a:lnTo>
                  <a:moveTo>
                    <a:pt x="195" y="17"/>
                  </a:moveTo>
                  <a:lnTo>
                    <a:pt x="195" y="21"/>
                  </a:lnTo>
                  <a:moveTo>
                    <a:pt x="195" y="24"/>
                  </a:moveTo>
                  <a:lnTo>
                    <a:pt x="196" y="24"/>
                  </a:lnTo>
                  <a:moveTo>
                    <a:pt x="199" y="24"/>
                  </a:moveTo>
                  <a:lnTo>
                    <a:pt x="203" y="24"/>
                  </a:lnTo>
                  <a:moveTo>
                    <a:pt x="206" y="24"/>
                  </a:moveTo>
                  <a:lnTo>
                    <a:pt x="207" y="24"/>
                  </a:lnTo>
                  <a:moveTo>
                    <a:pt x="210" y="24"/>
                  </a:moveTo>
                  <a:lnTo>
                    <a:pt x="214" y="24"/>
                  </a:lnTo>
                  <a:moveTo>
                    <a:pt x="217" y="24"/>
                  </a:moveTo>
                  <a:lnTo>
                    <a:pt x="218" y="24"/>
                  </a:lnTo>
                  <a:moveTo>
                    <a:pt x="221" y="24"/>
                  </a:moveTo>
                  <a:lnTo>
                    <a:pt x="225" y="24"/>
                  </a:lnTo>
                  <a:moveTo>
                    <a:pt x="228" y="24"/>
                  </a:moveTo>
                  <a:lnTo>
                    <a:pt x="229" y="24"/>
                  </a:lnTo>
                  <a:moveTo>
                    <a:pt x="232" y="24"/>
                  </a:moveTo>
                  <a:lnTo>
                    <a:pt x="236" y="24"/>
                  </a:lnTo>
                  <a:moveTo>
                    <a:pt x="239" y="24"/>
                  </a:moveTo>
                  <a:lnTo>
                    <a:pt x="240" y="24"/>
                  </a:lnTo>
                  <a:moveTo>
                    <a:pt x="243" y="24"/>
                  </a:moveTo>
                  <a:lnTo>
                    <a:pt x="247" y="24"/>
                  </a:lnTo>
                  <a:moveTo>
                    <a:pt x="250" y="24"/>
                  </a:moveTo>
                  <a:lnTo>
                    <a:pt x="251" y="24"/>
                  </a:lnTo>
                  <a:moveTo>
                    <a:pt x="254" y="24"/>
                  </a:moveTo>
                  <a:lnTo>
                    <a:pt x="258" y="24"/>
                  </a:lnTo>
                  <a:moveTo>
                    <a:pt x="260" y="25"/>
                  </a:moveTo>
                  <a:lnTo>
                    <a:pt x="260" y="26"/>
                  </a:lnTo>
                  <a:moveTo>
                    <a:pt x="260" y="29"/>
                  </a:moveTo>
                  <a:lnTo>
                    <a:pt x="260" y="33"/>
                  </a:lnTo>
                  <a:moveTo>
                    <a:pt x="260" y="36"/>
                  </a:moveTo>
                  <a:lnTo>
                    <a:pt x="260" y="37"/>
                  </a:lnTo>
                  <a:moveTo>
                    <a:pt x="260" y="40"/>
                  </a:moveTo>
                  <a:lnTo>
                    <a:pt x="264" y="40"/>
                  </a:lnTo>
                  <a:moveTo>
                    <a:pt x="267" y="40"/>
                  </a:moveTo>
                  <a:lnTo>
                    <a:pt x="268" y="40"/>
                  </a:lnTo>
                  <a:moveTo>
                    <a:pt x="271" y="40"/>
                  </a:moveTo>
                  <a:lnTo>
                    <a:pt x="275" y="40"/>
                  </a:lnTo>
                  <a:moveTo>
                    <a:pt x="278" y="40"/>
                  </a:moveTo>
                  <a:lnTo>
                    <a:pt x="279" y="40"/>
                  </a:lnTo>
                  <a:moveTo>
                    <a:pt x="282" y="40"/>
                  </a:moveTo>
                  <a:lnTo>
                    <a:pt x="286" y="40"/>
                  </a:lnTo>
                  <a:moveTo>
                    <a:pt x="289" y="40"/>
                  </a:moveTo>
                  <a:lnTo>
                    <a:pt x="290" y="40"/>
                  </a:lnTo>
                  <a:moveTo>
                    <a:pt x="293" y="40"/>
                  </a:moveTo>
                  <a:lnTo>
                    <a:pt x="297" y="40"/>
                  </a:lnTo>
                  <a:moveTo>
                    <a:pt x="300" y="40"/>
                  </a:moveTo>
                  <a:lnTo>
                    <a:pt x="301" y="40"/>
                  </a:lnTo>
                  <a:moveTo>
                    <a:pt x="304" y="40"/>
                  </a:moveTo>
                  <a:lnTo>
                    <a:pt x="308" y="40"/>
                  </a:lnTo>
                  <a:moveTo>
                    <a:pt x="311" y="40"/>
                  </a:moveTo>
                  <a:lnTo>
                    <a:pt x="312" y="40"/>
                  </a:lnTo>
                  <a:moveTo>
                    <a:pt x="315" y="40"/>
                  </a:moveTo>
                  <a:lnTo>
                    <a:pt x="319" y="40"/>
                  </a:lnTo>
                  <a:moveTo>
                    <a:pt x="322" y="40"/>
                  </a:moveTo>
                  <a:lnTo>
                    <a:pt x="323" y="40"/>
                  </a:lnTo>
                  <a:moveTo>
                    <a:pt x="325" y="41"/>
                  </a:moveTo>
                  <a:lnTo>
                    <a:pt x="325" y="45"/>
                  </a:lnTo>
                  <a:moveTo>
                    <a:pt x="325" y="48"/>
                  </a:moveTo>
                  <a:lnTo>
                    <a:pt x="325" y="49"/>
                  </a:lnTo>
                  <a:moveTo>
                    <a:pt x="325" y="52"/>
                  </a:moveTo>
                  <a:lnTo>
                    <a:pt x="325" y="56"/>
                  </a:lnTo>
                  <a:moveTo>
                    <a:pt x="325" y="59"/>
                  </a:moveTo>
                  <a:lnTo>
                    <a:pt x="325" y="60"/>
                  </a:lnTo>
                  <a:moveTo>
                    <a:pt x="325" y="63"/>
                  </a:moveTo>
                  <a:lnTo>
                    <a:pt x="329" y="63"/>
                  </a:lnTo>
                  <a:moveTo>
                    <a:pt x="332" y="63"/>
                  </a:moveTo>
                  <a:lnTo>
                    <a:pt x="333" y="63"/>
                  </a:lnTo>
                  <a:moveTo>
                    <a:pt x="336" y="63"/>
                  </a:moveTo>
                  <a:lnTo>
                    <a:pt x="340" y="63"/>
                  </a:lnTo>
                  <a:moveTo>
                    <a:pt x="343" y="63"/>
                  </a:moveTo>
                  <a:lnTo>
                    <a:pt x="344" y="63"/>
                  </a:lnTo>
                  <a:moveTo>
                    <a:pt x="347" y="63"/>
                  </a:moveTo>
                  <a:lnTo>
                    <a:pt x="351" y="63"/>
                  </a:lnTo>
                  <a:moveTo>
                    <a:pt x="354" y="63"/>
                  </a:moveTo>
                  <a:lnTo>
                    <a:pt x="355" y="63"/>
                  </a:lnTo>
                  <a:moveTo>
                    <a:pt x="358" y="63"/>
                  </a:moveTo>
                  <a:lnTo>
                    <a:pt x="362" y="63"/>
                  </a:lnTo>
                  <a:moveTo>
                    <a:pt x="365" y="63"/>
                  </a:moveTo>
                  <a:lnTo>
                    <a:pt x="366" y="63"/>
                  </a:lnTo>
                  <a:moveTo>
                    <a:pt x="369" y="63"/>
                  </a:moveTo>
                  <a:lnTo>
                    <a:pt x="373" y="63"/>
                  </a:lnTo>
                  <a:moveTo>
                    <a:pt x="376" y="63"/>
                  </a:moveTo>
                  <a:lnTo>
                    <a:pt x="377" y="63"/>
                  </a:lnTo>
                  <a:moveTo>
                    <a:pt x="380" y="63"/>
                  </a:moveTo>
                  <a:lnTo>
                    <a:pt x="384" y="63"/>
                  </a:lnTo>
                  <a:moveTo>
                    <a:pt x="387" y="63"/>
                  </a:moveTo>
                  <a:lnTo>
                    <a:pt x="388" y="63"/>
                  </a:lnTo>
                  <a:moveTo>
                    <a:pt x="391" y="63"/>
                  </a:moveTo>
                  <a:lnTo>
                    <a:pt x="391" y="67"/>
                  </a:lnTo>
                  <a:moveTo>
                    <a:pt x="391" y="70"/>
                  </a:moveTo>
                  <a:lnTo>
                    <a:pt x="391" y="71"/>
                  </a:lnTo>
                  <a:moveTo>
                    <a:pt x="391" y="74"/>
                  </a:moveTo>
                  <a:lnTo>
                    <a:pt x="391" y="78"/>
                  </a:lnTo>
                  <a:moveTo>
                    <a:pt x="391" y="81"/>
                  </a:moveTo>
                  <a:lnTo>
                    <a:pt x="391" y="82"/>
                  </a:lnTo>
                  <a:moveTo>
                    <a:pt x="391" y="85"/>
                  </a:moveTo>
                  <a:lnTo>
                    <a:pt x="391" y="89"/>
                  </a:lnTo>
                  <a:moveTo>
                    <a:pt x="391" y="92"/>
                  </a:moveTo>
                  <a:lnTo>
                    <a:pt x="391" y="93"/>
                  </a:lnTo>
                  <a:moveTo>
                    <a:pt x="391" y="96"/>
                  </a:moveTo>
                  <a:lnTo>
                    <a:pt x="391" y="100"/>
                  </a:lnTo>
                  <a:moveTo>
                    <a:pt x="391" y="103"/>
                  </a:moveTo>
                  <a:lnTo>
                    <a:pt x="391" y="104"/>
                  </a:lnTo>
                  <a:moveTo>
                    <a:pt x="391" y="107"/>
                  </a:moveTo>
                  <a:lnTo>
                    <a:pt x="395" y="107"/>
                  </a:lnTo>
                  <a:moveTo>
                    <a:pt x="398" y="107"/>
                  </a:moveTo>
                  <a:lnTo>
                    <a:pt x="399" y="107"/>
                  </a:lnTo>
                  <a:moveTo>
                    <a:pt x="402" y="107"/>
                  </a:moveTo>
                  <a:lnTo>
                    <a:pt x="406" y="107"/>
                  </a:lnTo>
                  <a:moveTo>
                    <a:pt x="409" y="107"/>
                  </a:moveTo>
                  <a:lnTo>
                    <a:pt x="410" y="107"/>
                  </a:lnTo>
                  <a:moveTo>
                    <a:pt x="413" y="107"/>
                  </a:moveTo>
                  <a:lnTo>
                    <a:pt x="417" y="107"/>
                  </a:lnTo>
                  <a:moveTo>
                    <a:pt x="420" y="107"/>
                  </a:moveTo>
                  <a:lnTo>
                    <a:pt x="421" y="107"/>
                  </a:lnTo>
                  <a:moveTo>
                    <a:pt x="424" y="107"/>
                  </a:moveTo>
                  <a:lnTo>
                    <a:pt x="428" y="107"/>
                  </a:lnTo>
                  <a:moveTo>
                    <a:pt x="431" y="107"/>
                  </a:moveTo>
                  <a:lnTo>
                    <a:pt x="432" y="107"/>
                  </a:lnTo>
                  <a:moveTo>
                    <a:pt x="435" y="107"/>
                  </a:moveTo>
                  <a:lnTo>
                    <a:pt x="439" y="107"/>
                  </a:lnTo>
                  <a:moveTo>
                    <a:pt x="442" y="107"/>
                  </a:moveTo>
                  <a:lnTo>
                    <a:pt x="443" y="107"/>
                  </a:lnTo>
                  <a:moveTo>
                    <a:pt x="446" y="107"/>
                  </a:moveTo>
                  <a:lnTo>
                    <a:pt x="450" y="107"/>
                  </a:lnTo>
                  <a:moveTo>
                    <a:pt x="453" y="107"/>
                  </a:moveTo>
                  <a:lnTo>
                    <a:pt x="454" y="107"/>
                  </a:lnTo>
                  <a:moveTo>
                    <a:pt x="456" y="108"/>
                  </a:moveTo>
                  <a:lnTo>
                    <a:pt x="456" y="112"/>
                  </a:lnTo>
                  <a:moveTo>
                    <a:pt x="456" y="115"/>
                  </a:moveTo>
                  <a:lnTo>
                    <a:pt x="456" y="116"/>
                  </a:lnTo>
                  <a:moveTo>
                    <a:pt x="456" y="119"/>
                  </a:moveTo>
                  <a:lnTo>
                    <a:pt x="456" y="123"/>
                  </a:lnTo>
                  <a:moveTo>
                    <a:pt x="456" y="126"/>
                  </a:moveTo>
                  <a:lnTo>
                    <a:pt x="456" y="127"/>
                  </a:lnTo>
                  <a:moveTo>
                    <a:pt x="456" y="130"/>
                  </a:moveTo>
                  <a:lnTo>
                    <a:pt x="456" y="134"/>
                  </a:lnTo>
                  <a:moveTo>
                    <a:pt x="456" y="137"/>
                  </a:moveTo>
                  <a:lnTo>
                    <a:pt x="456" y="138"/>
                  </a:lnTo>
                  <a:moveTo>
                    <a:pt x="456" y="141"/>
                  </a:moveTo>
                  <a:lnTo>
                    <a:pt x="456" y="145"/>
                  </a:lnTo>
                  <a:moveTo>
                    <a:pt x="456" y="148"/>
                  </a:moveTo>
                  <a:lnTo>
                    <a:pt x="456" y="149"/>
                  </a:lnTo>
                  <a:moveTo>
                    <a:pt x="456" y="152"/>
                  </a:moveTo>
                  <a:lnTo>
                    <a:pt x="456" y="156"/>
                  </a:lnTo>
                  <a:moveTo>
                    <a:pt x="456" y="159"/>
                  </a:moveTo>
                  <a:lnTo>
                    <a:pt x="456" y="160"/>
                  </a:lnTo>
                  <a:moveTo>
                    <a:pt x="456" y="163"/>
                  </a:moveTo>
                  <a:lnTo>
                    <a:pt x="456" y="167"/>
                  </a:lnTo>
                  <a:moveTo>
                    <a:pt x="456" y="170"/>
                  </a:moveTo>
                  <a:lnTo>
                    <a:pt x="456" y="171"/>
                  </a:lnTo>
                  <a:moveTo>
                    <a:pt x="456" y="174"/>
                  </a:moveTo>
                  <a:lnTo>
                    <a:pt x="456" y="178"/>
                  </a:lnTo>
                  <a:moveTo>
                    <a:pt x="456" y="181"/>
                  </a:moveTo>
                  <a:lnTo>
                    <a:pt x="456" y="182"/>
                  </a:lnTo>
                  <a:moveTo>
                    <a:pt x="456" y="185"/>
                  </a:moveTo>
                  <a:lnTo>
                    <a:pt x="456" y="189"/>
                  </a:lnTo>
                  <a:moveTo>
                    <a:pt x="456" y="192"/>
                  </a:moveTo>
                  <a:lnTo>
                    <a:pt x="456" y="193"/>
                  </a:lnTo>
                  <a:moveTo>
                    <a:pt x="456" y="196"/>
                  </a:moveTo>
                  <a:lnTo>
                    <a:pt x="456" y="200"/>
                  </a:lnTo>
                  <a:moveTo>
                    <a:pt x="456" y="203"/>
                  </a:moveTo>
                  <a:lnTo>
                    <a:pt x="456" y="204"/>
                  </a:lnTo>
                  <a:moveTo>
                    <a:pt x="456" y="207"/>
                  </a:moveTo>
                  <a:lnTo>
                    <a:pt x="456" y="211"/>
                  </a:lnTo>
                  <a:moveTo>
                    <a:pt x="456" y="214"/>
                  </a:moveTo>
                  <a:lnTo>
                    <a:pt x="456" y="215"/>
                  </a:lnTo>
                  <a:moveTo>
                    <a:pt x="456" y="218"/>
                  </a:moveTo>
                  <a:lnTo>
                    <a:pt x="456" y="222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dirty="0"/>
            </a:p>
          </p:txBody>
        </p:sp>
        <p:sp>
          <p:nvSpPr>
            <p:cNvPr id="86" name="Line 84">
              <a:extLst>
                <a:ext uri="{FF2B5EF4-FFF2-40B4-BE49-F238E27FC236}">
                  <a16:creationId xmlns:a16="http://schemas.microsoft.com/office/drawing/2014/main" id="{EE94EE4D-3611-42CA-4DAE-11E21B143B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" y="1186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7" name="Line 85">
              <a:extLst>
                <a:ext uri="{FF2B5EF4-FFF2-40B4-BE49-F238E27FC236}">
                  <a16:creationId xmlns:a16="http://schemas.microsoft.com/office/drawing/2014/main" id="{E26FD408-321F-7A93-D31D-2E582D61F7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" y="1174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dirty="0"/>
            </a:p>
          </p:txBody>
        </p:sp>
        <p:sp>
          <p:nvSpPr>
            <p:cNvPr id="88" name="Line 86">
              <a:extLst>
                <a:ext uri="{FF2B5EF4-FFF2-40B4-BE49-F238E27FC236}">
                  <a16:creationId xmlns:a16="http://schemas.microsoft.com/office/drawing/2014/main" id="{370D561F-3521-8FA2-174F-032685D0A6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" y="1198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89" name="Line 87">
              <a:extLst>
                <a:ext uri="{FF2B5EF4-FFF2-40B4-BE49-F238E27FC236}">
                  <a16:creationId xmlns:a16="http://schemas.microsoft.com/office/drawing/2014/main" id="{EE3D07A1-0C9A-015B-FBCB-BC050DB6D3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" y="1186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0" name="Line 88">
              <a:extLst>
                <a:ext uri="{FF2B5EF4-FFF2-40B4-BE49-F238E27FC236}">
                  <a16:creationId xmlns:a16="http://schemas.microsoft.com/office/drawing/2014/main" id="{2DC7524B-F58E-A8C1-1708-DA96BB5084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" y="1221"/>
              <a:ext cx="2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1" name="Line 89">
              <a:extLst>
                <a:ext uri="{FF2B5EF4-FFF2-40B4-BE49-F238E27FC236}">
                  <a16:creationId xmlns:a16="http://schemas.microsoft.com/office/drawing/2014/main" id="{4DE5098A-F9A2-D2E3-A3AF-B0C470CCA5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9" y="1209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2" name="Line 90">
              <a:extLst>
                <a:ext uri="{FF2B5EF4-FFF2-40B4-BE49-F238E27FC236}">
                  <a16:creationId xmlns:a16="http://schemas.microsoft.com/office/drawing/2014/main" id="{5388A542-95D2-F315-839F-196C974369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1" y="1257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3" name="Line 91">
              <a:extLst>
                <a:ext uri="{FF2B5EF4-FFF2-40B4-BE49-F238E27FC236}">
                  <a16:creationId xmlns:a16="http://schemas.microsoft.com/office/drawing/2014/main" id="{C4381B85-AD24-D1D3-CD8C-78A8DDC7BB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2" y="1245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4" name="Line 92">
              <a:extLst>
                <a:ext uri="{FF2B5EF4-FFF2-40B4-BE49-F238E27FC236}">
                  <a16:creationId xmlns:a16="http://schemas.microsoft.com/office/drawing/2014/main" id="{6DD0EF3F-91A7-2B3E-AAAF-35EA594C35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4" y="1304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5" name="Line 93">
              <a:extLst>
                <a:ext uri="{FF2B5EF4-FFF2-40B4-BE49-F238E27FC236}">
                  <a16:creationId xmlns:a16="http://schemas.microsoft.com/office/drawing/2014/main" id="{985795BF-BDA4-922E-B908-4BA0F996B6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5" y="1292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6" name="Line 94">
              <a:extLst>
                <a:ext uri="{FF2B5EF4-FFF2-40B4-BE49-F238E27FC236}">
                  <a16:creationId xmlns:a16="http://schemas.microsoft.com/office/drawing/2014/main" id="{8B5245D6-2ACC-D757-6884-482856B590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7" y="1381"/>
              <a:ext cx="25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7" name="Line 95">
              <a:extLst>
                <a:ext uri="{FF2B5EF4-FFF2-40B4-BE49-F238E27FC236}">
                  <a16:creationId xmlns:a16="http://schemas.microsoft.com/office/drawing/2014/main" id="{367CA829-D114-6B75-74BC-31DDD298B8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51" y="1369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8" name="Line 96">
              <a:extLst>
                <a:ext uri="{FF2B5EF4-FFF2-40B4-BE49-F238E27FC236}">
                  <a16:creationId xmlns:a16="http://schemas.microsoft.com/office/drawing/2014/main" id="{AB2B3DC0-9520-0514-54A7-5C0E5B168B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92" y="1572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99" name="Line 97">
              <a:extLst>
                <a:ext uri="{FF2B5EF4-FFF2-40B4-BE49-F238E27FC236}">
                  <a16:creationId xmlns:a16="http://schemas.microsoft.com/office/drawing/2014/main" id="{4EF0945C-7AB0-9C37-54E0-BEB3C87462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04" y="1560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00" name="Line 98">
              <a:extLst>
                <a:ext uri="{FF2B5EF4-FFF2-40B4-BE49-F238E27FC236}">
                  <a16:creationId xmlns:a16="http://schemas.microsoft.com/office/drawing/2014/main" id="{34FC1600-3811-35E5-3053-8F47CB34AC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" y="1828"/>
              <a:ext cx="68" cy="0"/>
            </a:xfrm>
            <a:prstGeom prst="line">
              <a:avLst/>
            </a:prstGeom>
            <a:ln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01" name="Freeform 99">
              <a:extLst>
                <a:ext uri="{FF2B5EF4-FFF2-40B4-BE49-F238E27FC236}">
                  <a16:creationId xmlns:a16="http://schemas.microsoft.com/office/drawing/2014/main" id="{5D558A7F-DFDE-202C-1CA2-D9911F22E17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07" y="1873"/>
              <a:ext cx="59" cy="0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dirty="0"/>
            </a:p>
          </p:txBody>
        </p:sp>
        <p:sp>
          <p:nvSpPr>
            <p:cNvPr id="102" name="Freeform 100">
              <a:extLst>
                <a:ext uri="{FF2B5EF4-FFF2-40B4-BE49-F238E27FC236}">
                  <a16:creationId xmlns:a16="http://schemas.microsoft.com/office/drawing/2014/main" id="{3763F24E-5795-981F-A0FA-50F583A7007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00" y="1918"/>
              <a:ext cx="66" cy="0"/>
            </a:xfrm>
            <a:custGeom>
              <a:avLst/>
              <a:gdLst>
                <a:gd name="T0" fmla="*/ 0 w 28"/>
                <a:gd name="T1" fmla="*/ 3 w 28"/>
                <a:gd name="T2" fmla="*/ 4 w 28"/>
                <a:gd name="T3" fmla="*/ 7 w 28"/>
                <a:gd name="T4" fmla="*/ 8 w 28"/>
                <a:gd name="T5" fmla="*/ 11 w 28"/>
                <a:gd name="T6" fmla="*/ 12 w 28"/>
                <a:gd name="T7" fmla="*/ 15 w 28"/>
                <a:gd name="T8" fmla="*/ 16 w 28"/>
                <a:gd name="T9" fmla="*/ 19 w 28"/>
                <a:gd name="T10" fmla="*/ 20 w 28"/>
                <a:gd name="T11" fmla="*/ 23 w 28"/>
                <a:gd name="T12" fmla="*/ 24 w 28"/>
                <a:gd name="T13" fmla="*/ 27 w 2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</a:cxnLst>
              <a:rect l="0" t="0" r="r" b="b"/>
              <a:pathLst>
                <a:path w="2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dirty="0"/>
            </a:p>
          </p:txBody>
        </p:sp>
        <p:sp>
          <p:nvSpPr>
            <p:cNvPr id="103" name="Freeform 101">
              <a:extLst>
                <a:ext uri="{FF2B5EF4-FFF2-40B4-BE49-F238E27FC236}">
                  <a16:creationId xmlns:a16="http://schemas.microsoft.com/office/drawing/2014/main" id="{87D046A4-44DB-0CBB-62D3-5E25DD5BD05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00" y="1962"/>
              <a:ext cx="66" cy="0"/>
            </a:xfrm>
            <a:custGeom>
              <a:avLst/>
              <a:gdLst>
                <a:gd name="T0" fmla="*/ 0 w 28"/>
                <a:gd name="T1" fmla="*/ 3 w 28"/>
                <a:gd name="T2" fmla="*/ 7 w 28"/>
                <a:gd name="T3" fmla="*/ 10 w 28"/>
                <a:gd name="T4" fmla="*/ 11 w 28"/>
                <a:gd name="T5" fmla="*/ 14 w 28"/>
                <a:gd name="T6" fmla="*/ 18 w 28"/>
                <a:gd name="T7" fmla="*/ 21 w 28"/>
                <a:gd name="T8" fmla="*/ 22 w 28"/>
                <a:gd name="T9" fmla="*/ 25 w 2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</a:cxnLst>
              <a:rect l="0" t="0" r="r" b="b"/>
              <a:pathLst>
                <a:path w="28">
                  <a:moveTo>
                    <a:pt x="3" y="0"/>
                  </a:moveTo>
                  <a:lnTo>
                    <a:pt x="7" y="0"/>
                  </a:lnTo>
                  <a:moveTo>
                    <a:pt x="10" y="0"/>
                  </a:moveTo>
                  <a:lnTo>
                    <a:pt x="11" y="0"/>
                  </a:lnTo>
                  <a:moveTo>
                    <a:pt x="14" y="0"/>
                  </a:moveTo>
                  <a:lnTo>
                    <a:pt x="18" y="0"/>
                  </a:lnTo>
                  <a:moveTo>
                    <a:pt x="21" y="0"/>
                  </a:moveTo>
                  <a:lnTo>
                    <a:pt x="22" y="0"/>
                  </a:lnTo>
                  <a:moveTo>
                    <a:pt x="25" y="0"/>
                  </a:move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dirty="0"/>
            </a:p>
          </p:txBody>
        </p:sp>
        <p:sp>
          <p:nvSpPr>
            <p:cNvPr id="104" name="Rectangle 102">
              <a:extLst>
                <a:ext uri="{FF2B5EF4-FFF2-40B4-BE49-F238E27FC236}">
                  <a16:creationId xmlns:a16="http://schemas.microsoft.com/office/drawing/2014/main" id="{7A23B1B5-A5A2-383B-78FD-68F031A7E1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" y="1711"/>
              <a:ext cx="18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Group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5" name="Rectangle 103">
              <a:extLst>
                <a:ext uri="{FF2B5EF4-FFF2-40B4-BE49-F238E27FC236}">
                  <a16:creationId xmlns:a16="http://schemas.microsoft.com/office/drawing/2014/main" id="{3E00F43D-4D1D-0486-A5A3-4DC0CA8B10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" y="1777"/>
              <a:ext cx="568" cy="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ontrol (</a:t>
              </a:r>
              <a:r>
                <a:rPr kumimoji="0" lang="en-US" altLang="en-US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=50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6" name="Rectangle 104">
              <a:extLst>
                <a:ext uri="{FF2B5EF4-FFF2-40B4-BE49-F238E27FC236}">
                  <a16:creationId xmlns:a16="http://schemas.microsoft.com/office/drawing/2014/main" id="{9C0BA57F-EF5E-012F-E1B2-56F376C9C3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" y="1829"/>
              <a:ext cx="555" cy="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GST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NFM (</a:t>
              </a:r>
              <a:r>
                <a:rPr kumimoji="0" lang="en-US" altLang="en-US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=69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7" name="Rectangle 105">
              <a:extLst>
                <a:ext uri="{FF2B5EF4-FFF2-40B4-BE49-F238E27FC236}">
                  <a16:creationId xmlns:a16="http://schemas.microsoft.com/office/drawing/2014/main" id="{36D440B7-D786-64D9-7297-79384C1E9B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1879"/>
              <a:ext cx="633" cy="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GST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PRM (</a:t>
              </a:r>
              <a:r>
                <a:rPr kumimoji="0" lang="en-US" altLang="en-US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=76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8" name="Rectangle 106">
              <a:extLst>
                <a:ext uri="{FF2B5EF4-FFF2-40B4-BE49-F238E27FC236}">
                  <a16:creationId xmlns:a16="http://schemas.microsoft.com/office/drawing/2014/main" id="{AB680A5A-C14B-310F-5247-30DA01E4D0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" y="1930"/>
              <a:ext cx="552" cy="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GST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FM (</a:t>
              </a:r>
              <a:r>
                <a:rPr kumimoji="0" lang="en-US" altLang="en-US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=58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grpSp>
        <p:nvGrpSpPr>
          <p:cNvPr id="111" name="Group 109">
            <a:extLst>
              <a:ext uri="{FF2B5EF4-FFF2-40B4-BE49-F238E27FC236}">
                <a16:creationId xmlns:a16="http://schemas.microsoft.com/office/drawing/2014/main" id="{2F522E40-74F9-90FA-C687-5683708AAD9E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51746" y="4377195"/>
            <a:ext cx="2745879" cy="2661282"/>
            <a:chOff x="184" y="1827"/>
            <a:chExt cx="1558" cy="1510"/>
          </a:xfrm>
        </p:grpSpPr>
        <p:sp>
          <p:nvSpPr>
            <p:cNvPr id="112" name="AutoShape 108">
              <a:extLst>
                <a:ext uri="{FF2B5EF4-FFF2-40B4-BE49-F238E27FC236}">
                  <a16:creationId xmlns:a16="http://schemas.microsoft.com/office/drawing/2014/main" id="{23C6995C-BC68-4535-6F66-B237AF6CEF2D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84" y="1827"/>
              <a:ext cx="1558" cy="1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Line 110">
              <a:extLst>
                <a:ext uri="{FF2B5EF4-FFF2-40B4-BE49-F238E27FC236}">
                  <a16:creationId xmlns:a16="http://schemas.microsoft.com/office/drawing/2014/main" id="{36684E85-F4AE-B127-0400-D715727572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3" y="3026"/>
              <a:ext cx="107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14" name="Line 111">
              <a:extLst>
                <a:ext uri="{FF2B5EF4-FFF2-40B4-BE49-F238E27FC236}">
                  <a16:creationId xmlns:a16="http://schemas.microsoft.com/office/drawing/2014/main" id="{F0A2F853-7FE6-6A03-B444-5FD4240F0A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3" y="3026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15" name="Line 112">
              <a:extLst>
                <a:ext uri="{FF2B5EF4-FFF2-40B4-BE49-F238E27FC236}">
                  <a16:creationId xmlns:a16="http://schemas.microsoft.com/office/drawing/2014/main" id="{0F1793FF-99E8-A9A1-4F25-D36BD406E8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6" y="3026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16" name="Line 113">
              <a:extLst>
                <a:ext uri="{FF2B5EF4-FFF2-40B4-BE49-F238E27FC236}">
                  <a16:creationId xmlns:a16="http://schemas.microsoft.com/office/drawing/2014/main" id="{AA74055A-465B-2824-5D0C-9C97224DBC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9" y="3026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17" name="Line 114">
              <a:extLst>
                <a:ext uri="{FF2B5EF4-FFF2-40B4-BE49-F238E27FC236}">
                  <a16:creationId xmlns:a16="http://schemas.microsoft.com/office/drawing/2014/main" id="{C1F9BA40-B60F-F127-F1B3-156114C513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44" y="3026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18" name="Line 115">
              <a:extLst>
                <a:ext uri="{FF2B5EF4-FFF2-40B4-BE49-F238E27FC236}">
                  <a16:creationId xmlns:a16="http://schemas.microsoft.com/office/drawing/2014/main" id="{D5D58A79-5B33-3A7A-90C8-7C03079A5A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7" y="3026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19" name="Line 116">
              <a:extLst>
                <a:ext uri="{FF2B5EF4-FFF2-40B4-BE49-F238E27FC236}">
                  <a16:creationId xmlns:a16="http://schemas.microsoft.com/office/drawing/2014/main" id="{7CD0F7B7-5262-9D21-9C2F-17FD9C75DA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0" y="3026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20" name="Line 117">
              <a:extLst>
                <a:ext uri="{FF2B5EF4-FFF2-40B4-BE49-F238E27FC236}">
                  <a16:creationId xmlns:a16="http://schemas.microsoft.com/office/drawing/2014/main" id="{D9648974-8F47-6382-1ED3-AA11CCABAE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06" y="3026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21" name="Line 118">
              <a:extLst>
                <a:ext uri="{FF2B5EF4-FFF2-40B4-BE49-F238E27FC236}">
                  <a16:creationId xmlns:a16="http://schemas.microsoft.com/office/drawing/2014/main" id="{E8FD5A58-55A5-F1B1-172E-5AC84F2E56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59" y="3026"/>
              <a:ext cx="0" cy="2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22" name="Rectangle 119">
              <a:extLst>
                <a:ext uri="{FF2B5EF4-FFF2-40B4-BE49-F238E27FC236}">
                  <a16:creationId xmlns:a16="http://schemas.microsoft.com/office/drawing/2014/main" id="{25B6DA0F-FF5D-45F5-D36B-3F0E44C2C7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" y="3075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23" name="Rectangle 120">
              <a:extLst>
                <a:ext uri="{FF2B5EF4-FFF2-40B4-BE49-F238E27FC236}">
                  <a16:creationId xmlns:a16="http://schemas.microsoft.com/office/drawing/2014/main" id="{ED05014B-8E13-551A-5BAC-02961D8A6B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" y="3075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24" name="Rectangle 121">
              <a:extLst>
                <a:ext uri="{FF2B5EF4-FFF2-40B4-BE49-F238E27FC236}">
                  <a16:creationId xmlns:a16="http://schemas.microsoft.com/office/drawing/2014/main" id="{FC113C3D-7AEC-A2DB-77C7-9BC6A155F8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9" y="3075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25" name="Rectangle 122">
              <a:extLst>
                <a:ext uri="{FF2B5EF4-FFF2-40B4-BE49-F238E27FC236}">
                  <a16:creationId xmlns:a16="http://schemas.microsoft.com/office/drawing/2014/main" id="{15689E16-43C3-BC3A-8DF3-E3B055B68A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4" y="3075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26" name="Rectangle 123">
              <a:extLst>
                <a:ext uri="{FF2B5EF4-FFF2-40B4-BE49-F238E27FC236}">
                  <a16:creationId xmlns:a16="http://schemas.microsoft.com/office/drawing/2014/main" id="{22677234-9286-1269-ECE4-63878DA836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7" y="3075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27" name="Rectangle 124">
              <a:extLst>
                <a:ext uri="{FF2B5EF4-FFF2-40B4-BE49-F238E27FC236}">
                  <a16:creationId xmlns:a16="http://schemas.microsoft.com/office/drawing/2014/main" id="{5BB7AC4B-E2C1-EB3E-EC7E-B8FBB280C4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" y="3075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28" name="Rectangle 125">
              <a:extLst>
                <a:ext uri="{FF2B5EF4-FFF2-40B4-BE49-F238E27FC236}">
                  <a16:creationId xmlns:a16="http://schemas.microsoft.com/office/drawing/2014/main" id="{B14B88C9-C7D3-D6E4-4E24-096CE549B2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6" y="3075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29" name="Rectangle 126">
              <a:extLst>
                <a:ext uri="{FF2B5EF4-FFF2-40B4-BE49-F238E27FC236}">
                  <a16:creationId xmlns:a16="http://schemas.microsoft.com/office/drawing/2014/main" id="{D3C9E514-713B-F224-7C7B-5A7C446B9F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9" y="3075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</a:t>
              </a:r>
              <a:endPara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30" name="Line 127">
              <a:extLst>
                <a:ext uri="{FF2B5EF4-FFF2-40B4-BE49-F238E27FC236}">
                  <a16:creationId xmlns:a16="http://schemas.microsoft.com/office/drawing/2014/main" id="{A982B205-B46F-1329-755D-ADFB55B7C1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9" y="2035"/>
              <a:ext cx="0" cy="95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31" name="Line 128">
              <a:extLst>
                <a:ext uri="{FF2B5EF4-FFF2-40B4-BE49-F238E27FC236}">
                  <a16:creationId xmlns:a16="http://schemas.microsoft.com/office/drawing/2014/main" id="{9B0A3304-C0B9-583E-AD34-C23EE4116D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" y="2986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32" name="Line 129">
              <a:extLst>
                <a:ext uri="{FF2B5EF4-FFF2-40B4-BE49-F238E27FC236}">
                  <a16:creationId xmlns:a16="http://schemas.microsoft.com/office/drawing/2014/main" id="{B03FD0E0-F4D8-81C5-34F2-02EC5C1497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" y="2798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33" name="Line 130">
              <a:extLst>
                <a:ext uri="{FF2B5EF4-FFF2-40B4-BE49-F238E27FC236}">
                  <a16:creationId xmlns:a16="http://schemas.microsoft.com/office/drawing/2014/main" id="{C12C66E7-04C6-341A-1DFF-BC30505227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" y="2607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34" name="Line 131">
              <a:extLst>
                <a:ext uri="{FF2B5EF4-FFF2-40B4-BE49-F238E27FC236}">
                  <a16:creationId xmlns:a16="http://schemas.microsoft.com/office/drawing/2014/main" id="{E801FEA0-DA52-6C7E-1A5D-C6A5AE3A6D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" y="2416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35" name="Line 132">
              <a:extLst>
                <a:ext uri="{FF2B5EF4-FFF2-40B4-BE49-F238E27FC236}">
                  <a16:creationId xmlns:a16="http://schemas.microsoft.com/office/drawing/2014/main" id="{47087E7D-AC52-9CC8-4803-9D75C5A322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" y="2226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36" name="Line 133">
              <a:extLst>
                <a:ext uri="{FF2B5EF4-FFF2-40B4-BE49-F238E27FC236}">
                  <a16:creationId xmlns:a16="http://schemas.microsoft.com/office/drawing/2014/main" id="{AB813B59-1B68-A8D3-A11E-1120296FE1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" y="2035"/>
              <a:ext cx="22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37" name="Rectangle 134">
              <a:extLst>
                <a:ext uri="{FF2B5EF4-FFF2-40B4-BE49-F238E27FC236}">
                  <a16:creationId xmlns:a16="http://schemas.microsoft.com/office/drawing/2014/main" id="{6B386B63-7932-3513-7465-1336A498D3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" y="2937"/>
              <a:ext cx="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38" name="Rectangle 135">
              <a:extLst>
                <a:ext uri="{FF2B5EF4-FFF2-40B4-BE49-F238E27FC236}">
                  <a16:creationId xmlns:a16="http://schemas.microsoft.com/office/drawing/2014/main" id="{C3C5BD27-DA16-5E77-AB12-D2D9E9F133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" y="2747"/>
              <a:ext cx="7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39" name="Rectangle 136">
              <a:extLst>
                <a:ext uri="{FF2B5EF4-FFF2-40B4-BE49-F238E27FC236}">
                  <a16:creationId xmlns:a16="http://schemas.microsoft.com/office/drawing/2014/main" id="{8D9425D2-70C9-4385-0540-06D9D12DC3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" y="2562"/>
              <a:ext cx="7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0" name="Rectangle 137">
              <a:extLst>
                <a:ext uri="{FF2B5EF4-FFF2-40B4-BE49-F238E27FC236}">
                  <a16:creationId xmlns:a16="http://schemas.microsoft.com/office/drawing/2014/main" id="{94C166C0-E266-BED9-9C14-7883692993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" y="2363"/>
              <a:ext cx="7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1" name="Rectangle 138">
              <a:extLst>
                <a:ext uri="{FF2B5EF4-FFF2-40B4-BE49-F238E27FC236}">
                  <a16:creationId xmlns:a16="http://schemas.microsoft.com/office/drawing/2014/main" id="{6BB8C31B-A1BC-2050-C5D5-22FFD4F684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" y="2176"/>
              <a:ext cx="7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2" name="Rectangle 139">
              <a:extLst>
                <a:ext uri="{FF2B5EF4-FFF2-40B4-BE49-F238E27FC236}">
                  <a16:creationId xmlns:a16="http://schemas.microsoft.com/office/drawing/2014/main" id="{8AD10E42-8EFD-E64C-ADA3-07893077FC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" y="1991"/>
              <a:ext cx="10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00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3" name="Freeform 140">
              <a:extLst>
                <a:ext uri="{FF2B5EF4-FFF2-40B4-BE49-F238E27FC236}">
                  <a16:creationId xmlns:a16="http://schemas.microsoft.com/office/drawing/2014/main" id="{75B64734-8967-3ED5-3FE2-37CC03932F42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" y="1998"/>
              <a:ext cx="1162" cy="1028"/>
            </a:xfrm>
            <a:custGeom>
              <a:avLst/>
              <a:gdLst>
                <a:gd name="T0" fmla="*/ 0 w 494"/>
                <a:gd name="T1" fmla="*/ 0 h 437"/>
                <a:gd name="T2" fmla="*/ 0 w 494"/>
                <a:gd name="T3" fmla="*/ 437 h 437"/>
                <a:gd name="T4" fmla="*/ 494 w 494"/>
                <a:gd name="T5" fmla="*/ 437 h 4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4" h="437">
                  <a:moveTo>
                    <a:pt x="0" y="0"/>
                  </a:moveTo>
                  <a:lnTo>
                    <a:pt x="0" y="437"/>
                  </a:lnTo>
                  <a:lnTo>
                    <a:pt x="494" y="437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44" name="Rectangle 141">
              <a:extLst>
                <a:ext uri="{FF2B5EF4-FFF2-40B4-BE49-F238E27FC236}">
                  <a16:creationId xmlns:a16="http://schemas.microsoft.com/office/drawing/2014/main" id="{89467723-A1B5-CAE4-B33A-F8EFB43EC9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4" y="3151"/>
              <a:ext cx="53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Days-post feeding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5" name="Rectangle 142">
              <a:extLst>
                <a:ext uri="{FF2B5EF4-FFF2-40B4-BE49-F238E27FC236}">
                  <a16:creationId xmlns:a16="http://schemas.microsoft.com/office/drawing/2014/main" id="{7A069F84-7EAE-2BD3-6F0F-D489514808F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28" y="2491"/>
              <a:ext cx="54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ortality rate (%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6" name="Freeform 143">
              <a:extLst>
                <a:ext uri="{FF2B5EF4-FFF2-40B4-BE49-F238E27FC236}">
                  <a16:creationId xmlns:a16="http://schemas.microsoft.com/office/drawing/2014/main" id="{6A54E70E-998C-C5AB-1281-AF85E5D7A5C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3" y="2035"/>
              <a:ext cx="1076" cy="118"/>
            </a:xfrm>
            <a:custGeom>
              <a:avLst/>
              <a:gdLst>
                <a:gd name="T0" fmla="*/ 0 w 457"/>
                <a:gd name="T1" fmla="*/ 0 h 50"/>
                <a:gd name="T2" fmla="*/ 65 w 457"/>
                <a:gd name="T3" fmla="*/ 0 h 50"/>
                <a:gd name="T4" fmla="*/ 65 w 457"/>
                <a:gd name="T5" fmla="*/ 1 h 50"/>
                <a:gd name="T6" fmla="*/ 130 w 457"/>
                <a:gd name="T7" fmla="*/ 1 h 50"/>
                <a:gd name="T8" fmla="*/ 130 w 457"/>
                <a:gd name="T9" fmla="*/ 2 h 50"/>
                <a:gd name="T10" fmla="*/ 196 w 457"/>
                <a:gd name="T11" fmla="*/ 2 h 50"/>
                <a:gd name="T12" fmla="*/ 196 w 457"/>
                <a:gd name="T13" fmla="*/ 2 h 50"/>
                <a:gd name="T14" fmla="*/ 261 w 457"/>
                <a:gd name="T15" fmla="*/ 2 h 50"/>
                <a:gd name="T16" fmla="*/ 261 w 457"/>
                <a:gd name="T17" fmla="*/ 4 h 50"/>
                <a:gd name="T18" fmla="*/ 326 w 457"/>
                <a:gd name="T19" fmla="*/ 4 h 50"/>
                <a:gd name="T20" fmla="*/ 326 w 457"/>
                <a:gd name="T21" fmla="*/ 7 h 50"/>
                <a:gd name="T22" fmla="*/ 392 w 457"/>
                <a:gd name="T23" fmla="*/ 7 h 50"/>
                <a:gd name="T24" fmla="*/ 392 w 457"/>
                <a:gd name="T25" fmla="*/ 19 h 50"/>
                <a:gd name="T26" fmla="*/ 457 w 457"/>
                <a:gd name="T27" fmla="*/ 19 h 50"/>
                <a:gd name="T28" fmla="*/ 457 w 457"/>
                <a:gd name="T29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57" h="50">
                  <a:moveTo>
                    <a:pt x="0" y="0"/>
                  </a:moveTo>
                  <a:lnTo>
                    <a:pt x="65" y="0"/>
                  </a:lnTo>
                  <a:lnTo>
                    <a:pt x="65" y="1"/>
                  </a:lnTo>
                  <a:lnTo>
                    <a:pt x="130" y="1"/>
                  </a:lnTo>
                  <a:lnTo>
                    <a:pt x="130" y="2"/>
                  </a:lnTo>
                  <a:lnTo>
                    <a:pt x="196" y="2"/>
                  </a:lnTo>
                  <a:lnTo>
                    <a:pt x="196" y="2"/>
                  </a:lnTo>
                  <a:lnTo>
                    <a:pt x="261" y="2"/>
                  </a:lnTo>
                  <a:lnTo>
                    <a:pt x="261" y="4"/>
                  </a:lnTo>
                  <a:lnTo>
                    <a:pt x="326" y="4"/>
                  </a:lnTo>
                  <a:lnTo>
                    <a:pt x="326" y="7"/>
                  </a:lnTo>
                  <a:lnTo>
                    <a:pt x="392" y="7"/>
                  </a:lnTo>
                  <a:lnTo>
                    <a:pt x="392" y="19"/>
                  </a:lnTo>
                  <a:lnTo>
                    <a:pt x="457" y="19"/>
                  </a:lnTo>
                  <a:lnTo>
                    <a:pt x="457" y="50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dirty="0"/>
            </a:p>
          </p:txBody>
        </p:sp>
        <p:sp>
          <p:nvSpPr>
            <p:cNvPr id="147" name="Line 144">
              <a:extLst>
                <a:ext uri="{FF2B5EF4-FFF2-40B4-BE49-F238E27FC236}">
                  <a16:creationId xmlns:a16="http://schemas.microsoft.com/office/drawing/2014/main" id="{076C47E4-383F-D98A-2AB4-79EB8277E7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4" y="2038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48" name="Line 145">
              <a:extLst>
                <a:ext uri="{FF2B5EF4-FFF2-40B4-BE49-F238E27FC236}">
                  <a16:creationId xmlns:a16="http://schemas.microsoft.com/office/drawing/2014/main" id="{48783955-BC20-A2C8-8E27-3C1003FFA8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6" y="2026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49" name="Line 146">
              <a:extLst>
                <a:ext uri="{FF2B5EF4-FFF2-40B4-BE49-F238E27FC236}">
                  <a16:creationId xmlns:a16="http://schemas.microsoft.com/office/drawing/2014/main" id="{9FAA38E4-FE36-B815-2FB8-FD55E5AC7E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7" y="2038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0" name="Line 147">
              <a:extLst>
                <a:ext uri="{FF2B5EF4-FFF2-40B4-BE49-F238E27FC236}">
                  <a16:creationId xmlns:a16="http://schemas.microsoft.com/office/drawing/2014/main" id="{4862EC60-4DA1-6967-324E-97EB970147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9" y="2026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1" name="Line 148">
              <a:extLst>
                <a:ext uri="{FF2B5EF4-FFF2-40B4-BE49-F238E27FC236}">
                  <a16:creationId xmlns:a16="http://schemas.microsoft.com/office/drawing/2014/main" id="{06526310-BA6F-7991-45C7-D7A38A3F74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0" y="2040"/>
              <a:ext cx="2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2" name="Line 149">
              <a:extLst>
                <a:ext uri="{FF2B5EF4-FFF2-40B4-BE49-F238E27FC236}">
                  <a16:creationId xmlns:a16="http://schemas.microsoft.com/office/drawing/2014/main" id="{A4525B76-0442-6F34-3576-3228FCE88C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44" y="2028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3" name="Line 150">
              <a:extLst>
                <a:ext uri="{FF2B5EF4-FFF2-40B4-BE49-F238E27FC236}">
                  <a16:creationId xmlns:a16="http://schemas.microsoft.com/office/drawing/2014/main" id="{D8F8B9FE-AB2D-D86E-A2D8-4E600AE0CD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86" y="2042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4" name="Line 151">
              <a:extLst>
                <a:ext uri="{FF2B5EF4-FFF2-40B4-BE49-F238E27FC236}">
                  <a16:creationId xmlns:a16="http://schemas.microsoft.com/office/drawing/2014/main" id="{AA8E36DE-5A00-EF55-F6A2-EA503BDB08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97" y="2031"/>
              <a:ext cx="0" cy="25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5" name="Line 152">
              <a:extLst>
                <a:ext uri="{FF2B5EF4-FFF2-40B4-BE49-F238E27FC236}">
                  <a16:creationId xmlns:a16="http://schemas.microsoft.com/office/drawing/2014/main" id="{B696A1BF-857E-4A66-97D5-309867220C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9" y="2049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6" name="Line 153">
              <a:extLst>
                <a:ext uri="{FF2B5EF4-FFF2-40B4-BE49-F238E27FC236}">
                  <a16:creationId xmlns:a16="http://schemas.microsoft.com/office/drawing/2014/main" id="{8F5B5F27-EA6E-2D73-3C45-20CF42C328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50" y="2038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7" name="Line 154">
              <a:extLst>
                <a:ext uri="{FF2B5EF4-FFF2-40B4-BE49-F238E27FC236}">
                  <a16:creationId xmlns:a16="http://schemas.microsoft.com/office/drawing/2014/main" id="{DDA9A5FA-7CBB-6FE9-AAD5-2422877928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92" y="2066"/>
              <a:ext cx="25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8" name="Line 155">
              <a:extLst>
                <a:ext uri="{FF2B5EF4-FFF2-40B4-BE49-F238E27FC236}">
                  <a16:creationId xmlns:a16="http://schemas.microsoft.com/office/drawing/2014/main" id="{3BFC5EC0-56F7-5C22-04C8-95BA8F65B6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06" y="2054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59" name="Line 156">
              <a:extLst>
                <a:ext uri="{FF2B5EF4-FFF2-40B4-BE49-F238E27FC236}">
                  <a16:creationId xmlns:a16="http://schemas.microsoft.com/office/drawing/2014/main" id="{07466FF1-6211-950E-F39B-530A97BCC6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47" y="2118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0" name="Line 157">
              <a:extLst>
                <a:ext uri="{FF2B5EF4-FFF2-40B4-BE49-F238E27FC236}">
                  <a16:creationId xmlns:a16="http://schemas.microsoft.com/office/drawing/2014/main" id="{681409C5-11AE-84A9-85C3-B6A1E63347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59" y="2106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1" name="Freeform 158">
              <a:extLst>
                <a:ext uri="{FF2B5EF4-FFF2-40B4-BE49-F238E27FC236}">
                  <a16:creationId xmlns:a16="http://schemas.microsoft.com/office/drawing/2014/main" id="{C18835B6-D193-7D8D-DB1A-C23FFD8D150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3" y="2035"/>
              <a:ext cx="1066" cy="323"/>
            </a:xfrm>
            <a:custGeom>
              <a:avLst/>
              <a:gdLst>
                <a:gd name="T0" fmla="*/ 8 w 453"/>
                <a:gd name="T1" fmla="*/ 0 h 137"/>
                <a:gd name="T2" fmla="*/ 20 w 453"/>
                <a:gd name="T3" fmla="*/ 0 h 137"/>
                <a:gd name="T4" fmla="*/ 32 w 453"/>
                <a:gd name="T5" fmla="*/ 0 h 137"/>
                <a:gd name="T6" fmla="*/ 44 w 453"/>
                <a:gd name="T7" fmla="*/ 0 h 137"/>
                <a:gd name="T8" fmla="*/ 56 w 453"/>
                <a:gd name="T9" fmla="*/ 0 h 137"/>
                <a:gd name="T10" fmla="*/ 61 w 453"/>
                <a:gd name="T11" fmla="*/ 3 h 137"/>
                <a:gd name="T12" fmla="*/ 69 w 453"/>
                <a:gd name="T13" fmla="*/ 3 h 137"/>
                <a:gd name="T14" fmla="*/ 81 w 453"/>
                <a:gd name="T15" fmla="*/ 3 h 137"/>
                <a:gd name="T16" fmla="*/ 93 w 453"/>
                <a:gd name="T17" fmla="*/ 3 h 137"/>
                <a:gd name="T18" fmla="*/ 105 w 453"/>
                <a:gd name="T19" fmla="*/ 3 h 137"/>
                <a:gd name="T20" fmla="*/ 117 w 453"/>
                <a:gd name="T21" fmla="*/ 3 h 137"/>
                <a:gd name="T22" fmla="*/ 126 w 453"/>
                <a:gd name="T23" fmla="*/ 6 h 137"/>
                <a:gd name="T24" fmla="*/ 133 w 453"/>
                <a:gd name="T25" fmla="*/ 7 h 137"/>
                <a:gd name="T26" fmla="*/ 145 w 453"/>
                <a:gd name="T27" fmla="*/ 7 h 137"/>
                <a:gd name="T28" fmla="*/ 157 w 453"/>
                <a:gd name="T29" fmla="*/ 7 h 137"/>
                <a:gd name="T30" fmla="*/ 169 w 453"/>
                <a:gd name="T31" fmla="*/ 7 h 137"/>
                <a:gd name="T32" fmla="*/ 181 w 453"/>
                <a:gd name="T33" fmla="*/ 7 h 137"/>
                <a:gd name="T34" fmla="*/ 192 w 453"/>
                <a:gd name="T35" fmla="*/ 7 h 137"/>
                <a:gd name="T36" fmla="*/ 197 w 453"/>
                <a:gd name="T37" fmla="*/ 11 h 137"/>
                <a:gd name="T38" fmla="*/ 209 w 453"/>
                <a:gd name="T39" fmla="*/ 11 h 137"/>
                <a:gd name="T40" fmla="*/ 221 w 453"/>
                <a:gd name="T41" fmla="*/ 11 h 137"/>
                <a:gd name="T42" fmla="*/ 233 w 453"/>
                <a:gd name="T43" fmla="*/ 11 h 137"/>
                <a:gd name="T44" fmla="*/ 245 w 453"/>
                <a:gd name="T45" fmla="*/ 11 h 137"/>
                <a:gd name="T46" fmla="*/ 257 w 453"/>
                <a:gd name="T47" fmla="*/ 11 h 137"/>
                <a:gd name="T48" fmla="*/ 261 w 453"/>
                <a:gd name="T49" fmla="*/ 19 h 137"/>
                <a:gd name="T50" fmla="*/ 273 w 453"/>
                <a:gd name="T51" fmla="*/ 19 h 137"/>
                <a:gd name="T52" fmla="*/ 285 w 453"/>
                <a:gd name="T53" fmla="*/ 19 h 137"/>
                <a:gd name="T54" fmla="*/ 297 w 453"/>
                <a:gd name="T55" fmla="*/ 19 h 137"/>
                <a:gd name="T56" fmla="*/ 309 w 453"/>
                <a:gd name="T57" fmla="*/ 19 h 137"/>
                <a:gd name="T58" fmla="*/ 321 w 453"/>
                <a:gd name="T59" fmla="*/ 19 h 137"/>
                <a:gd name="T60" fmla="*/ 322 w 453"/>
                <a:gd name="T61" fmla="*/ 26 h 137"/>
                <a:gd name="T62" fmla="*/ 322 w 453"/>
                <a:gd name="T63" fmla="*/ 36 h 137"/>
                <a:gd name="T64" fmla="*/ 332 w 453"/>
                <a:gd name="T65" fmla="*/ 36 h 137"/>
                <a:gd name="T66" fmla="*/ 344 w 453"/>
                <a:gd name="T67" fmla="*/ 36 h 137"/>
                <a:gd name="T68" fmla="*/ 356 w 453"/>
                <a:gd name="T69" fmla="*/ 36 h 137"/>
                <a:gd name="T70" fmla="*/ 368 w 453"/>
                <a:gd name="T71" fmla="*/ 36 h 137"/>
                <a:gd name="T72" fmla="*/ 380 w 453"/>
                <a:gd name="T73" fmla="*/ 36 h 137"/>
                <a:gd name="T74" fmla="*/ 388 w 453"/>
                <a:gd name="T75" fmla="*/ 36 h 137"/>
                <a:gd name="T76" fmla="*/ 388 w 453"/>
                <a:gd name="T77" fmla="*/ 48 h 137"/>
                <a:gd name="T78" fmla="*/ 388 w 453"/>
                <a:gd name="T79" fmla="*/ 60 h 137"/>
                <a:gd name="T80" fmla="*/ 396 w 453"/>
                <a:gd name="T81" fmla="*/ 64 h 137"/>
                <a:gd name="T82" fmla="*/ 408 w 453"/>
                <a:gd name="T83" fmla="*/ 64 h 137"/>
                <a:gd name="T84" fmla="*/ 420 w 453"/>
                <a:gd name="T85" fmla="*/ 64 h 137"/>
                <a:gd name="T86" fmla="*/ 432 w 453"/>
                <a:gd name="T87" fmla="*/ 64 h 137"/>
                <a:gd name="T88" fmla="*/ 444 w 453"/>
                <a:gd name="T89" fmla="*/ 64 h 137"/>
                <a:gd name="T90" fmla="*/ 453 w 453"/>
                <a:gd name="T91" fmla="*/ 64 h 137"/>
                <a:gd name="T92" fmla="*/ 453 w 453"/>
                <a:gd name="T93" fmla="*/ 75 h 137"/>
                <a:gd name="T94" fmla="*/ 453 w 453"/>
                <a:gd name="T95" fmla="*/ 87 h 137"/>
                <a:gd name="T96" fmla="*/ 453 w 453"/>
                <a:gd name="T97" fmla="*/ 99 h 137"/>
                <a:gd name="T98" fmla="*/ 453 w 453"/>
                <a:gd name="T99" fmla="*/ 111 h 137"/>
                <a:gd name="T100" fmla="*/ 453 w 453"/>
                <a:gd name="T101" fmla="*/ 123 h 137"/>
                <a:gd name="T102" fmla="*/ 453 w 453"/>
                <a:gd name="T103" fmla="*/ 135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453" h="137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1" y="0"/>
                  </a:lnTo>
                  <a:lnTo>
                    <a:pt x="61" y="3"/>
                  </a:lnTo>
                  <a:lnTo>
                    <a:pt x="61" y="3"/>
                  </a:lnTo>
                  <a:moveTo>
                    <a:pt x="65" y="3"/>
                  </a:moveTo>
                  <a:lnTo>
                    <a:pt x="69" y="3"/>
                  </a:lnTo>
                  <a:moveTo>
                    <a:pt x="73" y="3"/>
                  </a:moveTo>
                  <a:lnTo>
                    <a:pt x="77" y="3"/>
                  </a:lnTo>
                  <a:moveTo>
                    <a:pt x="81" y="3"/>
                  </a:moveTo>
                  <a:lnTo>
                    <a:pt x="85" y="3"/>
                  </a:lnTo>
                  <a:moveTo>
                    <a:pt x="89" y="3"/>
                  </a:moveTo>
                  <a:lnTo>
                    <a:pt x="93" y="3"/>
                  </a:lnTo>
                  <a:moveTo>
                    <a:pt x="97" y="3"/>
                  </a:moveTo>
                  <a:lnTo>
                    <a:pt x="101" y="3"/>
                  </a:lnTo>
                  <a:moveTo>
                    <a:pt x="105" y="3"/>
                  </a:moveTo>
                  <a:lnTo>
                    <a:pt x="109" y="3"/>
                  </a:lnTo>
                  <a:moveTo>
                    <a:pt x="113" y="3"/>
                  </a:moveTo>
                  <a:lnTo>
                    <a:pt x="117" y="3"/>
                  </a:lnTo>
                  <a:moveTo>
                    <a:pt x="121" y="3"/>
                  </a:moveTo>
                  <a:lnTo>
                    <a:pt x="125" y="3"/>
                  </a:lnTo>
                  <a:moveTo>
                    <a:pt x="126" y="6"/>
                  </a:moveTo>
                  <a:lnTo>
                    <a:pt x="126" y="7"/>
                  </a:lnTo>
                  <a:lnTo>
                    <a:pt x="129" y="7"/>
                  </a:lnTo>
                  <a:moveTo>
                    <a:pt x="133" y="7"/>
                  </a:moveTo>
                  <a:lnTo>
                    <a:pt x="137" y="7"/>
                  </a:lnTo>
                  <a:moveTo>
                    <a:pt x="141" y="7"/>
                  </a:moveTo>
                  <a:lnTo>
                    <a:pt x="145" y="7"/>
                  </a:lnTo>
                  <a:moveTo>
                    <a:pt x="149" y="7"/>
                  </a:moveTo>
                  <a:lnTo>
                    <a:pt x="153" y="7"/>
                  </a:lnTo>
                  <a:moveTo>
                    <a:pt x="157" y="7"/>
                  </a:moveTo>
                  <a:lnTo>
                    <a:pt x="161" y="7"/>
                  </a:lnTo>
                  <a:moveTo>
                    <a:pt x="165" y="7"/>
                  </a:moveTo>
                  <a:lnTo>
                    <a:pt x="169" y="7"/>
                  </a:lnTo>
                  <a:moveTo>
                    <a:pt x="173" y="7"/>
                  </a:moveTo>
                  <a:lnTo>
                    <a:pt x="177" y="7"/>
                  </a:lnTo>
                  <a:moveTo>
                    <a:pt x="181" y="7"/>
                  </a:moveTo>
                  <a:lnTo>
                    <a:pt x="185" y="7"/>
                  </a:lnTo>
                  <a:moveTo>
                    <a:pt x="189" y="7"/>
                  </a:moveTo>
                  <a:lnTo>
                    <a:pt x="192" y="7"/>
                  </a:lnTo>
                  <a:lnTo>
                    <a:pt x="192" y="8"/>
                  </a:lnTo>
                  <a:moveTo>
                    <a:pt x="193" y="11"/>
                  </a:moveTo>
                  <a:lnTo>
                    <a:pt x="197" y="11"/>
                  </a:lnTo>
                  <a:moveTo>
                    <a:pt x="201" y="11"/>
                  </a:moveTo>
                  <a:lnTo>
                    <a:pt x="205" y="11"/>
                  </a:lnTo>
                  <a:moveTo>
                    <a:pt x="209" y="11"/>
                  </a:moveTo>
                  <a:lnTo>
                    <a:pt x="213" y="11"/>
                  </a:lnTo>
                  <a:moveTo>
                    <a:pt x="217" y="11"/>
                  </a:moveTo>
                  <a:lnTo>
                    <a:pt x="221" y="11"/>
                  </a:lnTo>
                  <a:moveTo>
                    <a:pt x="225" y="11"/>
                  </a:moveTo>
                  <a:lnTo>
                    <a:pt x="229" y="11"/>
                  </a:lnTo>
                  <a:moveTo>
                    <a:pt x="233" y="11"/>
                  </a:moveTo>
                  <a:lnTo>
                    <a:pt x="237" y="11"/>
                  </a:lnTo>
                  <a:moveTo>
                    <a:pt x="241" y="11"/>
                  </a:moveTo>
                  <a:lnTo>
                    <a:pt x="245" y="11"/>
                  </a:lnTo>
                  <a:moveTo>
                    <a:pt x="249" y="11"/>
                  </a:moveTo>
                  <a:lnTo>
                    <a:pt x="253" y="11"/>
                  </a:lnTo>
                  <a:moveTo>
                    <a:pt x="257" y="11"/>
                  </a:moveTo>
                  <a:lnTo>
                    <a:pt x="257" y="15"/>
                  </a:lnTo>
                  <a:moveTo>
                    <a:pt x="257" y="19"/>
                  </a:moveTo>
                  <a:lnTo>
                    <a:pt x="261" y="19"/>
                  </a:lnTo>
                  <a:moveTo>
                    <a:pt x="265" y="19"/>
                  </a:moveTo>
                  <a:lnTo>
                    <a:pt x="269" y="19"/>
                  </a:lnTo>
                  <a:moveTo>
                    <a:pt x="273" y="19"/>
                  </a:moveTo>
                  <a:lnTo>
                    <a:pt x="277" y="19"/>
                  </a:lnTo>
                  <a:moveTo>
                    <a:pt x="281" y="19"/>
                  </a:moveTo>
                  <a:lnTo>
                    <a:pt x="285" y="19"/>
                  </a:lnTo>
                  <a:moveTo>
                    <a:pt x="289" y="19"/>
                  </a:moveTo>
                  <a:lnTo>
                    <a:pt x="293" y="19"/>
                  </a:lnTo>
                  <a:moveTo>
                    <a:pt x="297" y="19"/>
                  </a:moveTo>
                  <a:lnTo>
                    <a:pt x="301" y="19"/>
                  </a:lnTo>
                  <a:moveTo>
                    <a:pt x="305" y="19"/>
                  </a:moveTo>
                  <a:lnTo>
                    <a:pt x="309" y="19"/>
                  </a:lnTo>
                  <a:moveTo>
                    <a:pt x="313" y="19"/>
                  </a:moveTo>
                  <a:lnTo>
                    <a:pt x="317" y="19"/>
                  </a:lnTo>
                  <a:moveTo>
                    <a:pt x="321" y="19"/>
                  </a:moveTo>
                  <a:lnTo>
                    <a:pt x="322" y="19"/>
                  </a:lnTo>
                  <a:lnTo>
                    <a:pt x="322" y="22"/>
                  </a:lnTo>
                  <a:moveTo>
                    <a:pt x="322" y="26"/>
                  </a:moveTo>
                  <a:lnTo>
                    <a:pt x="322" y="30"/>
                  </a:lnTo>
                  <a:moveTo>
                    <a:pt x="322" y="34"/>
                  </a:moveTo>
                  <a:lnTo>
                    <a:pt x="322" y="36"/>
                  </a:lnTo>
                  <a:lnTo>
                    <a:pt x="324" y="36"/>
                  </a:lnTo>
                  <a:moveTo>
                    <a:pt x="328" y="36"/>
                  </a:moveTo>
                  <a:lnTo>
                    <a:pt x="332" y="36"/>
                  </a:lnTo>
                  <a:moveTo>
                    <a:pt x="336" y="36"/>
                  </a:moveTo>
                  <a:lnTo>
                    <a:pt x="340" y="36"/>
                  </a:lnTo>
                  <a:moveTo>
                    <a:pt x="344" y="36"/>
                  </a:moveTo>
                  <a:lnTo>
                    <a:pt x="348" y="36"/>
                  </a:lnTo>
                  <a:moveTo>
                    <a:pt x="352" y="36"/>
                  </a:moveTo>
                  <a:lnTo>
                    <a:pt x="356" y="36"/>
                  </a:lnTo>
                  <a:moveTo>
                    <a:pt x="360" y="36"/>
                  </a:moveTo>
                  <a:lnTo>
                    <a:pt x="364" y="36"/>
                  </a:lnTo>
                  <a:moveTo>
                    <a:pt x="368" y="36"/>
                  </a:moveTo>
                  <a:lnTo>
                    <a:pt x="372" y="36"/>
                  </a:lnTo>
                  <a:moveTo>
                    <a:pt x="376" y="36"/>
                  </a:moveTo>
                  <a:lnTo>
                    <a:pt x="380" y="36"/>
                  </a:lnTo>
                  <a:moveTo>
                    <a:pt x="384" y="36"/>
                  </a:moveTo>
                  <a:lnTo>
                    <a:pt x="388" y="36"/>
                  </a:lnTo>
                  <a:lnTo>
                    <a:pt x="388" y="36"/>
                  </a:lnTo>
                  <a:moveTo>
                    <a:pt x="388" y="40"/>
                  </a:moveTo>
                  <a:lnTo>
                    <a:pt x="388" y="44"/>
                  </a:lnTo>
                  <a:moveTo>
                    <a:pt x="388" y="48"/>
                  </a:moveTo>
                  <a:lnTo>
                    <a:pt x="388" y="52"/>
                  </a:lnTo>
                  <a:moveTo>
                    <a:pt x="388" y="56"/>
                  </a:moveTo>
                  <a:lnTo>
                    <a:pt x="388" y="60"/>
                  </a:lnTo>
                  <a:moveTo>
                    <a:pt x="388" y="64"/>
                  </a:moveTo>
                  <a:lnTo>
                    <a:pt x="392" y="64"/>
                  </a:lnTo>
                  <a:moveTo>
                    <a:pt x="396" y="64"/>
                  </a:moveTo>
                  <a:lnTo>
                    <a:pt x="400" y="64"/>
                  </a:lnTo>
                  <a:moveTo>
                    <a:pt x="404" y="64"/>
                  </a:moveTo>
                  <a:lnTo>
                    <a:pt x="408" y="64"/>
                  </a:lnTo>
                  <a:moveTo>
                    <a:pt x="412" y="64"/>
                  </a:moveTo>
                  <a:lnTo>
                    <a:pt x="416" y="64"/>
                  </a:lnTo>
                  <a:moveTo>
                    <a:pt x="420" y="64"/>
                  </a:moveTo>
                  <a:lnTo>
                    <a:pt x="424" y="64"/>
                  </a:lnTo>
                  <a:moveTo>
                    <a:pt x="428" y="64"/>
                  </a:moveTo>
                  <a:lnTo>
                    <a:pt x="432" y="64"/>
                  </a:lnTo>
                  <a:moveTo>
                    <a:pt x="436" y="64"/>
                  </a:moveTo>
                  <a:lnTo>
                    <a:pt x="440" y="64"/>
                  </a:lnTo>
                  <a:moveTo>
                    <a:pt x="444" y="64"/>
                  </a:moveTo>
                  <a:lnTo>
                    <a:pt x="448" y="64"/>
                  </a:lnTo>
                  <a:moveTo>
                    <a:pt x="452" y="64"/>
                  </a:moveTo>
                  <a:lnTo>
                    <a:pt x="453" y="64"/>
                  </a:lnTo>
                  <a:lnTo>
                    <a:pt x="453" y="67"/>
                  </a:lnTo>
                  <a:moveTo>
                    <a:pt x="453" y="71"/>
                  </a:moveTo>
                  <a:lnTo>
                    <a:pt x="453" y="75"/>
                  </a:lnTo>
                  <a:moveTo>
                    <a:pt x="453" y="79"/>
                  </a:moveTo>
                  <a:lnTo>
                    <a:pt x="453" y="83"/>
                  </a:lnTo>
                  <a:moveTo>
                    <a:pt x="453" y="87"/>
                  </a:moveTo>
                  <a:lnTo>
                    <a:pt x="453" y="91"/>
                  </a:lnTo>
                  <a:moveTo>
                    <a:pt x="453" y="95"/>
                  </a:moveTo>
                  <a:lnTo>
                    <a:pt x="453" y="99"/>
                  </a:lnTo>
                  <a:moveTo>
                    <a:pt x="453" y="103"/>
                  </a:moveTo>
                  <a:lnTo>
                    <a:pt x="453" y="107"/>
                  </a:lnTo>
                  <a:moveTo>
                    <a:pt x="453" y="111"/>
                  </a:moveTo>
                  <a:lnTo>
                    <a:pt x="453" y="115"/>
                  </a:lnTo>
                  <a:moveTo>
                    <a:pt x="453" y="119"/>
                  </a:moveTo>
                  <a:lnTo>
                    <a:pt x="453" y="123"/>
                  </a:lnTo>
                  <a:moveTo>
                    <a:pt x="453" y="127"/>
                  </a:moveTo>
                  <a:lnTo>
                    <a:pt x="453" y="131"/>
                  </a:lnTo>
                  <a:moveTo>
                    <a:pt x="453" y="135"/>
                  </a:move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2" name="Line 159">
              <a:extLst>
                <a:ext uri="{FF2B5EF4-FFF2-40B4-BE49-F238E27FC236}">
                  <a16:creationId xmlns:a16="http://schemas.microsoft.com/office/drawing/2014/main" id="{D5F2C177-CB8A-78E9-3E92-D038E5FC59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4" y="2040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3" name="Line 160">
              <a:extLst>
                <a:ext uri="{FF2B5EF4-FFF2-40B4-BE49-F238E27FC236}">
                  <a16:creationId xmlns:a16="http://schemas.microsoft.com/office/drawing/2014/main" id="{8DB9FBA5-0DED-33BD-E214-AB37D58B33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6" y="2028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4" name="Line 161">
              <a:extLst>
                <a:ext uri="{FF2B5EF4-FFF2-40B4-BE49-F238E27FC236}">
                  <a16:creationId xmlns:a16="http://schemas.microsoft.com/office/drawing/2014/main" id="{F46F66CB-AE88-0E32-1B20-58264943BE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7" y="2047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5" name="Line 162">
              <a:extLst>
                <a:ext uri="{FF2B5EF4-FFF2-40B4-BE49-F238E27FC236}">
                  <a16:creationId xmlns:a16="http://schemas.microsoft.com/office/drawing/2014/main" id="{8D6CF34F-7C90-8701-E635-CE1271ED55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9" y="2035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6" name="Line 163">
              <a:extLst>
                <a:ext uri="{FF2B5EF4-FFF2-40B4-BE49-F238E27FC236}">
                  <a16:creationId xmlns:a16="http://schemas.microsoft.com/office/drawing/2014/main" id="{510AACB7-E701-B8CE-8D56-89866D76A2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0" y="2056"/>
              <a:ext cx="2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7" name="Line 164">
              <a:extLst>
                <a:ext uri="{FF2B5EF4-FFF2-40B4-BE49-F238E27FC236}">
                  <a16:creationId xmlns:a16="http://schemas.microsoft.com/office/drawing/2014/main" id="{0C39F99C-060E-7C83-5ED9-9DAD7471E1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44" y="2045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8" name="Line 165">
              <a:extLst>
                <a:ext uri="{FF2B5EF4-FFF2-40B4-BE49-F238E27FC236}">
                  <a16:creationId xmlns:a16="http://schemas.microsoft.com/office/drawing/2014/main" id="{14153801-0800-78B1-CAD3-8B4E31160C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86" y="2071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69" name="Line 166">
              <a:extLst>
                <a:ext uri="{FF2B5EF4-FFF2-40B4-BE49-F238E27FC236}">
                  <a16:creationId xmlns:a16="http://schemas.microsoft.com/office/drawing/2014/main" id="{ED38EF64-2A7C-4686-31B5-03E9940D56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97" y="2059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0" name="Line 167">
              <a:extLst>
                <a:ext uri="{FF2B5EF4-FFF2-40B4-BE49-F238E27FC236}">
                  <a16:creationId xmlns:a16="http://schemas.microsoft.com/office/drawing/2014/main" id="{35BFB519-A4FC-6B3E-AB21-9986CBBE19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9" y="2101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1" name="Line 168">
              <a:extLst>
                <a:ext uri="{FF2B5EF4-FFF2-40B4-BE49-F238E27FC236}">
                  <a16:creationId xmlns:a16="http://schemas.microsoft.com/office/drawing/2014/main" id="{F00AC3B3-88A5-F693-CD2B-9081B240BF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50" y="2087"/>
              <a:ext cx="0" cy="26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2" name="Line 169">
              <a:extLst>
                <a:ext uri="{FF2B5EF4-FFF2-40B4-BE49-F238E27FC236}">
                  <a16:creationId xmlns:a16="http://schemas.microsoft.com/office/drawing/2014/main" id="{8078EFEE-04FA-9E7F-8ADF-186CBC82F2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92" y="2153"/>
              <a:ext cx="25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3" name="Line 170">
              <a:extLst>
                <a:ext uri="{FF2B5EF4-FFF2-40B4-BE49-F238E27FC236}">
                  <a16:creationId xmlns:a16="http://schemas.microsoft.com/office/drawing/2014/main" id="{3D3376B4-6E3E-D09A-AC8D-D67995A9E9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06" y="2141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4" name="Line 171">
              <a:extLst>
                <a:ext uri="{FF2B5EF4-FFF2-40B4-BE49-F238E27FC236}">
                  <a16:creationId xmlns:a16="http://schemas.microsoft.com/office/drawing/2014/main" id="{EC2856E1-A719-C80F-98E7-D38DBA2A13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47" y="2271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5" name="Line 172">
              <a:extLst>
                <a:ext uri="{FF2B5EF4-FFF2-40B4-BE49-F238E27FC236}">
                  <a16:creationId xmlns:a16="http://schemas.microsoft.com/office/drawing/2014/main" id="{1CCCCCFE-B0B5-7B34-452A-D1435375A3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59" y="2259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6" name="Freeform 173">
              <a:extLst>
                <a:ext uri="{FF2B5EF4-FFF2-40B4-BE49-F238E27FC236}">
                  <a16:creationId xmlns:a16="http://schemas.microsoft.com/office/drawing/2014/main" id="{9C628072-5AB2-A56C-4147-A3776019845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6" y="2035"/>
              <a:ext cx="1073" cy="393"/>
            </a:xfrm>
            <a:custGeom>
              <a:avLst/>
              <a:gdLst>
                <a:gd name="T0" fmla="*/ 8 w 456"/>
                <a:gd name="T1" fmla="*/ 0 h 167"/>
                <a:gd name="T2" fmla="*/ 19 w 456"/>
                <a:gd name="T3" fmla="*/ 0 h 167"/>
                <a:gd name="T4" fmla="*/ 28 w 456"/>
                <a:gd name="T5" fmla="*/ 0 h 167"/>
                <a:gd name="T6" fmla="*/ 39 w 456"/>
                <a:gd name="T7" fmla="*/ 0 h 167"/>
                <a:gd name="T8" fmla="*/ 48 w 456"/>
                <a:gd name="T9" fmla="*/ 0 h 167"/>
                <a:gd name="T10" fmla="*/ 59 w 456"/>
                <a:gd name="T11" fmla="*/ 0 h 167"/>
                <a:gd name="T12" fmla="*/ 64 w 456"/>
                <a:gd name="T13" fmla="*/ 3 h 167"/>
                <a:gd name="T14" fmla="*/ 73 w 456"/>
                <a:gd name="T15" fmla="*/ 3 h 167"/>
                <a:gd name="T16" fmla="*/ 84 w 456"/>
                <a:gd name="T17" fmla="*/ 3 h 167"/>
                <a:gd name="T18" fmla="*/ 93 w 456"/>
                <a:gd name="T19" fmla="*/ 3 h 167"/>
                <a:gd name="T20" fmla="*/ 104 w 456"/>
                <a:gd name="T21" fmla="*/ 3 h 167"/>
                <a:gd name="T22" fmla="*/ 113 w 456"/>
                <a:gd name="T23" fmla="*/ 3 h 167"/>
                <a:gd name="T24" fmla="*/ 124 w 456"/>
                <a:gd name="T25" fmla="*/ 3 h 167"/>
                <a:gd name="T26" fmla="*/ 129 w 456"/>
                <a:gd name="T27" fmla="*/ 6 h 167"/>
                <a:gd name="T28" fmla="*/ 136 w 456"/>
                <a:gd name="T29" fmla="*/ 7 h 167"/>
                <a:gd name="T30" fmla="*/ 145 w 456"/>
                <a:gd name="T31" fmla="*/ 7 h 167"/>
                <a:gd name="T32" fmla="*/ 156 w 456"/>
                <a:gd name="T33" fmla="*/ 7 h 167"/>
                <a:gd name="T34" fmla="*/ 165 w 456"/>
                <a:gd name="T35" fmla="*/ 7 h 167"/>
                <a:gd name="T36" fmla="*/ 176 w 456"/>
                <a:gd name="T37" fmla="*/ 7 h 167"/>
                <a:gd name="T38" fmla="*/ 185 w 456"/>
                <a:gd name="T39" fmla="*/ 7 h 167"/>
                <a:gd name="T40" fmla="*/ 195 w 456"/>
                <a:gd name="T41" fmla="*/ 8 h 167"/>
                <a:gd name="T42" fmla="*/ 200 w 456"/>
                <a:gd name="T43" fmla="*/ 12 h 167"/>
                <a:gd name="T44" fmla="*/ 211 w 456"/>
                <a:gd name="T45" fmla="*/ 12 h 167"/>
                <a:gd name="T46" fmla="*/ 220 w 456"/>
                <a:gd name="T47" fmla="*/ 12 h 167"/>
                <a:gd name="T48" fmla="*/ 231 w 456"/>
                <a:gd name="T49" fmla="*/ 12 h 167"/>
                <a:gd name="T50" fmla="*/ 240 w 456"/>
                <a:gd name="T51" fmla="*/ 12 h 167"/>
                <a:gd name="T52" fmla="*/ 251 w 456"/>
                <a:gd name="T53" fmla="*/ 12 h 167"/>
                <a:gd name="T54" fmla="*/ 260 w 456"/>
                <a:gd name="T55" fmla="*/ 12 h 167"/>
                <a:gd name="T56" fmla="*/ 260 w 456"/>
                <a:gd name="T57" fmla="*/ 20 h 167"/>
                <a:gd name="T58" fmla="*/ 269 w 456"/>
                <a:gd name="T59" fmla="*/ 22 h 167"/>
                <a:gd name="T60" fmla="*/ 278 w 456"/>
                <a:gd name="T61" fmla="*/ 22 h 167"/>
                <a:gd name="T62" fmla="*/ 289 w 456"/>
                <a:gd name="T63" fmla="*/ 22 h 167"/>
                <a:gd name="T64" fmla="*/ 298 w 456"/>
                <a:gd name="T65" fmla="*/ 22 h 167"/>
                <a:gd name="T66" fmla="*/ 309 w 456"/>
                <a:gd name="T67" fmla="*/ 22 h 167"/>
                <a:gd name="T68" fmla="*/ 318 w 456"/>
                <a:gd name="T69" fmla="*/ 22 h 167"/>
                <a:gd name="T70" fmla="*/ 325 w 456"/>
                <a:gd name="T71" fmla="*/ 26 h 167"/>
                <a:gd name="T72" fmla="*/ 325 w 456"/>
                <a:gd name="T73" fmla="*/ 35 h 167"/>
                <a:gd name="T74" fmla="*/ 334 w 456"/>
                <a:gd name="T75" fmla="*/ 37 h 167"/>
                <a:gd name="T76" fmla="*/ 343 w 456"/>
                <a:gd name="T77" fmla="*/ 37 h 167"/>
                <a:gd name="T78" fmla="*/ 354 w 456"/>
                <a:gd name="T79" fmla="*/ 37 h 167"/>
                <a:gd name="T80" fmla="*/ 363 w 456"/>
                <a:gd name="T81" fmla="*/ 37 h 167"/>
                <a:gd name="T82" fmla="*/ 374 w 456"/>
                <a:gd name="T83" fmla="*/ 37 h 167"/>
                <a:gd name="T84" fmla="*/ 383 w 456"/>
                <a:gd name="T85" fmla="*/ 37 h 167"/>
                <a:gd name="T86" fmla="*/ 391 w 456"/>
                <a:gd name="T87" fmla="*/ 37 h 167"/>
                <a:gd name="T88" fmla="*/ 391 w 456"/>
                <a:gd name="T89" fmla="*/ 48 h 167"/>
                <a:gd name="T90" fmla="*/ 391 w 456"/>
                <a:gd name="T91" fmla="*/ 57 h 167"/>
                <a:gd name="T92" fmla="*/ 391 w 456"/>
                <a:gd name="T93" fmla="*/ 68 h 167"/>
                <a:gd name="T94" fmla="*/ 391 w 456"/>
                <a:gd name="T95" fmla="*/ 77 h 167"/>
                <a:gd name="T96" fmla="*/ 401 w 456"/>
                <a:gd name="T97" fmla="*/ 78 h 167"/>
                <a:gd name="T98" fmla="*/ 410 w 456"/>
                <a:gd name="T99" fmla="*/ 78 h 167"/>
                <a:gd name="T100" fmla="*/ 421 w 456"/>
                <a:gd name="T101" fmla="*/ 78 h 167"/>
                <a:gd name="T102" fmla="*/ 430 w 456"/>
                <a:gd name="T103" fmla="*/ 78 h 167"/>
                <a:gd name="T104" fmla="*/ 441 w 456"/>
                <a:gd name="T105" fmla="*/ 78 h 167"/>
                <a:gd name="T106" fmla="*/ 450 w 456"/>
                <a:gd name="T107" fmla="*/ 78 h 167"/>
                <a:gd name="T108" fmla="*/ 456 w 456"/>
                <a:gd name="T109" fmla="*/ 83 h 167"/>
                <a:gd name="T110" fmla="*/ 456 w 456"/>
                <a:gd name="T111" fmla="*/ 92 h 167"/>
                <a:gd name="T112" fmla="*/ 456 w 456"/>
                <a:gd name="T113" fmla="*/ 103 h 167"/>
                <a:gd name="T114" fmla="*/ 456 w 456"/>
                <a:gd name="T115" fmla="*/ 112 h 167"/>
                <a:gd name="T116" fmla="*/ 456 w 456"/>
                <a:gd name="T117" fmla="*/ 123 h 167"/>
                <a:gd name="T118" fmla="*/ 456 w 456"/>
                <a:gd name="T119" fmla="*/ 132 h 167"/>
                <a:gd name="T120" fmla="*/ 456 w 456"/>
                <a:gd name="T121" fmla="*/ 143 h 167"/>
                <a:gd name="T122" fmla="*/ 456 w 456"/>
                <a:gd name="T123" fmla="*/ 152 h 167"/>
                <a:gd name="T124" fmla="*/ 456 w 456"/>
                <a:gd name="T125" fmla="*/ 163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456" h="167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lnTo>
                    <a:pt x="64" y="0"/>
                  </a:lnTo>
                  <a:moveTo>
                    <a:pt x="64" y="3"/>
                  </a:moveTo>
                  <a:lnTo>
                    <a:pt x="65" y="3"/>
                  </a:lnTo>
                  <a:moveTo>
                    <a:pt x="68" y="3"/>
                  </a:moveTo>
                  <a:lnTo>
                    <a:pt x="69" y="3"/>
                  </a:lnTo>
                  <a:moveTo>
                    <a:pt x="72" y="3"/>
                  </a:moveTo>
                  <a:lnTo>
                    <a:pt x="73" y="3"/>
                  </a:lnTo>
                  <a:moveTo>
                    <a:pt x="76" y="3"/>
                  </a:moveTo>
                  <a:lnTo>
                    <a:pt x="77" y="3"/>
                  </a:lnTo>
                  <a:moveTo>
                    <a:pt x="80" y="3"/>
                  </a:moveTo>
                  <a:lnTo>
                    <a:pt x="81" y="3"/>
                  </a:lnTo>
                  <a:moveTo>
                    <a:pt x="84" y="3"/>
                  </a:moveTo>
                  <a:lnTo>
                    <a:pt x="85" y="3"/>
                  </a:lnTo>
                  <a:moveTo>
                    <a:pt x="88" y="3"/>
                  </a:moveTo>
                  <a:lnTo>
                    <a:pt x="89" y="3"/>
                  </a:lnTo>
                  <a:moveTo>
                    <a:pt x="92" y="3"/>
                  </a:moveTo>
                  <a:lnTo>
                    <a:pt x="93" y="3"/>
                  </a:lnTo>
                  <a:moveTo>
                    <a:pt x="96" y="3"/>
                  </a:moveTo>
                  <a:lnTo>
                    <a:pt x="97" y="3"/>
                  </a:lnTo>
                  <a:moveTo>
                    <a:pt x="100" y="3"/>
                  </a:moveTo>
                  <a:lnTo>
                    <a:pt x="101" y="3"/>
                  </a:lnTo>
                  <a:moveTo>
                    <a:pt x="104" y="3"/>
                  </a:moveTo>
                  <a:lnTo>
                    <a:pt x="105" y="3"/>
                  </a:lnTo>
                  <a:moveTo>
                    <a:pt x="108" y="3"/>
                  </a:moveTo>
                  <a:lnTo>
                    <a:pt x="109" y="3"/>
                  </a:lnTo>
                  <a:moveTo>
                    <a:pt x="112" y="3"/>
                  </a:moveTo>
                  <a:lnTo>
                    <a:pt x="113" y="3"/>
                  </a:lnTo>
                  <a:moveTo>
                    <a:pt x="116" y="3"/>
                  </a:moveTo>
                  <a:lnTo>
                    <a:pt x="117" y="3"/>
                  </a:lnTo>
                  <a:moveTo>
                    <a:pt x="120" y="3"/>
                  </a:moveTo>
                  <a:lnTo>
                    <a:pt x="121" y="3"/>
                  </a:lnTo>
                  <a:moveTo>
                    <a:pt x="124" y="3"/>
                  </a:moveTo>
                  <a:lnTo>
                    <a:pt x="125" y="3"/>
                  </a:lnTo>
                  <a:moveTo>
                    <a:pt x="128" y="3"/>
                  </a:moveTo>
                  <a:lnTo>
                    <a:pt x="129" y="3"/>
                  </a:lnTo>
                  <a:lnTo>
                    <a:pt x="129" y="3"/>
                  </a:lnTo>
                  <a:moveTo>
                    <a:pt x="129" y="6"/>
                  </a:moveTo>
                  <a:lnTo>
                    <a:pt x="129" y="7"/>
                  </a:lnTo>
                  <a:lnTo>
                    <a:pt x="129" y="7"/>
                  </a:lnTo>
                  <a:moveTo>
                    <a:pt x="132" y="7"/>
                  </a:moveTo>
                  <a:lnTo>
                    <a:pt x="133" y="7"/>
                  </a:lnTo>
                  <a:moveTo>
                    <a:pt x="136" y="7"/>
                  </a:moveTo>
                  <a:lnTo>
                    <a:pt x="137" y="7"/>
                  </a:lnTo>
                  <a:moveTo>
                    <a:pt x="140" y="7"/>
                  </a:moveTo>
                  <a:lnTo>
                    <a:pt x="141" y="7"/>
                  </a:lnTo>
                  <a:moveTo>
                    <a:pt x="144" y="7"/>
                  </a:moveTo>
                  <a:lnTo>
                    <a:pt x="145" y="7"/>
                  </a:lnTo>
                  <a:moveTo>
                    <a:pt x="148" y="7"/>
                  </a:moveTo>
                  <a:lnTo>
                    <a:pt x="149" y="7"/>
                  </a:lnTo>
                  <a:moveTo>
                    <a:pt x="152" y="7"/>
                  </a:moveTo>
                  <a:lnTo>
                    <a:pt x="153" y="7"/>
                  </a:lnTo>
                  <a:moveTo>
                    <a:pt x="156" y="7"/>
                  </a:moveTo>
                  <a:lnTo>
                    <a:pt x="157" y="7"/>
                  </a:lnTo>
                  <a:moveTo>
                    <a:pt x="160" y="7"/>
                  </a:moveTo>
                  <a:lnTo>
                    <a:pt x="161" y="7"/>
                  </a:lnTo>
                  <a:moveTo>
                    <a:pt x="164" y="7"/>
                  </a:moveTo>
                  <a:lnTo>
                    <a:pt x="165" y="7"/>
                  </a:lnTo>
                  <a:moveTo>
                    <a:pt x="168" y="7"/>
                  </a:moveTo>
                  <a:lnTo>
                    <a:pt x="169" y="7"/>
                  </a:lnTo>
                  <a:moveTo>
                    <a:pt x="172" y="7"/>
                  </a:moveTo>
                  <a:lnTo>
                    <a:pt x="173" y="7"/>
                  </a:lnTo>
                  <a:moveTo>
                    <a:pt x="176" y="7"/>
                  </a:moveTo>
                  <a:lnTo>
                    <a:pt x="177" y="7"/>
                  </a:lnTo>
                  <a:moveTo>
                    <a:pt x="180" y="7"/>
                  </a:moveTo>
                  <a:lnTo>
                    <a:pt x="181" y="7"/>
                  </a:lnTo>
                  <a:moveTo>
                    <a:pt x="184" y="7"/>
                  </a:moveTo>
                  <a:lnTo>
                    <a:pt x="185" y="7"/>
                  </a:lnTo>
                  <a:moveTo>
                    <a:pt x="188" y="7"/>
                  </a:moveTo>
                  <a:lnTo>
                    <a:pt x="189" y="7"/>
                  </a:lnTo>
                  <a:moveTo>
                    <a:pt x="192" y="7"/>
                  </a:moveTo>
                  <a:lnTo>
                    <a:pt x="193" y="7"/>
                  </a:lnTo>
                  <a:moveTo>
                    <a:pt x="195" y="8"/>
                  </a:moveTo>
                  <a:lnTo>
                    <a:pt x="195" y="9"/>
                  </a:lnTo>
                  <a:moveTo>
                    <a:pt x="195" y="12"/>
                  </a:moveTo>
                  <a:lnTo>
                    <a:pt x="196" y="12"/>
                  </a:lnTo>
                  <a:moveTo>
                    <a:pt x="199" y="12"/>
                  </a:moveTo>
                  <a:lnTo>
                    <a:pt x="200" y="12"/>
                  </a:lnTo>
                  <a:moveTo>
                    <a:pt x="203" y="12"/>
                  </a:moveTo>
                  <a:lnTo>
                    <a:pt x="204" y="12"/>
                  </a:lnTo>
                  <a:moveTo>
                    <a:pt x="207" y="12"/>
                  </a:moveTo>
                  <a:lnTo>
                    <a:pt x="208" y="12"/>
                  </a:lnTo>
                  <a:moveTo>
                    <a:pt x="211" y="12"/>
                  </a:moveTo>
                  <a:lnTo>
                    <a:pt x="212" y="12"/>
                  </a:lnTo>
                  <a:moveTo>
                    <a:pt x="215" y="12"/>
                  </a:moveTo>
                  <a:lnTo>
                    <a:pt x="216" y="12"/>
                  </a:lnTo>
                  <a:moveTo>
                    <a:pt x="219" y="12"/>
                  </a:moveTo>
                  <a:lnTo>
                    <a:pt x="220" y="12"/>
                  </a:lnTo>
                  <a:moveTo>
                    <a:pt x="223" y="12"/>
                  </a:moveTo>
                  <a:lnTo>
                    <a:pt x="224" y="12"/>
                  </a:lnTo>
                  <a:moveTo>
                    <a:pt x="227" y="12"/>
                  </a:moveTo>
                  <a:lnTo>
                    <a:pt x="228" y="12"/>
                  </a:lnTo>
                  <a:moveTo>
                    <a:pt x="231" y="12"/>
                  </a:moveTo>
                  <a:lnTo>
                    <a:pt x="232" y="12"/>
                  </a:lnTo>
                  <a:moveTo>
                    <a:pt x="235" y="12"/>
                  </a:moveTo>
                  <a:lnTo>
                    <a:pt x="236" y="12"/>
                  </a:lnTo>
                  <a:moveTo>
                    <a:pt x="239" y="12"/>
                  </a:moveTo>
                  <a:lnTo>
                    <a:pt x="240" y="12"/>
                  </a:lnTo>
                  <a:moveTo>
                    <a:pt x="243" y="12"/>
                  </a:moveTo>
                  <a:lnTo>
                    <a:pt x="244" y="12"/>
                  </a:lnTo>
                  <a:moveTo>
                    <a:pt x="247" y="12"/>
                  </a:moveTo>
                  <a:lnTo>
                    <a:pt x="248" y="12"/>
                  </a:lnTo>
                  <a:moveTo>
                    <a:pt x="251" y="12"/>
                  </a:moveTo>
                  <a:lnTo>
                    <a:pt x="252" y="12"/>
                  </a:lnTo>
                  <a:moveTo>
                    <a:pt x="255" y="12"/>
                  </a:moveTo>
                  <a:lnTo>
                    <a:pt x="256" y="12"/>
                  </a:lnTo>
                  <a:moveTo>
                    <a:pt x="259" y="12"/>
                  </a:moveTo>
                  <a:lnTo>
                    <a:pt x="260" y="12"/>
                  </a:lnTo>
                  <a:lnTo>
                    <a:pt x="260" y="12"/>
                  </a:lnTo>
                  <a:moveTo>
                    <a:pt x="260" y="15"/>
                  </a:moveTo>
                  <a:lnTo>
                    <a:pt x="260" y="16"/>
                  </a:lnTo>
                  <a:moveTo>
                    <a:pt x="260" y="19"/>
                  </a:moveTo>
                  <a:lnTo>
                    <a:pt x="260" y="20"/>
                  </a:lnTo>
                  <a:moveTo>
                    <a:pt x="261" y="22"/>
                  </a:moveTo>
                  <a:lnTo>
                    <a:pt x="262" y="22"/>
                  </a:lnTo>
                  <a:moveTo>
                    <a:pt x="265" y="22"/>
                  </a:moveTo>
                  <a:lnTo>
                    <a:pt x="266" y="22"/>
                  </a:lnTo>
                  <a:moveTo>
                    <a:pt x="269" y="22"/>
                  </a:moveTo>
                  <a:lnTo>
                    <a:pt x="270" y="22"/>
                  </a:lnTo>
                  <a:moveTo>
                    <a:pt x="273" y="22"/>
                  </a:moveTo>
                  <a:lnTo>
                    <a:pt x="274" y="22"/>
                  </a:lnTo>
                  <a:moveTo>
                    <a:pt x="277" y="22"/>
                  </a:moveTo>
                  <a:lnTo>
                    <a:pt x="278" y="22"/>
                  </a:lnTo>
                  <a:moveTo>
                    <a:pt x="281" y="22"/>
                  </a:moveTo>
                  <a:lnTo>
                    <a:pt x="282" y="22"/>
                  </a:lnTo>
                  <a:moveTo>
                    <a:pt x="285" y="22"/>
                  </a:moveTo>
                  <a:lnTo>
                    <a:pt x="286" y="22"/>
                  </a:lnTo>
                  <a:moveTo>
                    <a:pt x="289" y="22"/>
                  </a:moveTo>
                  <a:lnTo>
                    <a:pt x="290" y="22"/>
                  </a:lnTo>
                  <a:moveTo>
                    <a:pt x="293" y="22"/>
                  </a:moveTo>
                  <a:lnTo>
                    <a:pt x="294" y="22"/>
                  </a:lnTo>
                  <a:moveTo>
                    <a:pt x="297" y="22"/>
                  </a:moveTo>
                  <a:lnTo>
                    <a:pt x="298" y="22"/>
                  </a:lnTo>
                  <a:moveTo>
                    <a:pt x="301" y="22"/>
                  </a:moveTo>
                  <a:lnTo>
                    <a:pt x="302" y="22"/>
                  </a:lnTo>
                  <a:moveTo>
                    <a:pt x="305" y="22"/>
                  </a:moveTo>
                  <a:lnTo>
                    <a:pt x="306" y="22"/>
                  </a:lnTo>
                  <a:moveTo>
                    <a:pt x="309" y="22"/>
                  </a:moveTo>
                  <a:lnTo>
                    <a:pt x="310" y="22"/>
                  </a:lnTo>
                  <a:moveTo>
                    <a:pt x="313" y="22"/>
                  </a:moveTo>
                  <a:lnTo>
                    <a:pt x="314" y="22"/>
                  </a:lnTo>
                  <a:moveTo>
                    <a:pt x="317" y="22"/>
                  </a:moveTo>
                  <a:lnTo>
                    <a:pt x="318" y="22"/>
                  </a:lnTo>
                  <a:moveTo>
                    <a:pt x="321" y="22"/>
                  </a:moveTo>
                  <a:lnTo>
                    <a:pt x="322" y="22"/>
                  </a:lnTo>
                  <a:moveTo>
                    <a:pt x="325" y="22"/>
                  </a:moveTo>
                  <a:lnTo>
                    <a:pt x="325" y="23"/>
                  </a:lnTo>
                  <a:moveTo>
                    <a:pt x="325" y="26"/>
                  </a:moveTo>
                  <a:lnTo>
                    <a:pt x="325" y="27"/>
                  </a:lnTo>
                  <a:moveTo>
                    <a:pt x="325" y="30"/>
                  </a:moveTo>
                  <a:lnTo>
                    <a:pt x="325" y="31"/>
                  </a:lnTo>
                  <a:moveTo>
                    <a:pt x="325" y="34"/>
                  </a:moveTo>
                  <a:lnTo>
                    <a:pt x="325" y="35"/>
                  </a:lnTo>
                  <a:moveTo>
                    <a:pt x="326" y="37"/>
                  </a:moveTo>
                  <a:lnTo>
                    <a:pt x="327" y="37"/>
                  </a:lnTo>
                  <a:moveTo>
                    <a:pt x="330" y="37"/>
                  </a:moveTo>
                  <a:lnTo>
                    <a:pt x="331" y="37"/>
                  </a:lnTo>
                  <a:moveTo>
                    <a:pt x="334" y="37"/>
                  </a:moveTo>
                  <a:lnTo>
                    <a:pt x="335" y="37"/>
                  </a:lnTo>
                  <a:moveTo>
                    <a:pt x="338" y="37"/>
                  </a:moveTo>
                  <a:lnTo>
                    <a:pt x="339" y="37"/>
                  </a:lnTo>
                  <a:moveTo>
                    <a:pt x="342" y="37"/>
                  </a:moveTo>
                  <a:lnTo>
                    <a:pt x="343" y="37"/>
                  </a:lnTo>
                  <a:moveTo>
                    <a:pt x="346" y="37"/>
                  </a:moveTo>
                  <a:lnTo>
                    <a:pt x="347" y="37"/>
                  </a:lnTo>
                  <a:moveTo>
                    <a:pt x="350" y="37"/>
                  </a:moveTo>
                  <a:lnTo>
                    <a:pt x="351" y="37"/>
                  </a:lnTo>
                  <a:moveTo>
                    <a:pt x="354" y="37"/>
                  </a:moveTo>
                  <a:lnTo>
                    <a:pt x="355" y="37"/>
                  </a:lnTo>
                  <a:moveTo>
                    <a:pt x="358" y="37"/>
                  </a:moveTo>
                  <a:lnTo>
                    <a:pt x="359" y="37"/>
                  </a:lnTo>
                  <a:moveTo>
                    <a:pt x="362" y="37"/>
                  </a:moveTo>
                  <a:lnTo>
                    <a:pt x="363" y="37"/>
                  </a:lnTo>
                  <a:moveTo>
                    <a:pt x="366" y="37"/>
                  </a:moveTo>
                  <a:lnTo>
                    <a:pt x="367" y="37"/>
                  </a:lnTo>
                  <a:moveTo>
                    <a:pt x="370" y="37"/>
                  </a:moveTo>
                  <a:lnTo>
                    <a:pt x="371" y="37"/>
                  </a:lnTo>
                  <a:moveTo>
                    <a:pt x="374" y="37"/>
                  </a:moveTo>
                  <a:lnTo>
                    <a:pt x="375" y="37"/>
                  </a:lnTo>
                  <a:moveTo>
                    <a:pt x="378" y="37"/>
                  </a:moveTo>
                  <a:lnTo>
                    <a:pt x="379" y="37"/>
                  </a:lnTo>
                  <a:moveTo>
                    <a:pt x="382" y="37"/>
                  </a:moveTo>
                  <a:lnTo>
                    <a:pt x="383" y="37"/>
                  </a:lnTo>
                  <a:moveTo>
                    <a:pt x="386" y="37"/>
                  </a:moveTo>
                  <a:lnTo>
                    <a:pt x="387" y="37"/>
                  </a:lnTo>
                  <a:moveTo>
                    <a:pt x="390" y="37"/>
                  </a:moveTo>
                  <a:lnTo>
                    <a:pt x="391" y="37"/>
                  </a:lnTo>
                  <a:lnTo>
                    <a:pt x="391" y="37"/>
                  </a:lnTo>
                  <a:moveTo>
                    <a:pt x="391" y="40"/>
                  </a:moveTo>
                  <a:lnTo>
                    <a:pt x="391" y="41"/>
                  </a:lnTo>
                  <a:moveTo>
                    <a:pt x="391" y="44"/>
                  </a:moveTo>
                  <a:lnTo>
                    <a:pt x="391" y="45"/>
                  </a:lnTo>
                  <a:moveTo>
                    <a:pt x="391" y="48"/>
                  </a:moveTo>
                  <a:lnTo>
                    <a:pt x="391" y="49"/>
                  </a:lnTo>
                  <a:moveTo>
                    <a:pt x="391" y="52"/>
                  </a:moveTo>
                  <a:lnTo>
                    <a:pt x="391" y="53"/>
                  </a:lnTo>
                  <a:moveTo>
                    <a:pt x="391" y="56"/>
                  </a:moveTo>
                  <a:lnTo>
                    <a:pt x="391" y="57"/>
                  </a:lnTo>
                  <a:moveTo>
                    <a:pt x="391" y="60"/>
                  </a:moveTo>
                  <a:lnTo>
                    <a:pt x="391" y="61"/>
                  </a:lnTo>
                  <a:moveTo>
                    <a:pt x="391" y="64"/>
                  </a:moveTo>
                  <a:lnTo>
                    <a:pt x="391" y="65"/>
                  </a:lnTo>
                  <a:moveTo>
                    <a:pt x="391" y="68"/>
                  </a:moveTo>
                  <a:lnTo>
                    <a:pt x="391" y="69"/>
                  </a:lnTo>
                  <a:moveTo>
                    <a:pt x="391" y="72"/>
                  </a:moveTo>
                  <a:lnTo>
                    <a:pt x="391" y="73"/>
                  </a:lnTo>
                  <a:moveTo>
                    <a:pt x="391" y="76"/>
                  </a:moveTo>
                  <a:lnTo>
                    <a:pt x="391" y="77"/>
                  </a:lnTo>
                  <a:moveTo>
                    <a:pt x="393" y="78"/>
                  </a:moveTo>
                  <a:lnTo>
                    <a:pt x="394" y="78"/>
                  </a:lnTo>
                  <a:moveTo>
                    <a:pt x="397" y="78"/>
                  </a:moveTo>
                  <a:lnTo>
                    <a:pt x="398" y="78"/>
                  </a:lnTo>
                  <a:moveTo>
                    <a:pt x="401" y="78"/>
                  </a:moveTo>
                  <a:lnTo>
                    <a:pt x="402" y="78"/>
                  </a:lnTo>
                  <a:moveTo>
                    <a:pt x="405" y="78"/>
                  </a:moveTo>
                  <a:lnTo>
                    <a:pt x="406" y="78"/>
                  </a:lnTo>
                  <a:moveTo>
                    <a:pt x="409" y="78"/>
                  </a:moveTo>
                  <a:lnTo>
                    <a:pt x="410" y="78"/>
                  </a:lnTo>
                  <a:moveTo>
                    <a:pt x="413" y="78"/>
                  </a:moveTo>
                  <a:lnTo>
                    <a:pt x="414" y="78"/>
                  </a:lnTo>
                  <a:moveTo>
                    <a:pt x="417" y="78"/>
                  </a:moveTo>
                  <a:lnTo>
                    <a:pt x="418" y="78"/>
                  </a:lnTo>
                  <a:moveTo>
                    <a:pt x="421" y="78"/>
                  </a:moveTo>
                  <a:lnTo>
                    <a:pt x="422" y="78"/>
                  </a:lnTo>
                  <a:moveTo>
                    <a:pt x="425" y="78"/>
                  </a:moveTo>
                  <a:lnTo>
                    <a:pt x="426" y="78"/>
                  </a:lnTo>
                  <a:moveTo>
                    <a:pt x="429" y="78"/>
                  </a:moveTo>
                  <a:lnTo>
                    <a:pt x="430" y="78"/>
                  </a:lnTo>
                  <a:moveTo>
                    <a:pt x="433" y="78"/>
                  </a:moveTo>
                  <a:lnTo>
                    <a:pt x="434" y="78"/>
                  </a:lnTo>
                  <a:moveTo>
                    <a:pt x="437" y="78"/>
                  </a:moveTo>
                  <a:lnTo>
                    <a:pt x="438" y="78"/>
                  </a:lnTo>
                  <a:moveTo>
                    <a:pt x="441" y="78"/>
                  </a:moveTo>
                  <a:lnTo>
                    <a:pt x="442" y="78"/>
                  </a:lnTo>
                  <a:moveTo>
                    <a:pt x="445" y="78"/>
                  </a:moveTo>
                  <a:lnTo>
                    <a:pt x="446" y="78"/>
                  </a:lnTo>
                  <a:moveTo>
                    <a:pt x="449" y="78"/>
                  </a:moveTo>
                  <a:lnTo>
                    <a:pt x="450" y="78"/>
                  </a:lnTo>
                  <a:moveTo>
                    <a:pt x="453" y="78"/>
                  </a:moveTo>
                  <a:lnTo>
                    <a:pt x="454" y="78"/>
                  </a:lnTo>
                  <a:moveTo>
                    <a:pt x="456" y="79"/>
                  </a:moveTo>
                  <a:lnTo>
                    <a:pt x="456" y="80"/>
                  </a:lnTo>
                  <a:moveTo>
                    <a:pt x="456" y="83"/>
                  </a:moveTo>
                  <a:lnTo>
                    <a:pt x="456" y="84"/>
                  </a:lnTo>
                  <a:moveTo>
                    <a:pt x="456" y="87"/>
                  </a:moveTo>
                  <a:lnTo>
                    <a:pt x="456" y="88"/>
                  </a:lnTo>
                  <a:moveTo>
                    <a:pt x="456" y="91"/>
                  </a:moveTo>
                  <a:lnTo>
                    <a:pt x="456" y="92"/>
                  </a:lnTo>
                  <a:moveTo>
                    <a:pt x="456" y="95"/>
                  </a:moveTo>
                  <a:lnTo>
                    <a:pt x="456" y="96"/>
                  </a:lnTo>
                  <a:moveTo>
                    <a:pt x="456" y="99"/>
                  </a:moveTo>
                  <a:lnTo>
                    <a:pt x="456" y="100"/>
                  </a:lnTo>
                  <a:moveTo>
                    <a:pt x="456" y="103"/>
                  </a:moveTo>
                  <a:lnTo>
                    <a:pt x="456" y="104"/>
                  </a:lnTo>
                  <a:moveTo>
                    <a:pt x="456" y="107"/>
                  </a:moveTo>
                  <a:lnTo>
                    <a:pt x="456" y="108"/>
                  </a:lnTo>
                  <a:moveTo>
                    <a:pt x="456" y="111"/>
                  </a:moveTo>
                  <a:lnTo>
                    <a:pt x="456" y="112"/>
                  </a:lnTo>
                  <a:moveTo>
                    <a:pt x="456" y="115"/>
                  </a:moveTo>
                  <a:lnTo>
                    <a:pt x="456" y="116"/>
                  </a:lnTo>
                  <a:moveTo>
                    <a:pt x="456" y="119"/>
                  </a:moveTo>
                  <a:lnTo>
                    <a:pt x="456" y="120"/>
                  </a:lnTo>
                  <a:moveTo>
                    <a:pt x="456" y="123"/>
                  </a:moveTo>
                  <a:lnTo>
                    <a:pt x="456" y="124"/>
                  </a:lnTo>
                  <a:moveTo>
                    <a:pt x="456" y="127"/>
                  </a:moveTo>
                  <a:lnTo>
                    <a:pt x="456" y="128"/>
                  </a:lnTo>
                  <a:moveTo>
                    <a:pt x="456" y="131"/>
                  </a:moveTo>
                  <a:lnTo>
                    <a:pt x="456" y="132"/>
                  </a:lnTo>
                  <a:moveTo>
                    <a:pt x="456" y="135"/>
                  </a:moveTo>
                  <a:lnTo>
                    <a:pt x="456" y="136"/>
                  </a:lnTo>
                  <a:moveTo>
                    <a:pt x="456" y="139"/>
                  </a:moveTo>
                  <a:lnTo>
                    <a:pt x="456" y="140"/>
                  </a:lnTo>
                  <a:moveTo>
                    <a:pt x="456" y="143"/>
                  </a:moveTo>
                  <a:lnTo>
                    <a:pt x="456" y="144"/>
                  </a:lnTo>
                  <a:moveTo>
                    <a:pt x="456" y="147"/>
                  </a:moveTo>
                  <a:lnTo>
                    <a:pt x="456" y="148"/>
                  </a:lnTo>
                  <a:moveTo>
                    <a:pt x="456" y="151"/>
                  </a:moveTo>
                  <a:lnTo>
                    <a:pt x="456" y="152"/>
                  </a:lnTo>
                  <a:moveTo>
                    <a:pt x="456" y="155"/>
                  </a:moveTo>
                  <a:lnTo>
                    <a:pt x="456" y="156"/>
                  </a:lnTo>
                  <a:moveTo>
                    <a:pt x="456" y="159"/>
                  </a:moveTo>
                  <a:lnTo>
                    <a:pt x="456" y="160"/>
                  </a:lnTo>
                  <a:moveTo>
                    <a:pt x="456" y="163"/>
                  </a:moveTo>
                  <a:lnTo>
                    <a:pt x="456" y="164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dirty="0"/>
            </a:p>
          </p:txBody>
        </p:sp>
        <p:sp>
          <p:nvSpPr>
            <p:cNvPr id="177" name="Line 174">
              <a:extLst>
                <a:ext uri="{FF2B5EF4-FFF2-40B4-BE49-F238E27FC236}">
                  <a16:creationId xmlns:a16="http://schemas.microsoft.com/office/drawing/2014/main" id="{E444374D-14D4-49AC-9D57-CBA4C1FB8D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4" y="2040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8" name="Line 175">
              <a:extLst>
                <a:ext uri="{FF2B5EF4-FFF2-40B4-BE49-F238E27FC236}">
                  <a16:creationId xmlns:a16="http://schemas.microsoft.com/office/drawing/2014/main" id="{AEB4B568-39DE-9AA2-CD6F-AC56D43379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6" y="2028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79" name="Line 176">
              <a:extLst>
                <a:ext uri="{FF2B5EF4-FFF2-40B4-BE49-F238E27FC236}">
                  <a16:creationId xmlns:a16="http://schemas.microsoft.com/office/drawing/2014/main" id="{ECF1B64C-DFB2-9B6C-4D2C-0EFA68EB45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7" y="2047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0" name="Line 177">
              <a:extLst>
                <a:ext uri="{FF2B5EF4-FFF2-40B4-BE49-F238E27FC236}">
                  <a16:creationId xmlns:a16="http://schemas.microsoft.com/office/drawing/2014/main" id="{8559FB17-C218-889C-28DE-0A4397C837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9" y="2035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1" name="Line 178">
              <a:extLst>
                <a:ext uri="{FF2B5EF4-FFF2-40B4-BE49-F238E27FC236}">
                  <a16:creationId xmlns:a16="http://schemas.microsoft.com/office/drawing/2014/main" id="{18C08866-7E8B-971B-ACE8-C46FE96B26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0" y="2056"/>
              <a:ext cx="2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2" name="Line 179">
              <a:extLst>
                <a:ext uri="{FF2B5EF4-FFF2-40B4-BE49-F238E27FC236}">
                  <a16:creationId xmlns:a16="http://schemas.microsoft.com/office/drawing/2014/main" id="{596AA293-9BC3-9617-C787-7542EAE86E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44" y="2045"/>
              <a:ext cx="0" cy="26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3" name="Line 180">
              <a:extLst>
                <a:ext uri="{FF2B5EF4-FFF2-40B4-BE49-F238E27FC236}">
                  <a16:creationId xmlns:a16="http://schemas.microsoft.com/office/drawing/2014/main" id="{1C5D9B3B-A010-A3EB-4E3E-FA96A996C6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86" y="2075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4" name="Line 181">
              <a:extLst>
                <a:ext uri="{FF2B5EF4-FFF2-40B4-BE49-F238E27FC236}">
                  <a16:creationId xmlns:a16="http://schemas.microsoft.com/office/drawing/2014/main" id="{46995DAB-A54B-1633-148C-72709CC95C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97" y="2063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5" name="Line 182">
              <a:extLst>
                <a:ext uri="{FF2B5EF4-FFF2-40B4-BE49-F238E27FC236}">
                  <a16:creationId xmlns:a16="http://schemas.microsoft.com/office/drawing/2014/main" id="{F827D83A-24E8-009C-2D07-44F3E36B85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9" y="2106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6" name="Line 183">
              <a:extLst>
                <a:ext uri="{FF2B5EF4-FFF2-40B4-BE49-F238E27FC236}">
                  <a16:creationId xmlns:a16="http://schemas.microsoft.com/office/drawing/2014/main" id="{EAE28103-6BC1-AFF8-55EC-446FC696D6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50" y="2094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7" name="Line 184">
              <a:extLst>
                <a:ext uri="{FF2B5EF4-FFF2-40B4-BE49-F238E27FC236}">
                  <a16:creationId xmlns:a16="http://schemas.microsoft.com/office/drawing/2014/main" id="{CED18257-6D57-DF5D-3C5D-6649A16976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92" y="2169"/>
              <a:ext cx="25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8" name="Line 185">
              <a:extLst>
                <a:ext uri="{FF2B5EF4-FFF2-40B4-BE49-F238E27FC236}">
                  <a16:creationId xmlns:a16="http://schemas.microsoft.com/office/drawing/2014/main" id="{14562F87-0638-D72C-0D2A-F84789AC84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06" y="2158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89" name="Line 186">
              <a:extLst>
                <a:ext uri="{FF2B5EF4-FFF2-40B4-BE49-F238E27FC236}">
                  <a16:creationId xmlns:a16="http://schemas.microsoft.com/office/drawing/2014/main" id="{2F9FCA10-4443-F04B-7E84-F69337195E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47" y="2322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0" name="Line 187">
              <a:extLst>
                <a:ext uri="{FF2B5EF4-FFF2-40B4-BE49-F238E27FC236}">
                  <a16:creationId xmlns:a16="http://schemas.microsoft.com/office/drawing/2014/main" id="{0F4A220D-9E09-9E78-2F0C-E6D3AF70FF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59" y="2311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1" name="Freeform 188">
              <a:extLst>
                <a:ext uri="{FF2B5EF4-FFF2-40B4-BE49-F238E27FC236}">
                  <a16:creationId xmlns:a16="http://schemas.microsoft.com/office/drawing/2014/main" id="{B9245ABC-4D73-BD17-F85C-F2873329239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6" y="2035"/>
              <a:ext cx="1073" cy="556"/>
            </a:xfrm>
            <a:custGeom>
              <a:avLst/>
              <a:gdLst>
                <a:gd name="T0" fmla="*/ 11 w 456"/>
                <a:gd name="T1" fmla="*/ 0 h 236"/>
                <a:gd name="T2" fmla="*/ 25 w 456"/>
                <a:gd name="T3" fmla="*/ 0 h 236"/>
                <a:gd name="T4" fmla="*/ 40 w 456"/>
                <a:gd name="T5" fmla="*/ 0 h 236"/>
                <a:gd name="T6" fmla="*/ 54 w 456"/>
                <a:gd name="T7" fmla="*/ 0 h 236"/>
                <a:gd name="T8" fmla="*/ 64 w 456"/>
                <a:gd name="T9" fmla="*/ 2 h 236"/>
                <a:gd name="T10" fmla="*/ 76 w 456"/>
                <a:gd name="T11" fmla="*/ 4 h 236"/>
                <a:gd name="T12" fmla="*/ 91 w 456"/>
                <a:gd name="T13" fmla="*/ 4 h 236"/>
                <a:gd name="T14" fmla="*/ 105 w 456"/>
                <a:gd name="T15" fmla="*/ 4 h 236"/>
                <a:gd name="T16" fmla="*/ 117 w 456"/>
                <a:gd name="T17" fmla="*/ 4 h 236"/>
                <a:gd name="T18" fmla="*/ 129 w 456"/>
                <a:gd name="T19" fmla="*/ 6 h 236"/>
                <a:gd name="T20" fmla="*/ 136 w 456"/>
                <a:gd name="T21" fmla="*/ 10 h 236"/>
                <a:gd name="T22" fmla="*/ 151 w 456"/>
                <a:gd name="T23" fmla="*/ 10 h 236"/>
                <a:gd name="T24" fmla="*/ 165 w 456"/>
                <a:gd name="T25" fmla="*/ 10 h 236"/>
                <a:gd name="T26" fmla="*/ 177 w 456"/>
                <a:gd name="T27" fmla="*/ 10 h 236"/>
                <a:gd name="T28" fmla="*/ 191 w 456"/>
                <a:gd name="T29" fmla="*/ 10 h 236"/>
                <a:gd name="T30" fmla="*/ 195 w 456"/>
                <a:gd name="T31" fmla="*/ 17 h 236"/>
                <a:gd name="T32" fmla="*/ 210 w 456"/>
                <a:gd name="T33" fmla="*/ 17 h 236"/>
                <a:gd name="T34" fmla="*/ 224 w 456"/>
                <a:gd name="T35" fmla="*/ 17 h 236"/>
                <a:gd name="T36" fmla="*/ 236 w 456"/>
                <a:gd name="T37" fmla="*/ 17 h 236"/>
                <a:gd name="T38" fmla="*/ 250 w 456"/>
                <a:gd name="T39" fmla="*/ 17 h 236"/>
                <a:gd name="T40" fmla="*/ 260 w 456"/>
                <a:gd name="T41" fmla="*/ 22 h 236"/>
                <a:gd name="T42" fmla="*/ 262 w 456"/>
                <a:gd name="T43" fmla="*/ 31 h 236"/>
                <a:gd name="T44" fmla="*/ 276 w 456"/>
                <a:gd name="T45" fmla="*/ 31 h 236"/>
                <a:gd name="T46" fmla="*/ 288 w 456"/>
                <a:gd name="T47" fmla="*/ 31 h 236"/>
                <a:gd name="T48" fmla="*/ 302 w 456"/>
                <a:gd name="T49" fmla="*/ 31 h 236"/>
                <a:gd name="T50" fmla="*/ 317 w 456"/>
                <a:gd name="T51" fmla="*/ 31 h 236"/>
                <a:gd name="T52" fmla="*/ 325 w 456"/>
                <a:gd name="T53" fmla="*/ 34 h 236"/>
                <a:gd name="T54" fmla="*/ 325 w 456"/>
                <a:gd name="T55" fmla="*/ 48 h 236"/>
                <a:gd name="T56" fmla="*/ 325 w 456"/>
                <a:gd name="T57" fmla="*/ 60 h 236"/>
                <a:gd name="T58" fmla="*/ 327 w 456"/>
                <a:gd name="T59" fmla="*/ 72 h 236"/>
                <a:gd name="T60" fmla="*/ 342 w 456"/>
                <a:gd name="T61" fmla="*/ 72 h 236"/>
                <a:gd name="T62" fmla="*/ 356 w 456"/>
                <a:gd name="T63" fmla="*/ 72 h 236"/>
                <a:gd name="T64" fmla="*/ 368 w 456"/>
                <a:gd name="T65" fmla="*/ 72 h 236"/>
                <a:gd name="T66" fmla="*/ 382 w 456"/>
                <a:gd name="T67" fmla="*/ 72 h 236"/>
                <a:gd name="T68" fmla="*/ 391 w 456"/>
                <a:gd name="T69" fmla="*/ 78 h 236"/>
                <a:gd name="T70" fmla="*/ 391 w 456"/>
                <a:gd name="T71" fmla="*/ 92 h 236"/>
                <a:gd name="T72" fmla="*/ 391 w 456"/>
                <a:gd name="T73" fmla="*/ 104 h 236"/>
                <a:gd name="T74" fmla="*/ 391 w 456"/>
                <a:gd name="T75" fmla="*/ 118 h 236"/>
                <a:gd name="T76" fmla="*/ 391 w 456"/>
                <a:gd name="T77" fmla="*/ 132 h 236"/>
                <a:gd name="T78" fmla="*/ 403 w 456"/>
                <a:gd name="T79" fmla="*/ 132 h 236"/>
                <a:gd name="T80" fmla="*/ 417 w 456"/>
                <a:gd name="T81" fmla="*/ 132 h 236"/>
                <a:gd name="T82" fmla="*/ 429 w 456"/>
                <a:gd name="T83" fmla="*/ 132 h 236"/>
                <a:gd name="T84" fmla="*/ 443 w 456"/>
                <a:gd name="T85" fmla="*/ 132 h 236"/>
                <a:gd name="T86" fmla="*/ 456 w 456"/>
                <a:gd name="T87" fmla="*/ 132 h 236"/>
                <a:gd name="T88" fmla="*/ 456 w 456"/>
                <a:gd name="T89" fmla="*/ 145 h 236"/>
                <a:gd name="T90" fmla="*/ 456 w 456"/>
                <a:gd name="T91" fmla="*/ 159 h 236"/>
                <a:gd name="T92" fmla="*/ 456 w 456"/>
                <a:gd name="T93" fmla="*/ 171 h 236"/>
                <a:gd name="T94" fmla="*/ 456 w 456"/>
                <a:gd name="T95" fmla="*/ 185 h 236"/>
                <a:gd name="T96" fmla="*/ 456 w 456"/>
                <a:gd name="T97" fmla="*/ 200 h 236"/>
                <a:gd name="T98" fmla="*/ 456 w 456"/>
                <a:gd name="T99" fmla="*/ 214 h 236"/>
                <a:gd name="T100" fmla="*/ 456 w 456"/>
                <a:gd name="T101" fmla="*/ 226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456" h="236">
                  <a:moveTo>
                    <a:pt x="3" y="0"/>
                  </a:moveTo>
                  <a:lnTo>
                    <a:pt x="7" y="0"/>
                  </a:lnTo>
                  <a:moveTo>
                    <a:pt x="10" y="0"/>
                  </a:moveTo>
                  <a:lnTo>
                    <a:pt x="11" y="0"/>
                  </a:lnTo>
                  <a:moveTo>
                    <a:pt x="14" y="0"/>
                  </a:moveTo>
                  <a:lnTo>
                    <a:pt x="18" y="0"/>
                  </a:lnTo>
                  <a:moveTo>
                    <a:pt x="21" y="0"/>
                  </a:moveTo>
                  <a:lnTo>
                    <a:pt x="22" y="0"/>
                  </a:lnTo>
                  <a:moveTo>
                    <a:pt x="25" y="0"/>
                  </a:moveTo>
                  <a:lnTo>
                    <a:pt x="29" y="0"/>
                  </a:lnTo>
                  <a:moveTo>
                    <a:pt x="32" y="0"/>
                  </a:moveTo>
                  <a:lnTo>
                    <a:pt x="33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51" y="0"/>
                  </a:lnTo>
                  <a:moveTo>
                    <a:pt x="54" y="0"/>
                  </a:moveTo>
                  <a:lnTo>
                    <a:pt x="55" y="0"/>
                  </a:lnTo>
                  <a:moveTo>
                    <a:pt x="58" y="0"/>
                  </a:moveTo>
                  <a:lnTo>
                    <a:pt x="62" y="0"/>
                  </a:lnTo>
                  <a:moveTo>
                    <a:pt x="64" y="1"/>
                  </a:moveTo>
                  <a:lnTo>
                    <a:pt x="64" y="2"/>
                  </a:lnTo>
                  <a:moveTo>
                    <a:pt x="65" y="4"/>
                  </a:moveTo>
                  <a:lnTo>
                    <a:pt x="69" y="4"/>
                  </a:lnTo>
                  <a:moveTo>
                    <a:pt x="72" y="4"/>
                  </a:moveTo>
                  <a:lnTo>
                    <a:pt x="73" y="4"/>
                  </a:lnTo>
                  <a:moveTo>
                    <a:pt x="76" y="4"/>
                  </a:moveTo>
                  <a:lnTo>
                    <a:pt x="80" y="4"/>
                  </a:lnTo>
                  <a:moveTo>
                    <a:pt x="83" y="4"/>
                  </a:moveTo>
                  <a:lnTo>
                    <a:pt x="84" y="4"/>
                  </a:lnTo>
                  <a:moveTo>
                    <a:pt x="87" y="4"/>
                  </a:moveTo>
                  <a:lnTo>
                    <a:pt x="91" y="4"/>
                  </a:lnTo>
                  <a:moveTo>
                    <a:pt x="94" y="4"/>
                  </a:moveTo>
                  <a:lnTo>
                    <a:pt x="95" y="4"/>
                  </a:lnTo>
                  <a:moveTo>
                    <a:pt x="98" y="4"/>
                  </a:moveTo>
                  <a:lnTo>
                    <a:pt x="102" y="4"/>
                  </a:lnTo>
                  <a:moveTo>
                    <a:pt x="105" y="4"/>
                  </a:moveTo>
                  <a:lnTo>
                    <a:pt x="106" y="4"/>
                  </a:lnTo>
                  <a:moveTo>
                    <a:pt x="109" y="4"/>
                  </a:moveTo>
                  <a:lnTo>
                    <a:pt x="113" y="4"/>
                  </a:lnTo>
                  <a:moveTo>
                    <a:pt x="116" y="4"/>
                  </a:moveTo>
                  <a:lnTo>
                    <a:pt x="117" y="4"/>
                  </a:lnTo>
                  <a:moveTo>
                    <a:pt x="120" y="4"/>
                  </a:moveTo>
                  <a:lnTo>
                    <a:pt x="124" y="4"/>
                  </a:lnTo>
                  <a:moveTo>
                    <a:pt x="127" y="4"/>
                  </a:moveTo>
                  <a:lnTo>
                    <a:pt x="128" y="4"/>
                  </a:lnTo>
                  <a:moveTo>
                    <a:pt x="129" y="6"/>
                  </a:moveTo>
                  <a:lnTo>
                    <a:pt x="129" y="10"/>
                  </a:lnTo>
                  <a:lnTo>
                    <a:pt x="129" y="10"/>
                  </a:lnTo>
                  <a:moveTo>
                    <a:pt x="132" y="10"/>
                  </a:moveTo>
                  <a:lnTo>
                    <a:pt x="133" y="10"/>
                  </a:lnTo>
                  <a:moveTo>
                    <a:pt x="136" y="10"/>
                  </a:moveTo>
                  <a:lnTo>
                    <a:pt x="140" y="10"/>
                  </a:lnTo>
                  <a:moveTo>
                    <a:pt x="143" y="10"/>
                  </a:moveTo>
                  <a:lnTo>
                    <a:pt x="144" y="10"/>
                  </a:lnTo>
                  <a:moveTo>
                    <a:pt x="147" y="10"/>
                  </a:moveTo>
                  <a:lnTo>
                    <a:pt x="151" y="10"/>
                  </a:lnTo>
                  <a:moveTo>
                    <a:pt x="154" y="10"/>
                  </a:moveTo>
                  <a:lnTo>
                    <a:pt x="155" y="10"/>
                  </a:lnTo>
                  <a:moveTo>
                    <a:pt x="158" y="10"/>
                  </a:moveTo>
                  <a:lnTo>
                    <a:pt x="162" y="10"/>
                  </a:lnTo>
                  <a:moveTo>
                    <a:pt x="165" y="10"/>
                  </a:moveTo>
                  <a:lnTo>
                    <a:pt x="166" y="10"/>
                  </a:lnTo>
                  <a:moveTo>
                    <a:pt x="169" y="10"/>
                  </a:moveTo>
                  <a:lnTo>
                    <a:pt x="173" y="10"/>
                  </a:lnTo>
                  <a:moveTo>
                    <a:pt x="176" y="10"/>
                  </a:moveTo>
                  <a:lnTo>
                    <a:pt x="177" y="10"/>
                  </a:lnTo>
                  <a:moveTo>
                    <a:pt x="180" y="10"/>
                  </a:moveTo>
                  <a:lnTo>
                    <a:pt x="184" y="10"/>
                  </a:lnTo>
                  <a:moveTo>
                    <a:pt x="187" y="10"/>
                  </a:moveTo>
                  <a:lnTo>
                    <a:pt x="188" y="10"/>
                  </a:lnTo>
                  <a:moveTo>
                    <a:pt x="191" y="10"/>
                  </a:moveTo>
                  <a:lnTo>
                    <a:pt x="195" y="10"/>
                  </a:lnTo>
                  <a:lnTo>
                    <a:pt x="195" y="10"/>
                  </a:lnTo>
                  <a:moveTo>
                    <a:pt x="195" y="13"/>
                  </a:moveTo>
                  <a:lnTo>
                    <a:pt x="195" y="14"/>
                  </a:lnTo>
                  <a:moveTo>
                    <a:pt x="195" y="17"/>
                  </a:moveTo>
                  <a:lnTo>
                    <a:pt x="199" y="17"/>
                  </a:lnTo>
                  <a:moveTo>
                    <a:pt x="202" y="17"/>
                  </a:moveTo>
                  <a:lnTo>
                    <a:pt x="203" y="17"/>
                  </a:lnTo>
                  <a:moveTo>
                    <a:pt x="206" y="17"/>
                  </a:moveTo>
                  <a:lnTo>
                    <a:pt x="210" y="17"/>
                  </a:lnTo>
                  <a:moveTo>
                    <a:pt x="213" y="17"/>
                  </a:moveTo>
                  <a:lnTo>
                    <a:pt x="214" y="17"/>
                  </a:lnTo>
                  <a:moveTo>
                    <a:pt x="217" y="17"/>
                  </a:moveTo>
                  <a:lnTo>
                    <a:pt x="221" y="17"/>
                  </a:lnTo>
                  <a:moveTo>
                    <a:pt x="224" y="17"/>
                  </a:moveTo>
                  <a:lnTo>
                    <a:pt x="225" y="17"/>
                  </a:lnTo>
                  <a:moveTo>
                    <a:pt x="228" y="17"/>
                  </a:moveTo>
                  <a:lnTo>
                    <a:pt x="232" y="17"/>
                  </a:lnTo>
                  <a:moveTo>
                    <a:pt x="235" y="17"/>
                  </a:moveTo>
                  <a:lnTo>
                    <a:pt x="236" y="17"/>
                  </a:lnTo>
                  <a:moveTo>
                    <a:pt x="239" y="17"/>
                  </a:moveTo>
                  <a:lnTo>
                    <a:pt x="243" y="17"/>
                  </a:lnTo>
                  <a:moveTo>
                    <a:pt x="246" y="17"/>
                  </a:moveTo>
                  <a:lnTo>
                    <a:pt x="247" y="17"/>
                  </a:lnTo>
                  <a:moveTo>
                    <a:pt x="250" y="17"/>
                  </a:moveTo>
                  <a:lnTo>
                    <a:pt x="254" y="17"/>
                  </a:lnTo>
                  <a:moveTo>
                    <a:pt x="257" y="17"/>
                  </a:moveTo>
                  <a:lnTo>
                    <a:pt x="258" y="17"/>
                  </a:lnTo>
                  <a:moveTo>
                    <a:pt x="260" y="18"/>
                  </a:moveTo>
                  <a:lnTo>
                    <a:pt x="260" y="22"/>
                  </a:lnTo>
                  <a:moveTo>
                    <a:pt x="260" y="25"/>
                  </a:moveTo>
                  <a:lnTo>
                    <a:pt x="260" y="26"/>
                  </a:lnTo>
                  <a:moveTo>
                    <a:pt x="260" y="29"/>
                  </a:moveTo>
                  <a:lnTo>
                    <a:pt x="260" y="31"/>
                  </a:lnTo>
                  <a:lnTo>
                    <a:pt x="262" y="31"/>
                  </a:lnTo>
                  <a:moveTo>
                    <a:pt x="265" y="31"/>
                  </a:moveTo>
                  <a:lnTo>
                    <a:pt x="266" y="31"/>
                  </a:lnTo>
                  <a:moveTo>
                    <a:pt x="269" y="31"/>
                  </a:moveTo>
                  <a:lnTo>
                    <a:pt x="273" y="31"/>
                  </a:lnTo>
                  <a:moveTo>
                    <a:pt x="276" y="31"/>
                  </a:moveTo>
                  <a:lnTo>
                    <a:pt x="277" y="31"/>
                  </a:lnTo>
                  <a:moveTo>
                    <a:pt x="280" y="31"/>
                  </a:moveTo>
                  <a:lnTo>
                    <a:pt x="284" y="31"/>
                  </a:lnTo>
                  <a:moveTo>
                    <a:pt x="287" y="31"/>
                  </a:moveTo>
                  <a:lnTo>
                    <a:pt x="288" y="31"/>
                  </a:lnTo>
                  <a:moveTo>
                    <a:pt x="291" y="31"/>
                  </a:moveTo>
                  <a:lnTo>
                    <a:pt x="295" y="31"/>
                  </a:lnTo>
                  <a:moveTo>
                    <a:pt x="298" y="31"/>
                  </a:moveTo>
                  <a:lnTo>
                    <a:pt x="299" y="31"/>
                  </a:lnTo>
                  <a:moveTo>
                    <a:pt x="302" y="31"/>
                  </a:moveTo>
                  <a:lnTo>
                    <a:pt x="306" y="31"/>
                  </a:lnTo>
                  <a:moveTo>
                    <a:pt x="309" y="31"/>
                  </a:moveTo>
                  <a:lnTo>
                    <a:pt x="310" y="31"/>
                  </a:lnTo>
                  <a:moveTo>
                    <a:pt x="313" y="31"/>
                  </a:moveTo>
                  <a:lnTo>
                    <a:pt x="317" y="31"/>
                  </a:lnTo>
                  <a:moveTo>
                    <a:pt x="320" y="31"/>
                  </a:moveTo>
                  <a:lnTo>
                    <a:pt x="321" y="31"/>
                  </a:lnTo>
                  <a:moveTo>
                    <a:pt x="324" y="31"/>
                  </a:moveTo>
                  <a:lnTo>
                    <a:pt x="325" y="31"/>
                  </a:lnTo>
                  <a:lnTo>
                    <a:pt x="325" y="34"/>
                  </a:lnTo>
                  <a:moveTo>
                    <a:pt x="325" y="37"/>
                  </a:moveTo>
                  <a:lnTo>
                    <a:pt x="325" y="38"/>
                  </a:lnTo>
                  <a:moveTo>
                    <a:pt x="325" y="41"/>
                  </a:moveTo>
                  <a:lnTo>
                    <a:pt x="325" y="45"/>
                  </a:lnTo>
                  <a:moveTo>
                    <a:pt x="325" y="48"/>
                  </a:moveTo>
                  <a:lnTo>
                    <a:pt x="325" y="49"/>
                  </a:lnTo>
                  <a:moveTo>
                    <a:pt x="325" y="52"/>
                  </a:moveTo>
                  <a:lnTo>
                    <a:pt x="325" y="56"/>
                  </a:lnTo>
                  <a:moveTo>
                    <a:pt x="325" y="59"/>
                  </a:moveTo>
                  <a:lnTo>
                    <a:pt x="325" y="60"/>
                  </a:lnTo>
                  <a:moveTo>
                    <a:pt x="325" y="63"/>
                  </a:moveTo>
                  <a:lnTo>
                    <a:pt x="325" y="67"/>
                  </a:lnTo>
                  <a:moveTo>
                    <a:pt x="325" y="70"/>
                  </a:moveTo>
                  <a:lnTo>
                    <a:pt x="325" y="71"/>
                  </a:lnTo>
                  <a:moveTo>
                    <a:pt x="327" y="72"/>
                  </a:moveTo>
                  <a:lnTo>
                    <a:pt x="331" y="72"/>
                  </a:lnTo>
                  <a:moveTo>
                    <a:pt x="334" y="72"/>
                  </a:moveTo>
                  <a:lnTo>
                    <a:pt x="335" y="72"/>
                  </a:lnTo>
                  <a:moveTo>
                    <a:pt x="338" y="72"/>
                  </a:moveTo>
                  <a:lnTo>
                    <a:pt x="342" y="72"/>
                  </a:lnTo>
                  <a:moveTo>
                    <a:pt x="345" y="72"/>
                  </a:moveTo>
                  <a:lnTo>
                    <a:pt x="346" y="72"/>
                  </a:lnTo>
                  <a:moveTo>
                    <a:pt x="349" y="72"/>
                  </a:moveTo>
                  <a:lnTo>
                    <a:pt x="353" y="72"/>
                  </a:lnTo>
                  <a:moveTo>
                    <a:pt x="356" y="72"/>
                  </a:moveTo>
                  <a:lnTo>
                    <a:pt x="357" y="72"/>
                  </a:lnTo>
                  <a:moveTo>
                    <a:pt x="360" y="72"/>
                  </a:moveTo>
                  <a:lnTo>
                    <a:pt x="364" y="72"/>
                  </a:lnTo>
                  <a:moveTo>
                    <a:pt x="367" y="72"/>
                  </a:moveTo>
                  <a:lnTo>
                    <a:pt x="368" y="72"/>
                  </a:lnTo>
                  <a:moveTo>
                    <a:pt x="371" y="72"/>
                  </a:moveTo>
                  <a:lnTo>
                    <a:pt x="375" y="72"/>
                  </a:lnTo>
                  <a:moveTo>
                    <a:pt x="378" y="72"/>
                  </a:moveTo>
                  <a:lnTo>
                    <a:pt x="379" y="72"/>
                  </a:lnTo>
                  <a:moveTo>
                    <a:pt x="382" y="72"/>
                  </a:moveTo>
                  <a:lnTo>
                    <a:pt x="386" y="72"/>
                  </a:lnTo>
                  <a:moveTo>
                    <a:pt x="389" y="72"/>
                  </a:moveTo>
                  <a:lnTo>
                    <a:pt x="390" y="72"/>
                  </a:lnTo>
                  <a:moveTo>
                    <a:pt x="391" y="74"/>
                  </a:moveTo>
                  <a:lnTo>
                    <a:pt x="391" y="78"/>
                  </a:lnTo>
                  <a:moveTo>
                    <a:pt x="391" y="81"/>
                  </a:moveTo>
                  <a:lnTo>
                    <a:pt x="391" y="82"/>
                  </a:lnTo>
                  <a:moveTo>
                    <a:pt x="391" y="85"/>
                  </a:moveTo>
                  <a:lnTo>
                    <a:pt x="391" y="89"/>
                  </a:lnTo>
                  <a:moveTo>
                    <a:pt x="391" y="92"/>
                  </a:moveTo>
                  <a:lnTo>
                    <a:pt x="391" y="93"/>
                  </a:lnTo>
                  <a:moveTo>
                    <a:pt x="391" y="96"/>
                  </a:moveTo>
                  <a:lnTo>
                    <a:pt x="391" y="100"/>
                  </a:lnTo>
                  <a:moveTo>
                    <a:pt x="391" y="103"/>
                  </a:moveTo>
                  <a:lnTo>
                    <a:pt x="391" y="104"/>
                  </a:lnTo>
                  <a:moveTo>
                    <a:pt x="391" y="107"/>
                  </a:moveTo>
                  <a:lnTo>
                    <a:pt x="391" y="111"/>
                  </a:lnTo>
                  <a:moveTo>
                    <a:pt x="391" y="114"/>
                  </a:moveTo>
                  <a:lnTo>
                    <a:pt x="391" y="115"/>
                  </a:lnTo>
                  <a:moveTo>
                    <a:pt x="391" y="118"/>
                  </a:moveTo>
                  <a:lnTo>
                    <a:pt x="391" y="122"/>
                  </a:lnTo>
                  <a:moveTo>
                    <a:pt x="391" y="125"/>
                  </a:moveTo>
                  <a:lnTo>
                    <a:pt x="391" y="126"/>
                  </a:lnTo>
                  <a:moveTo>
                    <a:pt x="391" y="129"/>
                  </a:moveTo>
                  <a:lnTo>
                    <a:pt x="391" y="132"/>
                  </a:lnTo>
                  <a:lnTo>
                    <a:pt x="392" y="132"/>
                  </a:lnTo>
                  <a:moveTo>
                    <a:pt x="395" y="132"/>
                  </a:moveTo>
                  <a:lnTo>
                    <a:pt x="396" y="132"/>
                  </a:lnTo>
                  <a:moveTo>
                    <a:pt x="399" y="132"/>
                  </a:moveTo>
                  <a:lnTo>
                    <a:pt x="403" y="132"/>
                  </a:lnTo>
                  <a:moveTo>
                    <a:pt x="406" y="132"/>
                  </a:moveTo>
                  <a:lnTo>
                    <a:pt x="407" y="132"/>
                  </a:lnTo>
                  <a:moveTo>
                    <a:pt x="410" y="132"/>
                  </a:moveTo>
                  <a:lnTo>
                    <a:pt x="414" y="132"/>
                  </a:lnTo>
                  <a:moveTo>
                    <a:pt x="417" y="132"/>
                  </a:moveTo>
                  <a:lnTo>
                    <a:pt x="418" y="132"/>
                  </a:lnTo>
                  <a:moveTo>
                    <a:pt x="421" y="132"/>
                  </a:moveTo>
                  <a:lnTo>
                    <a:pt x="425" y="132"/>
                  </a:lnTo>
                  <a:moveTo>
                    <a:pt x="428" y="132"/>
                  </a:moveTo>
                  <a:lnTo>
                    <a:pt x="429" y="132"/>
                  </a:lnTo>
                  <a:moveTo>
                    <a:pt x="432" y="132"/>
                  </a:moveTo>
                  <a:lnTo>
                    <a:pt x="436" y="132"/>
                  </a:lnTo>
                  <a:moveTo>
                    <a:pt x="439" y="132"/>
                  </a:moveTo>
                  <a:lnTo>
                    <a:pt x="440" y="132"/>
                  </a:lnTo>
                  <a:moveTo>
                    <a:pt x="443" y="132"/>
                  </a:moveTo>
                  <a:lnTo>
                    <a:pt x="447" y="132"/>
                  </a:lnTo>
                  <a:moveTo>
                    <a:pt x="450" y="132"/>
                  </a:moveTo>
                  <a:lnTo>
                    <a:pt x="451" y="132"/>
                  </a:lnTo>
                  <a:moveTo>
                    <a:pt x="454" y="132"/>
                  </a:moveTo>
                  <a:lnTo>
                    <a:pt x="456" y="132"/>
                  </a:lnTo>
                  <a:lnTo>
                    <a:pt x="456" y="134"/>
                  </a:lnTo>
                  <a:moveTo>
                    <a:pt x="456" y="137"/>
                  </a:moveTo>
                  <a:lnTo>
                    <a:pt x="456" y="138"/>
                  </a:lnTo>
                  <a:moveTo>
                    <a:pt x="456" y="141"/>
                  </a:moveTo>
                  <a:lnTo>
                    <a:pt x="456" y="145"/>
                  </a:lnTo>
                  <a:moveTo>
                    <a:pt x="456" y="148"/>
                  </a:moveTo>
                  <a:lnTo>
                    <a:pt x="456" y="149"/>
                  </a:lnTo>
                  <a:moveTo>
                    <a:pt x="456" y="152"/>
                  </a:moveTo>
                  <a:lnTo>
                    <a:pt x="456" y="156"/>
                  </a:lnTo>
                  <a:moveTo>
                    <a:pt x="456" y="159"/>
                  </a:moveTo>
                  <a:lnTo>
                    <a:pt x="456" y="160"/>
                  </a:lnTo>
                  <a:moveTo>
                    <a:pt x="456" y="163"/>
                  </a:moveTo>
                  <a:lnTo>
                    <a:pt x="456" y="167"/>
                  </a:lnTo>
                  <a:moveTo>
                    <a:pt x="456" y="170"/>
                  </a:moveTo>
                  <a:lnTo>
                    <a:pt x="456" y="171"/>
                  </a:lnTo>
                  <a:moveTo>
                    <a:pt x="456" y="174"/>
                  </a:moveTo>
                  <a:lnTo>
                    <a:pt x="456" y="178"/>
                  </a:lnTo>
                  <a:moveTo>
                    <a:pt x="456" y="181"/>
                  </a:moveTo>
                  <a:lnTo>
                    <a:pt x="456" y="182"/>
                  </a:lnTo>
                  <a:moveTo>
                    <a:pt x="456" y="185"/>
                  </a:moveTo>
                  <a:lnTo>
                    <a:pt x="456" y="189"/>
                  </a:lnTo>
                  <a:moveTo>
                    <a:pt x="456" y="192"/>
                  </a:moveTo>
                  <a:lnTo>
                    <a:pt x="456" y="193"/>
                  </a:lnTo>
                  <a:moveTo>
                    <a:pt x="456" y="196"/>
                  </a:moveTo>
                  <a:lnTo>
                    <a:pt x="456" y="200"/>
                  </a:lnTo>
                  <a:moveTo>
                    <a:pt x="456" y="203"/>
                  </a:moveTo>
                  <a:lnTo>
                    <a:pt x="456" y="204"/>
                  </a:lnTo>
                  <a:moveTo>
                    <a:pt x="456" y="207"/>
                  </a:moveTo>
                  <a:lnTo>
                    <a:pt x="456" y="211"/>
                  </a:lnTo>
                  <a:moveTo>
                    <a:pt x="456" y="214"/>
                  </a:moveTo>
                  <a:lnTo>
                    <a:pt x="456" y="215"/>
                  </a:lnTo>
                  <a:moveTo>
                    <a:pt x="456" y="218"/>
                  </a:moveTo>
                  <a:lnTo>
                    <a:pt x="456" y="222"/>
                  </a:lnTo>
                  <a:moveTo>
                    <a:pt x="456" y="225"/>
                  </a:moveTo>
                  <a:lnTo>
                    <a:pt x="456" y="226"/>
                  </a:lnTo>
                  <a:moveTo>
                    <a:pt x="456" y="229"/>
                  </a:moveTo>
                  <a:lnTo>
                    <a:pt x="456" y="233"/>
                  </a:lnTo>
                </a:path>
              </a:pathLst>
            </a:custGeom>
            <a:ln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2" name="Line 189">
              <a:extLst>
                <a:ext uri="{FF2B5EF4-FFF2-40B4-BE49-F238E27FC236}">
                  <a16:creationId xmlns:a16="http://schemas.microsoft.com/office/drawing/2014/main" id="{9B23C82B-ACDC-75B8-8585-5F3ACF1C8E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4" y="2040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3" name="Line 190">
              <a:extLst>
                <a:ext uri="{FF2B5EF4-FFF2-40B4-BE49-F238E27FC236}">
                  <a16:creationId xmlns:a16="http://schemas.microsoft.com/office/drawing/2014/main" id="{46099349-D56B-9914-8A72-6C86EDC523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6" y="2028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4" name="Line 191">
              <a:extLst>
                <a:ext uri="{FF2B5EF4-FFF2-40B4-BE49-F238E27FC236}">
                  <a16:creationId xmlns:a16="http://schemas.microsoft.com/office/drawing/2014/main" id="{3D2145D2-9848-BE11-2432-D11A63AD74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7" y="2052"/>
              <a:ext cx="24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5" name="Line 192">
              <a:extLst>
                <a:ext uri="{FF2B5EF4-FFF2-40B4-BE49-F238E27FC236}">
                  <a16:creationId xmlns:a16="http://schemas.microsoft.com/office/drawing/2014/main" id="{2DA9E38B-E263-C0DA-569B-DFFF6DBA4E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9" y="2038"/>
              <a:ext cx="0" cy="25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6" name="Line 193">
              <a:extLst>
                <a:ext uri="{FF2B5EF4-FFF2-40B4-BE49-F238E27FC236}">
                  <a16:creationId xmlns:a16="http://schemas.microsoft.com/office/drawing/2014/main" id="{D4864F92-D17E-610C-E900-EF904533AF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0" y="2066"/>
              <a:ext cx="26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7" name="Line 194">
              <a:extLst>
                <a:ext uri="{FF2B5EF4-FFF2-40B4-BE49-F238E27FC236}">
                  <a16:creationId xmlns:a16="http://schemas.microsoft.com/office/drawing/2014/main" id="{B7E5ED5D-8ADE-ED8E-31D2-5B8CEF83F3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44" y="2054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8" name="Line 195">
              <a:extLst>
                <a:ext uri="{FF2B5EF4-FFF2-40B4-BE49-F238E27FC236}">
                  <a16:creationId xmlns:a16="http://schemas.microsoft.com/office/drawing/2014/main" id="{757BCC8A-BCDD-870A-1D4E-142AF2D86A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86" y="2092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199" name="Line 196">
              <a:extLst>
                <a:ext uri="{FF2B5EF4-FFF2-40B4-BE49-F238E27FC236}">
                  <a16:creationId xmlns:a16="http://schemas.microsoft.com/office/drawing/2014/main" id="{B63A557E-3624-C129-11FB-631F8D4A12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97" y="2080"/>
              <a:ext cx="0" cy="23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0" name="Line 197">
              <a:extLst>
                <a:ext uri="{FF2B5EF4-FFF2-40B4-BE49-F238E27FC236}">
                  <a16:creationId xmlns:a16="http://schemas.microsoft.com/office/drawing/2014/main" id="{219D2AE8-C40B-9CBA-24FA-61D0E38BB2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9" y="2155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1" name="Line 198">
              <a:extLst>
                <a:ext uri="{FF2B5EF4-FFF2-40B4-BE49-F238E27FC236}">
                  <a16:creationId xmlns:a16="http://schemas.microsoft.com/office/drawing/2014/main" id="{941C3AB1-6FC0-D83E-4901-F754AD3AE5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50" y="2143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2" name="Line 199">
              <a:extLst>
                <a:ext uri="{FF2B5EF4-FFF2-40B4-BE49-F238E27FC236}">
                  <a16:creationId xmlns:a16="http://schemas.microsoft.com/office/drawing/2014/main" id="{575CB475-B121-2BC3-C33F-71DC720CC5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92" y="2275"/>
              <a:ext cx="25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3" name="Line 200">
              <a:extLst>
                <a:ext uri="{FF2B5EF4-FFF2-40B4-BE49-F238E27FC236}">
                  <a16:creationId xmlns:a16="http://schemas.microsoft.com/office/drawing/2014/main" id="{AD64DEF6-125F-9033-FFB7-F272F1D9CB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06" y="2263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4" name="Line 201">
              <a:extLst>
                <a:ext uri="{FF2B5EF4-FFF2-40B4-BE49-F238E27FC236}">
                  <a16:creationId xmlns:a16="http://schemas.microsoft.com/office/drawing/2014/main" id="{5244B300-A944-1B9E-0143-3E10F13CBE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47" y="2468"/>
              <a:ext cx="23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5" name="Line 202">
              <a:extLst>
                <a:ext uri="{FF2B5EF4-FFF2-40B4-BE49-F238E27FC236}">
                  <a16:creationId xmlns:a16="http://schemas.microsoft.com/office/drawing/2014/main" id="{B9CD9943-2722-FCCE-D92C-98878E84FB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59" y="2456"/>
              <a:ext cx="0" cy="24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6" name="Line 203">
              <a:extLst>
                <a:ext uri="{FF2B5EF4-FFF2-40B4-BE49-F238E27FC236}">
                  <a16:creationId xmlns:a16="http://schemas.microsoft.com/office/drawing/2014/main" id="{C80F6F5A-8C7F-B6D0-6AAD-B6A26ED895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7" y="2732"/>
              <a:ext cx="68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7" name="Freeform 204">
              <a:extLst>
                <a:ext uri="{FF2B5EF4-FFF2-40B4-BE49-F238E27FC236}">
                  <a16:creationId xmlns:a16="http://schemas.microsoft.com/office/drawing/2014/main" id="{F2BC3BD8-AD74-01DA-9860-4034F15E8A1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" y="2776"/>
              <a:ext cx="59" cy="0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8" name="Freeform 205">
              <a:extLst>
                <a:ext uri="{FF2B5EF4-FFF2-40B4-BE49-F238E27FC236}">
                  <a16:creationId xmlns:a16="http://schemas.microsoft.com/office/drawing/2014/main" id="{4985EE70-FE3A-1A14-BFCA-769E28C3B4E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69" y="2821"/>
              <a:ext cx="66" cy="0"/>
            </a:xfrm>
            <a:custGeom>
              <a:avLst/>
              <a:gdLst>
                <a:gd name="T0" fmla="*/ 0 w 28"/>
                <a:gd name="T1" fmla="*/ 3 w 28"/>
                <a:gd name="T2" fmla="*/ 4 w 28"/>
                <a:gd name="T3" fmla="*/ 7 w 28"/>
                <a:gd name="T4" fmla="*/ 8 w 28"/>
                <a:gd name="T5" fmla="*/ 11 w 28"/>
                <a:gd name="T6" fmla="*/ 12 w 28"/>
                <a:gd name="T7" fmla="*/ 15 w 28"/>
                <a:gd name="T8" fmla="*/ 16 w 28"/>
                <a:gd name="T9" fmla="*/ 19 w 28"/>
                <a:gd name="T10" fmla="*/ 20 w 28"/>
                <a:gd name="T11" fmla="*/ 23 w 28"/>
                <a:gd name="T12" fmla="*/ 24 w 28"/>
                <a:gd name="T13" fmla="*/ 27 w 2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</a:cxnLst>
              <a:rect l="0" t="0" r="r" b="b"/>
              <a:pathLst>
                <a:path w="2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09" name="Freeform 206">
              <a:extLst>
                <a:ext uri="{FF2B5EF4-FFF2-40B4-BE49-F238E27FC236}">
                  <a16:creationId xmlns:a16="http://schemas.microsoft.com/office/drawing/2014/main" id="{6227B285-A030-444D-A6A8-1AB844A679A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69" y="2866"/>
              <a:ext cx="66" cy="0"/>
            </a:xfrm>
            <a:custGeom>
              <a:avLst/>
              <a:gdLst>
                <a:gd name="T0" fmla="*/ 0 w 28"/>
                <a:gd name="T1" fmla="*/ 3 w 28"/>
                <a:gd name="T2" fmla="*/ 7 w 28"/>
                <a:gd name="T3" fmla="*/ 10 w 28"/>
                <a:gd name="T4" fmla="*/ 11 w 28"/>
                <a:gd name="T5" fmla="*/ 14 w 28"/>
                <a:gd name="T6" fmla="*/ 18 w 28"/>
                <a:gd name="T7" fmla="*/ 21 w 28"/>
                <a:gd name="T8" fmla="*/ 22 w 28"/>
                <a:gd name="T9" fmla="*/ 25 w 2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</a:cxnLst>
              <a:rect l="0" t="0" r="r" b="b"/>
              <a:pathLst>
                <a:path w="28">
                  <a:moveTo>
                    <a:pt x="3" y="0"/>
                  </a:moveTo>
                  <a:lnTo>
                    <a:pt x="7" y="0"/>
                  </a:lnTo>
                  <a:moveTo>
                    <a:pt x="10" y="0"/>
                  </a:moveTo>
                  <a:lnTo>
                    <a:pt x="11" y="0"/>
                  </a:lnTo>
                  <a:moveTo>
                    <a:pt x="14" y="0"/>
                  </a:moveTo>
                  <a:lnTo>
                    <a:pt x="18" y="0"/>
                  </a:lnTo>
                  <a:moveTo>
                    <a:pt x="21" y="0"/>
                  </a:moveTo>
                  <a:lnTo>
                    <a:pt x="22" y="0"/>
                  </a:lnTo>
                  <a:moveTo>
                    <a:pt x="25" y="0"/>
                  </a:move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/>
            </a:p>
          </p:txBody>
        </p:sp>
        <p:sp>
          <p:nvSpPr>
            <p:cNvPr id="210" name="Rectangle 207">
              <a:extLst>
                <a:ext uri="{FF2B5EF4-FFF2-40B4-BE49-F238E27FC236}">
                  <a16:creationId xmlns:a16="http://schemas.microsoft.com/office/drawing/2014/main" id="{CDE4CFD3-2BB4-4635-BF2B-7C448633A8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3" y="2601"/>
              <a:ext cx="18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Group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11" name="Rectangle 208">
              <a:extLst>
                <a:ext uri="{FF2B5EF4-FFF2-40B4-BE49-F238E27FC236}">
                  <a16:creationId xmlns:a16="http://schemas.microsoft.com/office/drawing/2014/main" id="{D07195AC-2147-6600-8482-D386AB97B8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2" y="2678"/>
              <a:ext cx="652" cy="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ontrol (</a:t>
              </a:r>
              <a:r>
                <a:rPr kumimoji="0" lang="en-US" altLang="en-US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=99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12" name="Rectangle 209">
              <a:extLst>
                <a:ext uri="{FF2B5EF4-FFF2-40B4-BE49-F238E27FC236}">
                  <a16:creationId xmlns:a16="http://schemas.microsoft.com/office/drawing/2014/main" id="{6492DCB2-5388-DC5B-9B8E-AC7CF06831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2" y="2726"/>
              <a:ext cx="624" cy="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GST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NFM (</a:t>
              </a:r>
              <a:r>
                <a:rPr kumimoji="0" lang="en-US" altLang="en-US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=79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13" name="Rectangle 210">
              <a:extLst>
                <a:ext uri="{FF2B5EF4-FFF2-40B4-BE49-F238E27FC236}">
                  <a16:creationId xmlns:a16="http://schemas.microsoft.com/office/drawing/2014/main" id="{EC4B19CE-812F-5280-FEFF-ABB195F3A9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" y="2779"/>
              <a:ext cx="627" cy="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dirty="0" err="1">
                  <a:solidFill>
                    <a:srgbClr val="000000"/>
                  </a:solidFill>
                  <a:latin typeface="+mn-lt"/>
                </a:rPr>
                <a:t>rGST</a:t>
              </a:r>
              <a:r>
                <a:rPr kumimoji="0" lang="en-US" altLang="en-US" sz="900" dirty="0">
                  <a:solidFill>
                    <a:srgbClr val="000000"/>
                  </a:solidFill>
                  <a:latin typeface="+mn-lt"/>
                </a:rPr>
                <a:t> 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RM (</a:t>
              </a:r>
              <a:r>
                <a:rPr kumimoji="0" lang="en-US" altLang="en-US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=77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14" name="Rectangle 211">
              <a:extLst>
                <a:ext uri="{FF2B5EF4-FFF2-40B4-BE49-F238E27FC236}">
                  <a16:creationId xmlns:a16="http://schemas.microsoft.com/office/drawing/2014/main" id="{A47E4A57-3DEB-E5AA-22A5-CD599FB761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2" y="2829"/>
              <a:ext cx="588" cy="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GST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FM (</a:t>
              </a:r>
              <a:r>
                <a:rPr kumimoji="0" lang="en-US" altLang="en-US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</a:t>
              </a: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=55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sp>
        <p:nvSpPr>
          <p:cNvPr id="215" name="TextBox 214">
            <a:extLst>
              <a:ext uri="{FF2B5EF4-FFF2-40B4-BE49-F238E27FC236}">
                <a16:creationId xmlns:a16="http://schemas.microsoft.com/office/drawing/2014/main" id="{DF00066E-96F3-19A0-0D05-0E3395007405}"/>
              </a:ext>
            </a:extLst>
          </p:cNvPr>
          <p:cNvSpPr txBox="1"/>
          <p:nvPr/>
        </p:nvSpPr>
        <p:spPr>
          <a:xfrm>
            <a:off x="195446" y="239562"/>
            <a:ext cx="5537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j-lt"/>
              </a:rPr>
              <a:t>Supplementary Figure 3a. Mortality rate of adult PRMs (experiment 1)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F051B887-3212-F198-18CC-377A8196582A}"/>
              </a:ext>
            </a:extLst>
          </p:cNvPr>
          <p:cNvSpPr txBox="1"/>
          <p:nvPr/>
        </p:nvSpPr>
        <p:spPr>
          <a:xfrm>
            <a:off x="50910" y="4001067"/>
            <a:ext cx="51679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j-lt"/>
              </a:rPr>
              <a:t>Supplementary Figure 3b. Mortality rate of nymph PRMs (experiment 1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2760E89-B5C5-8A3C-7321-7BEF7B083FAB}"/>
              </a:ext>
            </a:extLst>
          </p:cNvPr>
          <p:cNvSpPr txBox="1"/>
          <p:nvPr/>
        </p:nvSpPr>
        <p:spPr>
          <a:xfrm>
            <a:off x="218306" y="7350725"/>
            <a:ext cx="6309320" cy="881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900" b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9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Evaluation of the acaricidal potential of GSTs by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feeding with developmental stages of PRMs 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experiment 1). The survival rate of PRMs fed with plasmas obtained from each immunized group were assessed daily for a week. Number of PRMs for these analyses are (</a:t>
            </a:r>
            <a:r>
              <a:rPr lang="en-US" sz="900" b="1" dirty="0">
                <a:solidFill>
                  <a:srgbClr val="000000"/>
                </a:solidFill>
                <a:effectLst/>
                <a:latin typeface="+mj-lt"/>
                <a:ea typeface="ＭＳ ゴシック" panose="020B0609070205080204" pitchFamily="49" charset="-128"/>
                <a:cs typeface="Times New Roman" panose="02020603050405020304" pitchFamily="18" charset="0"/>
              </a:rPr>
              <a:t>a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adult PRMs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: immune plasma: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76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9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rGST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PRM),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=58 (</a:t>
            </a:r>
            <a:r>
              <a:rPr lang="en-US" sz="9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rGST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TFM),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n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69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9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rGST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NFM), control plasma: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900" b="1" dirty="0">
                <a:solidFill>
                  <a:srgbClr val="000000"/>
                </a:solidFill>
                <a:effectLst/>
                <a:latin typeface="+mj-lt"/>
                <a:ea typeface="ＭＳ ゴシック" panose="020B0609070205080204" pitchFamily="49" charset="-128"/>
                <a:cs typeface="Times New Roman" panose="02020603050405020304" pitchFamily="18" charset="0"/>
              </a:rPr>
              <a:t>b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nymph PRMs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: immune plasma: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77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9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rGST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PRM),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9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rGST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TFM),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79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9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rGST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NFM), control plasma: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sz="9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99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. The number of dead PRMs was recorded. The statistical analysis was calculated by a log-rank test. </a:t>
            </a:r>
            <a:r>
              <a:rPr lang="en-US" sz="9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9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&lt; 0.01 were considered statistically significant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B2E4B2B-CAB0-6182-1B53-72B82848BAA6}"/>
              </a:ext>
            </a:extLst>
          </p:cNvPr>
          <p:cNvSpPr txBox="1"/>
          <p:nvPr/>
        </p:nvSpPr>
        <p:spPr>
          <a:xfrm>
            <a:off x="2916316" y="5175454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P</a:t>
            </a:r>
            <a:r>
              <a:rPr lang="en-US" sz="900" dirty="0"/>
              <a:t>&lt;0.01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1701815A-224D-8008-9836-BE9D49AB2558}"/>
              </a:ext>
            </a:extLst>
          </p:cNvPr>
          <p:cNvSpPr txBox="1"/>
          <p:nvPr/>
        </p:nvSpPr>
        <p:spPr>
          <a:xfrm>
            <a:off x="2851308" y="1894153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P</a:t>
            </a:r>
            <a:r>
              <a:rPr lang="en-US" sz="900" dirty="0"/>
              <a:t>&lt;0.01</a:t>
            </a:r>
          </a:p>
        </p:txBody>
      </p:sp>
    </p:spTree>
    <p:extLst>
      <p:ext uri="{BB962C8B-B14F-4D97-AF65-F5344CB8AC3E}">
        <p14:creationId xmlns:p14="http://schemas.microsoft.com/office/powerpoint/2010/main" val="1798087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3">
      <a:majorFont>
        <a:latin typeface="Times New Roman"/>
        <a:ea typeface="ＭＳ 明朝"/>
        <a:cs typeface=""/>
      </a:majorFont>
      <a:minorFont>
        <a:latin typeface="Times New Roman"/>
        <a:ea typeface="ＭＳ 明朝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16</TotalTime>
  <Words>410</Words>
  <Application>Microsoft Office PowerPoint</Application>
  <PresentationFormat>A4 Paper (210x297 mm)</PresentationFormat>
  <Paragraphs>135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谷口綾香</dc:creator>
  <cp:lastModifiedBy>MDPI</cp:lastModifiedBy>
  <cp:revision>484</cp:revision>
  <cp:lastPrinted>2023-07-13T05:19:47Z</cp:lastPrinted>
  <dcterms:created xsi:type="dcterms:W3CDTF">2014-11-05T07:44:06Z</dcterms:created>
  <dcterms:modified xsi:type="dcterms:W3CDTF">2024-01-30T13:57:54Z</dcterms:modified>
</cp:coreProperties>
</file>